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5"/>
  </p:notesMasterIdLst>
  <p:sldIdLst>
    <p:sldId id="257" r:id="rId2"/>
    <p:sldId id="289" r:id="rId3"/>
    <p:sldId id="290" r:id="rId4"/>
    <p:sldId id="291" r:id="rId5"/>
    <p:sldId id="292" r:id="rId6"/>
    <p:sldId id="293" r:id="rId7"/>
    <p:sldId id="294" r:id="rId8"/>
    <p:sldId id="295" r:id="rId9"/>
    <p:sldId id="296" r:id="rId10"/>
    <p:sldId id="297" r:id="rId11"/>
    <p:sldId id="298" r:id="rId12"/>
    <p:sldId id="299" r:id="rId13"/>
    <p:sldId id="300" r:id="rId14"/>
  </p:sldIdLst>
  <p:sldSz cx="6264275" cy="7127875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ndice Ulmer" initials="CU" lastIdx="7" clrIdx="0">
    <p:extLst>
      <p:ext uri="{19B8F6BF-5375-455C-9EA6-DF929625EA0E}">
        <p15:presenceInfo xmlns:p15="http://schemas.microsoft.com/office/powerpoint/2012/main" userId="6ccd7c7cc1009ddb" providerId="Windows Live"/>
      </p:ext>
    </p:extLst>
  </p:cmAuthor>
  <p:cmAuthor id="2" name="John Bowden" initials="JB" lastIdx="10" clrIdx="1">
    <p:extLst>
      <p:ext uri="{19B8F6BF-5375-455C-9EA6-DF929625EA0E}">
        <p15:presenceInfo xmlns:p15="http://schemas.microsoft.com/office/powerpoint/2012/main" userId="John Bowden" providerId="None"/>
      </p:ext>
    </p:extLst>
  </p:cmAuthor>
  <p:cmAuthor id="3" name="Jeremy Koelmel" initials="JK" lastIdx="10" clrIdx="2">
    <p:extLst>
      <p:ext uri="{19B8F6BF-5375-455C-9EA6-DF929625EA0E}">
        <p15:presenceInfo xmlns:p15="http://schemas.microsoft.com/office/powerpoint/2012/main" userId="045177777db6ffe7" providerId="Windows Live"/>
      </p:ext>
    </p:extLst>
  </p:cmAuthor>
  <p:cmAuthor id="4" name="Robin Kemperman" initials="RK" lastIdx="7" clrIdx="3">
    <p:extLst>
      <p:ext uri="{19B8F6BF-5375-455C-9EA6-DF929625EA0E}">
        <p15:presenceInfo xmlns:p15="http://schemas.microsoft.com/office/powerpoint/2012/main" userId="9d255178c0dad457" providerId="Windows Live"/>
      </p:ext>
    </p:extLst>
  </p:cmAuthor>
  <p:cmAuthor id="5" name="SARTAIN,MARK (A-SantaClara,ex1)" initials="S(" lastIdx="11" clrIdx="4">
    <p:extLst>
      <p:ext uri="{19B8F6BF-5375-455C-9EA6-DF929625EA0E}">
        <p15:presenceInfo xmlns:p15="http://schemas.microsoft.com/office/powerpoint/2012/main" userId="S-1-5-21-198358228-527928863-167192953-72765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DC3E6"/>
    <a:srgbClr val="41719C"/>
    <a:srgbClr val="C9C9C9"/>
    <a:srgbClr val="F4B183"/>
    <a:srgbClr val="0000FF"/>
    <a:srgbClr val="BFBFBF"/>
    <a:srgbClr val="7F7F7F"/>
    <a:srgbClr val="EA8B00"/>
    <a:srgbClr val="800080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D38F3D5-6EB5-49F4-A26E-A52AB245C600}" v="314" dt="2019-06-19T21:19:53.68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31" autoAdjust="0"/>
    <p:restoredTop sz="95105" autoAdjust="0"/>
  </p:normalViewPr>
  <p:slideViewPr>
    <p:cSldViewPr snapToGrid="0">
      <p:cViewPr varScale="1">
        <p:scale>
          <a:sx n="81" d="100"/>
          <a:sy n="81" d="100"/>
        </p:scale>
        <p:origin x="2208" y="38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42" Type="http://schemas.microsoft.com/office/2016/11/relationships/changesInfo" Target="changesInfos/changesInfo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43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TAIN,MARK (A-SantaClara,ex1)" userId="46c8428a-b59c-4646-b0ec-805c3ac08cbb" providerId="ADAL" clId="{9C55B6A1-5D94-4B07-AE8F-D4D66851DE7D}"/>
    <pc:docChg chg="modSld">
      <pc:chgData name="SARTAIN,MARK (A-SantaClara,ex1)" userId="46c8428a-b59c-4646-b0ec-805c3ac08cbb" providerId="ADAL" clId="{9C55B6A1-5D94-4B07-AE8F-D4D66851DE7D}" dt="2019-06-13T04:22:21.697" v="13"/>
      <pc:docMkLst>
        <pc:docMk/>
      </pc:docMkLst>
      <pc:sldChg chg="addCm modCm">
        <pc:chgData name="SARTAIN,MARK (A-SantaClara,ex1)" userId="46c8428a-b59c-4646-b0ec-805c3ac08cbb" providerId="ADAL" clId="{9C55B6A1-5D94-4B07-AE8F-D4D66851DE7D}" dt="2019-06-13T04:01:26.085" v="1"/>
        <pc:sldMkLst>
          <pc:docMk/>
          <pc:sldMk cId="3050393190" sldId="277"/>
        </pc:sldMkLst>
      </pc:sldChg>
      <pc:sldChg chg="modSp addCm modCm">
        <pc:chgData name="SARTAIN,MARK (A-SantaClara,ex1)" userId="46c8428a-b59c-4646-b0ec-805c3ac08cbb" providerId="ADAL" clId="{9C55B6A1-5D94-4B07-AE8F-D4D66851DE7D}" dt="2019-06-13T04:22:21.697" v="13"/>
        <pc:sldMkLst>
          <pc:docMk/>
          <pc:sldMk cId="4186489" sldId="281"/>
        </pc:sldMkLst>
        <pc:spChg chg="mod">
          <ac:chgData name="SARTAIN,MARK (A-SantaClara,ex1)" userId="46c8428a-b59c-4646-b0ec-805c3ac08cbb" providerId="ADAL" clId="{9C55B6A1-5D94-4B07-AE8F-D4D66851DE7D}" dt="2019-06-13T04:22:08.716" v="11" actId="20577"/>
          <ac:spMkLst>
            <pc:docMk/>
            <pc:sldMk cId="4186489" sldId="281"/>
            <ac:spMk id="12" creationId="{00000000-0000-0000-0000-000000000000}"/>
          </ac:spMkLst>
        </pc:spChg>
      </pc:sldChg>
      <pc:sldChg chg="addCm modCm">
        <pc:chgData name="SARTAIN,MARK (A-SantaClara,ex1)" userId="46c8428a-b59c-4646-b0ec-805c3ac08cbb" providerId="ADAL" clId="{9C55B6A1-5D94-4B07-AE8F-D4D66851DE7D}" dt="2019-06-13T04:21:50.004" v="7"/>
        <pc:sldMkLst>
          <pc:docMk/>
          <pc:sldMk cId="4168674539" sldId="300"/>
        </pc:sldMkLst>
      </pc:sldChg>
    </pc:docChg>
  </pc:docChgLst>
  <pc:docChgLst>
    <pc:chgData name="SARTAIN,MARK (Agilent USA)" userId="46c8428a-b59c-4646-b0ec-805c3ac08cbb" providerId="ADAL" clId="{AD38F3D5-6EB5-49F4-A26E-A52AB245C600}"/>
    <pc:docChg chg="undo custSel addSld modSld">
      <pc:chgData name="SARTAIN,MARK (Agilent USA)" userId="46c8428a-b59c-4646-b0ec-805c3ac08cbb" providerId="ADAL" clId="{AD38F3D5-6EB5-49F4-A26E-A52AB245C600}" dt="2019-06-19T21:19:53.689" v="299" actId="20577"/>
      <pc:docMkLst>
        <pc:docMk/>
      </pc:docMkLst>
      <pc:sldChg chg="addCm modCm">
        <pc:chgData name="SARTAIN,MARK (Agilent USA)" userId="46c8428a-b59c-4646-b0ec-805c3ac08cbb" providerId="ADAL" clId="{AD38F3D5-6EB5-49F4-A26E-A52AB245C600}" dt="2019-06-17T22:51:36.784" v="1"/>
        <pc:sldMkLst>
          <pc:docMk/>
          <pc:sldMk cId="3283841961" sldId="292"/>
        </pc:sldMkLst>
      </pc:sldChg>
      <pc:sldChg chg="modSp addCm modCm">
        <pc:chgData name="SARTAIN,MARK (Agilent USA)" userId="46c8428a-b59c-4646-b0ec-805c3ac08cbb" providerId="ADAL" clId="{AD38F3D5-6EB5-49F4-A26E-A52AB245C600}" dt="2019-06-19T18:52:23.486" v="65"/>
        <pc:sldMkLst>
          <pc:docMk/>
          <pc:sldMk cId="1290661302" sldId="298"/>
        </pc:sldMkLst>
        <pc:spChg chg="mod">
          <ac:chgData name="SARTAIN,MARK (Agilent USA)" userId="46c8428a-b59c-4646-b0ec-805c3ac08cbb" providerId="ADAL" clId="{AD38F3D5-6EB5-49F4-A26E-A52AB245C600}" dt="2019-06-19T18:51:24.908" v="62" actId="20577"/>
          <ac:spMkLst>
            <pc:docMk/>
            <pc:sldMk cId="1290661302" sldId="298"/>
            <ac:spMk id="7" creationId="{00000000-0000-0000-0000-000000000000}"/>
          </ac:spMkLst>
        </pc:spChg>
      </pc:sldChg>
      <pc:sldChg chg="addSp delSp modSp addCm modCm">
        <pc:chgData name="SARTAIN,MARK (Agilent USA)" userId="46c8428a-b59c-4646-b0ec-805c3ac08cbb" providerId="ADAL" clId="{AD38F3D5-6EB5-49F4-A26E-A52AB245C600}" dt="2019-06-17T23:08:42.467" v="23"/>
        <pc:sldMkLst>
          <pc:docMk/>
          <pc:sldMk cId="4168674539" sldId="300"/>
        </pc:sldMkLst>
        <pc:picChg chg="add del mod">
          <ac:chgData name="SARTAIN,MARK (Agilent USA)" userId="46c8428a-b59c-4646-b0ec-805c3ac08cbb" providerId="ADAL" clId="{AD38F3D5-6EB5-49F4-A26E-A52AB245C600}" dt="2019-06-17T23:05:28.560" v="9" actId="478"/>
          <ac:picMkLst>
            <pc:docMk/>
            <pc:sldMk cId="4168674539" sldId="300"/>
            <ac:picMk id="2" creationId="{8F02AEC1-1A06-49B6-9810-DBC5194326E1}"/>
          </ac:picMkLst>
        </pc:picChg>
        <pc:picChg chg="add del">
          <ac:chgData name="SARTAIN,MARK (Agilent USA)" userId="46c8428a-b59c-4646-b0ec-805c3ac08cbb" providerId="ADAL" clId="{AD38F3D5-6EB5-49F4-A26E-A52AB245C600}" dt="2019-06-17T23:05:38.610" v="11" actId="478"/>
          <ac:picMkLst>
            <pc:docMk/>
            <pc:sldMk cId="4168674539" sldId="300"/>
            <ac:picMk id="6" creationId="{C224D915-2CCD-4870-AF79-8AE6B33CC526}"/>
          </ac:picMkLst>
        </pc:picChg>
        <pc:picChg chg="add del mod">
          <ac:chgData name="SARTAIN,MARK (Agilent USA)" userId="46c8428a-b59c-4646-b0ec-805c3ac08cbb" providerId="ADAL" clId="{AD38F3D5-6EB5-49F4-A26E-A52AB245C600}" dt="2019-06-17T23:06:06.229" v="14" actId="478"/>
          <ac:picMkLst>
            <pc:docMk/>
            <pc:sldMk cId="4168674539" sldId="300"/>
            <ac:picMk id="7" creationId="{7D17A606-B51F-460A-86F4-9D4205F5D415}"/>
          </ac:picMkLst>
        </pc:picChg>
        <pc:picChg chg="add mod">
          <ac:chgData name="SARTAIN,MARK (Agilent USA)" userId="46c8428a-b59c-4646-b0ec-805c3ac08cbb" providerId="ADAL" clId="{AD38F3D5-6EB5-49F4-A26E-A52AB245C600}" dt="2019-06-17T23:07:00.706" v="21" actId="1076"/>
          <ac:picMkLst>
            <pc:docMk/>
            <pc:sldMk cId="4168674539" sldId="300"/>
            <ac:picMk id="8" creationId="{AC9E64F6-CCE2-4511-BE2B-450CDBE4409B}"/>
          </ac:picMkLst>
        </pc:picChg>
        <pc:picChg chg="add mod">
          <ac:chgData name="SARTAIN,MARK (Agilent USA)" userId="46c8428a-b59c-4646-b0ec-805c3ac08cbb" providerId="ADAL" clId="{AD38F3D5-6EB5-49F4-A26E-A52AB245C600}" dt="2019-06-17T23:07:02.631" v="22" actId="1076"/>
          <ac:picMkLst>
            <pc:docMk/>
            <pc:sldMk cId="4168674539" sldId="300"/>
            <ac:picMk id="9" creationId="{8CCD0180-C53F-47F6-8C97-EAA80AD6CA18}"/>
          </ac:picMkLst>
        </pc:picChg>
      </pc:sldChg>
      <pc:sldChg chg="modSp">
        <pc:chgData name="SARTAIN,MARK (Agilent USA)" userId="46c8428a-b59c-4646-b0ec-805c3ac08cbb" providerId="ADAL" clId="{AD38F3D5-6EB5-49F4-A26E-A52AB245C600}" dt="2019-06-19T21:08:24.655" v="279" actId="20577"/>
        <pc:sldMkLst>
          <pc:docMk/>
          <pc:sldMk cId="4023568414" sldId="302"/>
        </pc:sldMkLst>
        <pc:spChg chg="mod">
          <ac:chgData name="SARTAIN,MARK (Agilent USA)" userId="46c8428a-b59c-4646-b0ec-805c3ac08cbb" providerId="ADAL" clId="{AD38F3D5-6EB5-49F4-A26E-A52AB245C600}" dt="2019-06-19T21:07:49.597" v="244" actId="1036"/>
          <ac:spMkLst>
            <pc:docMk/>
            <pc:sldMk cId="4023568414" sldId="302"/>
            <ac:spMk id="4" creationId="{00000000-0000-0000-0000-000000000000}"/>
          </ac:spMkLst>
        </pc:spChg>
        <pc:graphicFrameChg chg="modGraphic">
          <ac:chgData name="SARTAIN,MARK (Agilent USA)" userId="46c8428a-b59c-4646-b0ec-805c3ac08cbb" providerId="ADAL" clId="{AD38F3D5-6EB5-49F4-A26E-A52AB245C600}" dt="2019-06-19T21:08:24.655" v="279" actId="20577"/>
          <ac:graphicFrameMkLst>
            <pc:docMk/>
            <pc:sldMk cId="4023568414" sldId="302"/>
            <ac:graphicFrameMk id="2" creationId="{0B8A7803-3BB5-459A-9CAB-C7D84B33668E}"/>
          </ac:graphicFrameMkLst>
        </pc:graphicFrameChg>
      </pc:sldChg>
      <pc:sldChg chg="modSp">
        <pc:chgData name="SARTAIN,MARK (Agilent USA)" userId="46c8428a-b59c-4646-b0ec-805c3ac08cbb" providerId="ADAL" clId="{AD38F3D5-6EB5-49F4-A26E-A52AB245C600}" dt="2019-06-19T21:19:53.689" v="299" actId="20577"/>
        <pc:sldMkLst>
          <pc:docMk/>
          <pc:sldMk cId="1534790952" sldId="303"/>
        </pc:sldMkLst>
        <pc:spChg chg="mod">
          <ac:chgData name="SARTAIN,MARK (Agilent USA)" userId="46c8428a-b59c-4646-b0ec-805c3ac08cbb" providerId="ADAL" clId="{AD38F3D5-6EB5-49F4-A26E-A52AB245C600}" dt="2019-06-19T21:19:53.689" v="299" actId="20577"/>
          <ac:spMkLst>
            <pc:docMk/>
            <pc:sldMk cId="1534790952" sldId="303"/>
            <ac:spMk id="4" creationId="{00000000-0000-0000-0000-000000000000}"/>
          </ac:spMkLst>
        </pc:spChg>
        <pc:graphicFrameChg chg="modGraphic">
          <ac:chgData name="SARTAIN,MARK (Agilent USA)" userId="46c8428a-b59c-4646-b0ec-805c3ac08cbb" providerId="ADAL" clId="{AD38F3D5-6EB5-49F4-A26E-A52AB245C600}" dt="2019-06-19T21:17:48.637" v="284" actId="20577"/>
          <ac:graphicFrameMkLst>
            <pc:docMk/>
            <pc:sldMk cId="1534790952" sldId="303"/>
            <ac:graphicFrameMk id="3" creationId="{FA8AF8ED-F679-4A15-A640-834BEFF4DA71}"/>
          </ac:graphicFrameMkLst>
        </pc:graphicFrameChg>
      </pc:sldChg>
      <pc:sldChg chg="addCm modCm">
        <pc:chgData name="SARTAIN,MARK (Agilent USA)" userId="46c8428a-b59c-4646-b0ec-805c3ac08cbb" providerId="ADAL" clId="{AD38F3D5-6EB5-49F4-A26E-A52AB245C600}" dt="2019-06-19T18:47:49.548" v="61"/>
        <pc:sldMkLst>
          <pc:docMk/>
          <pc:sldMk cId="3448479510" sldId="304"/>
        </pc:sldMkLst>
      </pc:sldChg>
      <pc:sldChg chg="addSp modSp add addCm modCm">
        <pc:chgData name="SARTAIN,MARK (Agilent USA)" userId="46c8428a-b59c-4646-b0ec-805c3ac08cbb" providerId="ADAL" clId="{AD38F3D5-6EB5-49F4-A26E-A52AB245C600}" dt="2019-06-17T23:31:20.310" v="56"/>
        <pc:sldMkLst>
          <pc:docMk/>
          <pc:sldMk cId="336514352" sldId="305"/>
        </pc:sldMkLst>
        <pc:spChg chg="add mod">
          <ac:chgData name="SARTAIN,MARK (Agilent USA)" userId="46c8428a-b59c-4646-b0ec-805c3ac08cbb" providerId="ADAL" clId="{AD38F3D5-6EB5-49F4-A26E-A52AB245C600}" dt="2019-06-17T23:29:28.840" v="54" actId="20577"/>
          <ac:spMkLst>
            <pc:docMk/>
            <pc:sldMk cId="336514352" sldId="305"/>
            <ac:spMk id="2" creationId="{FF7DF71C-3B52-4436-8F7F-53F6B076DE7A}"/>
          </ac:spMkLst>
        </pc:spChg>
        <pc:graphicFrameChg chg="add mod">
          <ac:chgData name="SARTAIN,MARK (Agilent USA)" userId="46c8428a-b59c-4646-b0ec-805c3ac08cbb" providerId="ADAL" clId="{AD38F3D5-6EB5-49F4-A26E-A52AB245C600}" dt="2019-06-17T23:28:50.589" v="40" actId="1076"/>
          <ac:graphicFrameMkLst>
            <pc:docMk/>
            <pc:sldMk cId="336514352" sldId="305"/>
            <ac:graphicFrameMk id="3" creationId="{FF06253E-4432-4C02-8510-A4E771850011}"/>
          </ac:graphicFrameMkLst>
        </pc:graphicFrameChg>
        <pc:graphicFrameChg chg="add mod">
          <ac:chgData name="SARTAIN,MARK (Agilent USA)" userId="46c8428a-b59c-4646-b0ec-805c3ac08cbb" providerId="ADAL" clId="{AD38F3D5-6EB5-49F4-A26E-A52AB245C600}" dt="2019-06-17T23:28:50.589" v="40" actId="1076"/>
          <ac:graphicFrameMkLst>
            <pc:docMk/>
            <pc:sldMk cId="336514352" sldId="305"/>
            <ac:graphicFrameMk id="4" creationId="{2796B48C-0EBB-49BD-9A35-3BA7675ACB48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agilent-my.sharepoint.com/personal/mark_sartain_agilent_com/Documents/Desktop/Lipid%20Annotator/Publication%20-%20Jeremy/My%20suggestion%20for%20masss%20accuracy%20figure/Abundance%20vs%20mass%20accurac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agilent-my.sharepoint.com/personal/mark_sartain_agilent_com/Documents/Desktop/Lipid%20Annotator/Publication%20-%20Jeremy/My%20suggestion%20for%20masss%20accuracy%20figure/Abundance%20vs%20mass%20accurac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cap="none" baseline="0">
              <a:solidFill>
                <a:schemeClr val="lt1">
                  <a:lumMod val="8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Negative</c:v>
          </c:tx>
          <c:spPr>
            <a:ln w="25400" cap="rnd">
              <a:noFill/>
            </a:ln>
            <a:effectLst>
              <a:glow rad="139700">
                <a:schemeClr val="accent1">
                  <a:satMod val="175000"/>
                  <a:alpha val="14000"/>
                </a:schemeClr>
              </a:glow>
            </a:effectLst>
          </c:spPr>
          <c:marker>
            <c:symbol val="circle"/>
            <c:size val="3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>
                <a:glow rad="63500">
                  <a:schemeClr val="accent1">
                    <a:satMod val="175000"/>
                    <a:alpha val="25000"/>
                  </a:schemeClr>
                </a:glow>
              </a:effectLst>
            </c:spPr>
          </c:marker>
          <c:xVal>
            <c:numRef>
              <c:f>'[Abundance vs mass accuracy.xlsx]Negative Annotated Lipids 1-6'!$G$2:$G$504</c:f>
              <c:numCache>
                <c:formatCode>General</c:formatCode>
                <c:ptCount val="503"/>
                <c:pt idx="0">
                  <c:v>8621</c:v>
                </c:pt>
                <c:pt idx="1">
                  <c:v>7173026</c:v>
                </c:pt>
                <c:pt idx="2">
                  <c:v>6398572</c:v>
                </c:pt>
                <c:pt idx="3">
                  <c:v>5991536</c:v>
                </c:pt>
                <c:pt idx="4">
                  <c:v>5967455</c:v>
                </c:pt>
                <c:pt idx="5">
                  <c:v>5377092</c:v>
                </c:pt>
                <c:pt idx="6">
                  <c:v>3565946</c:v>
                </c:pt>
                <c:pt idx="7">
                  <c:v>2657465</c:v>
                </c:pt>
                <c:pt idx="8">
                  <c:v>2238250</c:v>
                </c:pt>
                <c:pt idx="9">
                  <c:v>1850957</c:v>
                </c:pt>
                <c:pt idx="10">
                  <c:v>1845388</c:v>
                </c:pt>
                <c:pt idx="11">
                  <c:v>1365585</c:v>
                </c:pt>
                <c:pt idx="12">
                  <c:v>1177109</c:v>
                </c:pt>
                <c:pt idx="13">
                  <c:v>1064442</c:v>
                </c:pt>
                <c:pt idx="14">
                  <c:v>883828</c:v>
                </c:pt>
                <c:pt idx="15">
                  <c:v>829815</c:v>
                </c:pt>
                <c:pt idx="16">
                  <c:v>772394</c:v>
                </c:pt>
                <c:pt idx="17">
                  <c:v>723709</c:v>
                </c:pt>
                <c:pt idx="18">
                  <c:v>580990</c:v>
                </c:pt>
                <c:pt idx="19">
                  <c:v>532226</c:v>
                </c:pt>
                <c:pt idx="20">
                  <c:v>456673</c:v>
                </c:pt>
                <c:pt idx="21">
                  <c:v>252536</c:v>
                </c:pt>
                <c:pt idx="22">
                  <c:v>161938</c:v>
                </c:pt>
                <c:pt idx="23">
                  <c:v>138201</c:v>
                </c:pt>
                <c:pt idx="24">
                  <c:v>117144</c:v>
                </c:pt>
                <c:pt idx="25">
                  <c:v>82428</c:v>
                </c:pt>
                <c:pt idx="26">
                  <c:v>80263</c:v>
                </c:pt>
                <c:pt idx="27">
                  <c:v>78759</c:v>
                </c:pt>
                <c:pt idx="28">
                  <c:v>63514</c:v>
                </c:pt>
                <c:pt idx="29">
                  <c:v>56882</c:v>
                </c:pt>
                <c:pt idx="30">
                  <c:v>55222</c:v>
                </c:pt>
                <c:pt idx="31">
                  <c:v>46964</c:v>
                </c:pt>
                <c:pt idx="32">
                  <c:v>41839</c:v>
                </c:pt>
                <c:pt idx="33">
                  <c:v>41588</c:v>
                </c:pt>
                <c:pt idx="34">
                  <c:v>35371</c:v>
                </c:pt>
                <c:pt idx="35">
                  <c:v>30851</c:v>
                </c:pt>
                <c:pt idx="36">
                  <c:v>25768</c:v>
                </c:pt>
                <c:pt idx="37">
                  <c:v>22396</c:v>
                </c:pt>
                <c:pt idx="38">
                  <c:v>20697</c:v>
                </c:pt>
                <c:pt idx="39">
                  <c:v>20321</c:v>
                </c:pt>
                <c:pt idx="40">
                  <c:v>18645</c:v>
                </c:pt>
                <c:pt idx="41">
                  <c:v>17145</c:v>
                </c:pt>
                <c:pt idx="42">
                  <c:v>13344</c:v>
                </c:pt>
                <c:pt idx="43">
                  <c:v>11254</c:v>
                </c:pt>
                <c:pt idx="44">
                  <c:v>9890</c:v>
                </c:pt>
                <c:pt idx="45">
                  <c:v>9243</c:v>
                </c:pt>
                <c:pt idx="46">
                  <c:v>8190</c:v>
                </c:pt>
                <c:pt idx="47">
                  <c:v>6054</c:v>
                </c:pt>
                <c:pt idx="48">
                  <c:v>4200</c:v>
                </c:pt>
                <c:pt idx="49">
                  <c:v>3657</c:v>
                </c:pt>
                <c:pt idx="50">
                  <c:v>3648</c:v>
                </c:pt>
                <c:pt idx="51">
                  <c:v>2542</c:v>
                </c:pt>
                <c:pt idx="52">
                  <c:v>331262</c:v>
                </c:pt>
                <c:pt idx="53">
                  <c:v>287318</c:v>
                </c:pt>
                <c:pt idx="54">
                  <c:v>255350</c:v>
                </c:pt>
                <c:pt idx="55">
                  <c:v>254840</c:v>
                </c:pt>
                <c:pt idx="56">
                  <c:v>239969</c:v>
                </c:pt>
                <c:pt idx="57">
                  <c:v>212728</c:v>
                </c:pt>
                <c:pt idx="58">
                  <c:v>104193</c:v>
                </c:pt>
                <c:pt idx="59">
                  <c:v>102334</c:v>
                </c:pt>
                <c:pt idx="60">
                  <c:v>90682</c:v>
                </c:pt>
                <c:pt idx="61">
                  <c:v>83593</c:v>
                </c:pt>
                <c:pt idx="62">
                  <c:v>79244</c:v>
                </c:pt>
                <c:pt idx="63">
                  <c:v>78166</c:v>
                </c:pt>
                <c:pt idx="64">
                  <c:v>74740</c:v>
                </c:pt>
                <c:pt idx="65">
                  <c:v>74590</c:v>
                </c:pt>
                <c:pt idx="66">
                  <c:v>69724</c:v>
                </c:pt>
                <c:pt idx="67">
                  <c:v>56695</c:v>
                </c:pt>
                <c:pt idx="68">
                  <c:v>50221</c:v>
                </c:pt>
                <c:pt idx="69">
                  <c:v>45953</c:v>
                </c:pt>
                <c:pt idx="70">
                  <c:v>45864</c:v>
                </c:pt>
                <c:pt idx="71">
                  <c:v>44634</c:v>
                </c:pt>
                <c:pt idx="72">
                  <c:v>41113</c:v>
                </c:pt>
                <c:pt idx="73">
                  <c:v>37031</c:v>
                </c:pt>
                <c:pt idx="74">
                  <c:v>33025</c:v>
                </c:pt>
                <c:pt idx="75">
                  <c:v>32371</c:v>
                </c:pt>
                <c:pt idx="76">
                  <c:v>30027</c:v>
                </c:pt>
                <c:pt idx="77">
                  <c:v>29845</c:v>
                </c:pt>
                <c:pt idx="78">
                  <c:v>27258</c:v>
                </c:pt>
                <c:pt idx="79">
                  <c:v>21594</c:v>
                </c:pt>
                <c:pt idx="80">
                  <c:v>20963</c:v>
                </c:pt>
                <c:pt idx="81">
                  <c:v>20131</c:v>
                </c:pt>
                <c:pt idx="82">
                  <c:v>18708</c:v>
                </c:pt>
                <c:pt idx="83">
                  <c:v>18273</c:v>
                </c:pt>
                <c:pt idx="84">
                  <c:v>16532</c:v>
                </c:pt>
                <c:pt idx="85">
                  <c:v>15578</c:v>
                </c:pt>
                <c:pt idx="86">
                  <c:v>14998</c:v>
                </c:pt>
                <c:pt idx="87">
                  <c:v>14981</c:v>
                </c:pt>
                <c:pt idx="88">
                  <c:v>14362</c:v>
                </c:pt>
                <c:pt idx="89">
                  <c:v>13958</c:v>
                </c:pt>
                <c:pt idx="90">
                  <c:v>13151</c:v>
                </c:pt>
                <c:pt idx="91">
                  <c:v>11746</c:v>
                </c:pt>
                <c:pt idx="92">
                  <c:v>11116</c:v>
                </c:pt>
                <c:pt idx="93">
                  <c:v>9258</c:v>
                </c:pt>
                <c:pt idx="94">
                  <c:v>8999</c:v>
                </c:pt>
                <c:pt idx="95">
                  <c:v>8010</c:v>
                </c:pt>
                <c:pt idx="96">
                  <c:v>6700</c:v>
                </c:pt>
                <c:pt idx="97">
                  <c:v>3355</c:v>
                </c:pt>
                <c:pt idx="98">
                  <c:v>816153</c:v>
                </c:pt>
                <c:pt idx="99">
                  <c:v>368780</c:v>
                </c:pt>
                <c:pt idx="100">
                  <c:v>367716</c:v>
                </c:pt>
                <c:pt idx="101">
                  <c:v>266519</c:v>
                </c:pt>
                <c:pt idx="102">
                  <c:v>191625</c:v>
                </c:pt>
                <c:pt idx="103">
                  <c:v>141402</c:v>
                </c:pt>
                <c:pt idx="104">
                  <c:v>121817</c:v>
                </c:pt>
                <c:pt idx="105">
                  <c:v>116124</c:v>
                </c:pt>
                <c:pt idx="106">
                  <c:v>113276</c:v>
                </c:pt>
                <c:pt idx="107">
                  <c:v>81819</c:v>
                </c:pt>
                <c:pt idx="108">
                  <c:v>65460</c:v>
                </c:pt>
                <c:pt idx="109">
                  <c:v>64021</c:v>
                </c:pt>
                <c:pt idx="110">
                  <c:v>40998</c:v>
                </c:pt>
                <c:pt idx="111">
                  <c:v>32353</c:v>
                </c:pt>
                <c:pt idx="112">
                  <c:v>31118</c:v>
                </c:pt>
                <c:pt idx="113">
                  <c:v>24688</c:v>
                </c:pt>
                <c:pt idx="114">
                  <c:v>23253</c:v>
                </c:pt>
                <c:pt idx="115">
                  <c:v>21969</c:v>
                </c:pt>
                <c:pt idx="116">
                  <c:v>14372</c:v>
                </c:pt>
                <c:pt idx="117">
                  <c:v>12617</c:v>
                </c:pt>
                <c:pt idx="118">
                  <c:v>11971</c:v>
                </c:pt>
                <c:pt idx="119">
                  <c:v>7043</c:v>
                </c:pt>
                <c:pt idx="120">
                  <c:v>4593</c:v>
                </c:pt>
                <c:pt idx="121">
                  <c:v>4579</c:v>
                </c:pt>
                <c:pt idx="122">
                  <c:v>6160491</c:v>
                </c:pt>
                <c:pt idx="123">
                  <c:v>3181354</c:v>
                </c:pt>
                <c:pt idx="124">
                  <c:v>459763</c:v>
                </c:pt>
                <c:pt idx="125">
                  <c:v>371805</c:v>
                </c:pt>
                <c:pt idx="126">
                  <c:v>247667</c:v>
                </c:pt>
                <c:pt idx="127">
                  <c:v>236493</c:v>
                </c:pt>
                <c:pt idx="128">
                  <c:v>131714</c:v>
                </c:pt>
                <c:pt idx="129">
                  <c:v>124892</c:v>
                </c:pt>
                <c:pt idx="130">
                  <c:v>109504</c:v>
                </c:pt>
                <c:pt idx="131">
                  <c:v>80959</c:v>
                </c:pt>
                <c:pt idx="132">
                  <c:v>77323</c:v>
                </c:pt>
                <c:pt idx="133">
                  <c:v>60595</c:v>
                </c:pt>
                <c:pt idx="134">
                  <c:v>58616</c:v>
                </c:pt>
                <c:pt idx="135">
                  <c:v>55506</c:v>
                </c:pt>
                <c:pt idx="136">
                  <c:v>50058</c:v>
                </c:pt>
                <c:pt idx="137">
                  <c:v>48722</c:v>
                </c:pt>
                <c:pt idx="138">
                  <c:v>44948</c:v>
                </c:pt>
                <c:pt idx="139">
                  <c:v>41017</c:v>
                </c:pt>
                <c:pt idx="140">
                  <c:v>40420</c:v>
                </c:pt>
                <c:pt idx="141">
                  <c:v>39447</c:v>
                </c:pt>
                <c:pt idx="142">
                  <c:v>33853</c:v>
                </c:pt>
                <c:pt idx="143">
                  <c:v>33383</c:v>
                </c:pt>
                <c:pt idx="144">
                  <c:v>30749</c:v>
                </c:pt>
                <c:pt idx="145">
                  <c:v>30056</c:v>
                </c:pt>
                <c:pt idx="146">
                  <c:v>29798</c:v>
                </c:pt>
                <c:pt idx="147">
                  <c:v>26812</c:v>
                </c:pt>
                <c:pt idx="148">
                  <c:v>25992</c:v>
                </c:pt>
                <c:pt idx="149">
                  <c:v>24053</c:v>
                </c:pt>
                <c:pt idx="150">
                  <c:v>21150</c:v>
                </c:pt>
                <c:pt idx="151">
                  <c:v>20865</c:v>
                </c:pt>
                <c:pt idx="152">
                  <c:v>20064</c:v>
                </c:pt>
                <c:pt idx="153">
                  <c:v>17746</c:v>
                </c:pt>
                <c:pt idx="154">
                  <c:v>17299</c:v>
                </c:pt>
                <c:pt idx="155">
                  <c:v>15554</c:v>
                </c:pt>
                <c:pt idx="156">
                  <c:v>14890</c:v>
                </c:pt>
                <c:pt idx="157">
                  <c:v>11417</c:v>
                </c:pt>
                <c:pt idx="158">
                  <c:v>2957</c:v>
                </c:pt>
                <c:pt idx="159">
                  <c:v>8328757</c:v>
                </c:pt>
                <c:pt idx="160">
                  <c:v>8257842</c:v>
                </c:pt>
                <c:pt idx="161">
                  <c:v>4624418</c:v>
                </c:pt>
                <c:pt idx="162">
                  <c:v>2611626</c:v>
                </c:pt>
                <c:pt idx="163">
                  <c:v>2581140</c:v>
                </c:pt>
                <c:pt idx="164">
                  <c:v>2244720</c:v>
                </c:pt>
                <c:pt idx="165">
                  <c:v>2031375</c:v>
                </c:pt>
                <c:pt idx="166">
                  <c:v>1283366</c:v>
                </c:pt>
                <c:pt idx="167">
                  <c:v>1200668</c:v>
                </c:pt>
                <c:pt idx="168">
                  <c:v>1108649</c:v>
                </c:pt>
                <c:pt idx="169">
                  <c:v>786312</c:v>
                </c:pt>
                <c:pt idx="170">
                  <c:v>555569</c:v>
                </c:pt>
                <c:pt idx="171">
                  <c:v>487766</c:v>
                </c:pt>
                <c:pt idx="172">
                  <c:v>433635</c:v>
                </c:pt>
                <c:pt idx="173">
                  <c:v>330110</c:v>
                </c:pt>
                <c:pt idx="174">
                  <c:v>302891</c:v>
                </c:pt>
                <c:pt idx="175">
                  <c:v>298128</c:v>
                </c:pt>
                <c:pt idx="176">
                  <c:v>277223</c:v>
                </c:pt>
                <c:pt idx="177">
                  <c:v>260951</c:v>
                </c:pt>
                <c:pt idx="178">
                  <c:v>228248</c:v>
                </c:pt>
                <c:pt idx="179">
                  <c:v>215118</c:v>
                </c:pt>
                <c:pt idx="180">
                  <c:v>187207</c:v>
                </c:pt>
                <c:pt idx="181">
                  <c:v>185894</c:v>
                </c:pt>
                <c:pt idx="182">
                  <c:v>149803</c:v>
                </c:pt>
                <c:pt idx="183">
                  <c:v>125593</c:v>
                </c:pt>
                <c:pt idx="184">
                  <c:v>108539</c:v>
                </c:pt>
                <c:pt idx="185">
                  <c:v>94504</c:v>
                </c:pt>
                <c:pt idx="186">
                  <c:v>76649</c:v>
                </c:pt>
                <c:pt idx="187">
                  <c:v>54725</c:v>
                </c:pt>
                <c:pt idx="188">
                  <c:v>33424</c:v>
                </c:pt>
                <c:pt idx="189">
                  <c:v>28197</c:v>
                </c:pt>
                <c:pt idx="190">
                  <c:v>28193</c:v>
                </c:pt>
                <c:pt idx="191">
                  <c:v>18918</c:v>
                </c:pt>
                <c:pt idx="192">
                  <c:v>17043</c:v>
                </c:pt>
                <c:pt idx="193">
                  <c:v>16675</c:v>
                </c:pt>
                <c:pt idx="194">
                  <c:v>16539</c:v>
                </c:pt>
                <c:pt idx="195">
                  <c:v>16111</c:v>
                </c:pt>
                <c:pt idx="196">
                  <c:v>15294</c:v>
                </c:pt>
                <c:pt idx="197">
                  <c:v>10833</c:v>
                </c:pt>
                <c:pt idx="198">
                  <c:v>10161</c:v>
                </c:pt>
                <c:pt idx="199">
                  <c:v>8914</c:v>
                </c:pt>
                <c:pt idx="200">
                  <c:v>7196</c:v>
                </c:pt>
                <c:pt idx="201">
                  <c:v>178561</c:v>
                </c:pt>
                <c:pt idx="202">
                  <c:v>47382</c:v>
                </c:pt>
                <c:pt idx="203">
                  <c:v>31759</c:v>
                </c:pt>
                <c:pt idx="204">
                  <c:v>21996</c:v>
                </c:pt>
                <c:pt idx="205">
                  <c:v>21906</c:v>
                </c:pt>
                <c:pt idx="206">
                  <c:v>8410</c:v>
                </c:pt>
                <c:pt idx="207">
                  <c:v>8171</c:v>
                </c:pt>
                <c:pt idx="208">
                  <c:v>6259</c:v>
                </c:pt>
                <c:pt idx="209">
                  <c:v>4305</c:v>
                </c:pt>
                <c:pt idx="210">
                  <c:v>734553</c:v>
                </c:pt>
                <c:pt idx="211">
                  <c:v>471624</c:v>
                </c:pt>
                <c:pt idx="212">
                  <c:v>437177</c:v>
                </c:pt>
                <c:pt idx="213">
                  <c:v>388843</c:v>
                </c:pt>
                <c:pt idx="214">
                  <c:v>354992</c:v>
                </c:pt>
                <c:pt idx="215">
                  <c:v>94100</c:v>
                </c:pt>
                <c:pt idx="216">
                  <c:v>58708</c:v>
                </c:pt>
                <c:pt idx="217">
                  <c:v>58578</c:v>
                </c:pt>
                <c:pt idx="218">
                  <c:v>51146</c:v>
                </c:pt>
                <c:pt idx="219">
                  <c:v>24605</c:v>
                </c:pt>
                <c:pt idx="220">
                  <c:v>7949</c:v>
                </c:pt>
                <c:pt idx="221">
                  <c:v>7851</c:v>
                </c:pt>
                <c:pt idx="222">
                  <c:v>6811</c:v>
                </c:pt>
                <c:pt idx="223">
                  <c:v>1790691</c:v>
                </c:pt>
                <c:pt idx="224">
                  <c:v>1302373</c:v>
                </c:pt>
                <c:pt idx="225">
                  <c:v>1156165</c:v>
                </c:pt>
                <c:pt idx="226">
                  <c:v>902232</c:v>
                </c:pt>
                <c:pt idx="227">
                  <c:v>693383</c:v>
                </c:pt>
                <c:pt idx="228">
                  <c:v>676168</c:v>
                </c:pt>
                <c:pt idx="229">
                  <c:v>533058</c:v>
                </c:pt>
                <c:pt idx="230">
                  <c:v>492931</c:v>
                </c:pt>
                <c:pt idx="231">
                  <c:v>393415</c:v>
                </c:pt>
                <c:pt idx="232">
                  <c:v>318382</c:v>
                </c:pt>
                <c:pt idx="233">
                  <c:v>296619</c:v>
                </c:pt>
                <c:pt idx="234">
                  <c:v>221146</c:v>
                </c:pt>
                <c:pt idx="235">
                  <c:v>141199</c:v>
                </c:pt>
                <c:pt idx="236">
                  <c:v>139456</c:v>
                </c:pt>
                <c:pt idx="237">
                  <c:v>133113</c:v>
                </c:pt>
                <c:pt idx="238">
                  <c:v>124788</c:v>
                </c:pt>
                <c:pt idx="239">
                  <c:v>110006</c:v>
                </c:pt>
                <c:pt idx="240">
                  <c:v>109721</c:v>
                </c:pt>
                <c:pt idx="241">
                  <c:v>106792</c:v>
                </c:pt>
                <c:pt idx="242">
                  <c:v>69046</c:v>
                </c:pt>
                <c:pt idx="243">
                  <c:v>59264</c:v>
                </c:pt>
                <c:pt idx="244">
                  <c:v>48843</c:v>
                </c:pt>
                <c:pt idx="245">
                  <c:v>45965</c:v>
                </c:pt>
                <c:pt idx="246">
                  <c:v>36192</c:v>
                </c:pt>
                <c:pt idx="247">
                  <c:v>35045</c:v>
                </c:pt>
                <c:pt idx="248">
                  <c:v>33982</c:v>
                </c:pt>
                <c:pt idx="249">
                  <c:v>30458</c:v>
                </c:pt>
                <c:pt idx="250">
                  <c:v>29227</c:v>
                </c:pt>
                <c:pt idx="251">
                  <c:v>27894</c:v>
                </c:pt>
                <c:pt idx="252">
                  <c:v>24193</c:v>
                </c:pt>
                <c:pt idx="253">
                  <c:v>5854</c:v>
                </c:pt>
                <c:pt idx="254">
                  <c:v>747131</c:v>
                </c:pt>
                <c:pt idx="255">
                  <c:v>242669</c:v>
                </c:pt>
                <c:pt idx="256">
                  <c:v>227253</c:v>
                </c:pt>
                <c:pt idx="257">
                  <c:v>197142</c:v>
                </c:pt>
                <c:pt idx="258">
                  <c:v>106844</c:v>
                </c:pt>
                <c:pt idx="259">
                  <c:v>105581</c:v>
                </c:pt>
                <c:pt idx="260">
                  <c:v>98742</c:v>
                </c:pt>
                <c:pt idx="261">
                  <c:v>53511</c:v>
                </c:pt>
                <c:pt idx="262">
                  <c:v>22097</c:v>
                </c:pt>
                <c:pt idx="263">
                  <c:v>9876</c:v>
                </c:pt>
                <c:pt idx="264">
                  <c:v>9221</c:v>
                </c:pt>
                <c:pt idx="265">
                  <c:v>6020</c:v>
                </c:pt>
                <c:pt idx="266">
                  <c:v>5736</c:v>
                </c:pt>
                <c:pt idx="267">
                  <c:v>1490463</c:v>
                </c:pt>
                <c:pt idx="268">
                  <c:v>491458</c:v>
                </c:pt>
                <c:pt idx="269">
                  <c:v>83553</c:v>
                </c:pt>
                <c:pt idx="270">
                  <c:v>14212</c:v>
                </c:pt>
                <c:pt idx="271">
                  <c:v>300713</c:v>
                </c:pt>
                <c:pt idx="272">
                  <c:v>205542</c:v>
                </c:pt>
                <c:pt idx="273">
                  <c:v>99831</c:v>
                </c:pt>
                <c:pt idx="274">
                  <c:v>55173</c:v>
                </c:pt>
                <c:pt idx="275">
                  <c:v>50718</c:v>
                </c:pt>
                <c:pt idx="276">
                  <c:v>48822</c:v>
                </c:pt>
                <c:pt idx="277">
                  <c:v>43442</c:v>
                </c:pt>
                <c:pt idx="278">
                  <c:v>24620</c:v>
                </c:pt>
                <c:pt idx="279">
                  <c:v>16097</c:v>
                </c:pt>
                <c:pt idx="280">
                  <c:v>14324</c:v>
                </c:pt>
                <c:pt idx="281">
                  <c:v>7610</c:v>
                </c:pt>
                <c:pt idx="282">
                  <c:v>15932</c:v>
                </c:pt>
                <c:pt idx="283">
                  <c:v>10732</c:v>
                </c:pt>
                <c:pt idx="284">
                  <c:v>546074</c:v>
                </c:pt>
                <c:pt idx="285">
                  <c:v>236860</c:v>
                </c:pt>
                <c:pt idx="286">
                  <c:v>172075</c:v>
                </c:pt>
                <c:pt idx="287">
                  <c:v>13116</c:v>
                </c:pt>
                <c:pt idx="288">
                  <c:v>11524</c:v>
                </c:pt>
                <c:pt idx="289">
                  <c:v>2090043</c:v>
                </c:pt>
                <c:pt idx="290">
                  <c:v>1783544</c:v>
                </c:pt>
                <c:pt idx="291">
                  <c:v>1546263</c:v>
                </c:pt>
                <c:pt idx="292">
                  <c:v>1418360</c:v>
                </c:pt>
                <c:pt idx="293">
                  <c:v>1413742</c:v>
                </c:pt>
                <c:pt idx="294">
                  <c:v>1157231</c:v>
                </c:pt>
                <c:pt idx="295">
                  <c:v>1096983</c:v>
                </c:pt>
                <c:pt idx="296">
                  <c:v>975787</c:v>
                </c:pt>
                <c:pt idx="297">
                  <c:v>897494</c:v>
                </c:pt>
                <c:pt idx="298">
                  <c:v>725514</c:v>
                </c:pt>
                <c:pt idx="299">
                  <c:v>631174</c:v>
                </c:pt>
                <c:pt idx="300">
                  <c:v>614009</c:v>
                </c:pt>
                <c:pt idx="301">
                  <c:v>444526</c:v>
                </c:pt>
                <c:pt idx="302">
                  <c:v>360102</c:v>
                </c:pt>
                <c:pt idx="303">
                  <c:v>305808</c:v>
                </c:pt>
                <c:pt idx="304">
                  <c:v>259246</c:v>
                </c:pt>
                <c:pt idx="305">
                  <c:v>258222</c:v>
                </c:pt>
                <c:pt idx="306">
                  <c:v>241278</c:v>
                </c:pt>
                <c:pt idx="307">
                  <c:v>216812</c:v>
                </c:pt>
                <c:pt idx="308">
                  <c:v>200801</c:v>
                </c:pt>
                <c:pt idx="309">
                  <c:v>172303</c:v>
                </c:pt>
                <c:pt idx="310">
                  <c:v>162036</c:v>
                </c:pt>
                <c:pt idx="311">
                  <c:v>159934</c:v>
                </c:pt>
                <c:pt idx="312">
                  <c:v>158211</c:v>
                </c:pt>
                <c:pt idx="313">
                  <c:v>144876</c:v>
                </c:pt>
                <c:pt idx="314">
                  <c:v>143790</c:v>
                </c:pt>
                <c:pt idx="315">
                  <c:v>140405</c:v>
                </c:pt>
                <c:pt idx="316">
                  <c:v>131711</c:v>
                </c:pt>
                <c:pt idx="317">
                  <c:v>130041</c:v>
                </c:pt>
                <c:pt idx="318">
                  <c:v>109494</c:v>
                </c:pt>
                <c:pt idx="319">
                  <c:v>101994</c:v>
                </c:pt>
                <c:pt idx="320">
                  <c:v>97683</c:v>
                </c:pt>
                <c:pt idx="321">
                  <c:v>97420</c:v>
                </c:pt>
                <c:pt idx="322">
                  <c:v>92580</c:v>
                </c:pt>
                <c:pt idx="323">
                  <c:v>73254</c:v>
                </c:pt>
                <c:pt idx="324">
                  <c:v>70981</c:v>
                </c:pt>
                <c:pt idx="325">
                  <c:v>63846</c:v>
                </c:pt>
                <c:pt idx="326">
                  <c:v>63618</c:v>
                </c:pt>
                <c:pt idx="327">
                  <c:v>61388</c:v>
                </c:pt>
                <c:pt idx="328">
                  <c:v>59474</c:v>
                </c:pt>
                <c:pt idx="329">
                  <c:v>56314</c:v>
                </c:pt>
                <c:pt idx="330">
                  <c:v>42894</c:v>
                </c:pt>
                <c:pt idx="331">
                  <c:v>40720</c:v>
                </c:pt>
                <c:pt idx="332">
                  <c:v>35844</c:v>
                </c:pt>
                <c:pt idx="333">
                  <c:v>32591</c:v>
                </c:pt>
                <c:pt idx="334">
                  <c:v>32367</c:v>
                </c:pt>
                <c:pt idx="335">
                  <c:v>31287</c:v>
                </c:pt>
                <c:pt idx="336">
                  <c:v>26868</c:v>
                </c:pt>
                <c:pt idx="337">
                  <c:v>26186</c:v>
                </c:pt>
                <c:pt idx="338">
                  <c:v>22057</c:v>
                </c:pt>
                <c:pt idx="339">
                  <c:v>21678</c:v>
                </c:pt>
                <c:pt idx="340">
                  <c:v>21370</c:v>
                </c:pt>
                <c:pt idx="341">
                  <c:v>20168</c:v>
                </c:pt>
                <c:pt idx="342">
                  <c:v>19119</c:v>
                </c:pt>
                <c:pt idx="343">
                  <c:v>18960</c:v>
                </c:pt>
                <c:pt idx="344">
                  <c:v>18210</c:v>
                </c:pt>
                <c:pt idx="345">
                  <c:v>16242</c:v>
                </c:pt>
                <c:pt idx="346">
                  <c:v>14254</c:v>
                </c:pt>
                <c:pt idx="347">
                  <c:v>13078</c:v>
                </c:pt>
                <c:pt idx="348">
                  <c:v>11222</c:v>
                </c:pt>
                <c:pt idx="349">
                  <c:v>10488</c:v>
                </c:pt>
                <c:pt idx="350">
                  <c:v>10402</c:v>
                </c:pt>
                <c:pt idx="351">
                  <c:v>9877</c:v>
                </c:pt>
                <c:pt idx="352">
                  <c:v>9602</c:v>
                </c:pt>
                <c:pt idx="353">
                  <c:v>8499</c:v>
                </c:pt>
                <c:pt idx="354">
                  <c:v>8499</c:v>
                </c:pt>
                <c:pt idx="355">
                  <c:v>7751</c:v>
                </c:pt>
                <c:pt idx="356">
                  <c:v>6711</c:v>
                </c:pt>
                <c:pt idx="357">
                  <c:v>5504</c:v>
                </c:pt>
                <c:pt idx="358">
                  <c:v>4833</c:v>
                </c:pt>
                <c:pt idx="359">
                  <c:v>4684</c:v>
                </c:pt>
                <c:pt idx="360">
                  <c:v>396572</c:v>
                </c:pt>
                <c:pt idx="361">
                  <c:v>267814</c:v>
                </c:pt>
                <c:pt idx="362">
                  <c:v>259290</c:v>
                </c:pt>
                <c:pt idx="363">
                  <c:v>169781</c:v>
                </c:pt>
                <c:pt idx="364">
                  <c:v>143381</c:v>
                </c:pt>
                <c:pt idx="365">
                  <c:v>138304</c:v>
                </c:pt>
                <c:pt idx="366">
                  <c:v>132870</c:v>
                </c:pt>
                <c:pt idx="367">
                  <c:v>127308</c:v>
                </c:pt>
                <c:pt idx="368">
                  <c:v>79436</c:v>
                </c:pt>
                <c:pt idx="369">
                  <c:v>63293</c:v>
                </c:pt>
                <c:pt idx="370">
                  <c:v>53849</c:v>
                </c:pt>
                <c:pt idx="371">
                  <c:v>51350</c:v>
                </c:pt>
                <c:pt idx="372">
                  <c:v>50464</c:v>
                </c:pt>
                <c:pt idx="373">
                  <c:v>45609</c:v>
                </c:pt>
                <c:pt idx="374">
                  <c:v>42410</c:v>
                </c:pt>
                <c:pt idx="375">
                  <c:v>33237</c:v>
                </c:pt>
                <c:pt idx="376">
                  <c:v>30739</c:v>
                </c:pt>
                <c:pt idx="377">
                  <c:v>26252</c:v>
                </c:pt>
                <c:pt idx="378">
                  <c:v>25467</c:v>
                </c:pt>
                <c:pt idx="379">
                  <c:v>25347</c:v>
                </c:pt>
                <c:pt idx="380">
                  <c:v>24699</c:v>
                </c:pt>
                <c:pt idx="381">
                  <c:v>23130</c:v>
                </c:pt>
                <c:pt idx="382">
                  <c:v>19420</c:v>
                </c:pt>
                <c:pt idx="383">
                  <c:v>17259</c:v>
                </c:pt>
                <c:pt idx="384">
                  <c:v>15385</c:v>
                </c:pt>
                <c:pt idx="385">
                  <c:v>14886</c:v>
                </c:pt>
                <c:pt idx="386">
                  <c:v>14353</c:v>
                </c:pt>
                <c:pt idx="387">
                  <c:v>12969</c:v>
                </c:pt>
                <c:pt idx="388">
                  <c:v>12685</c:v>
                </c:pt>
                <c:pt idx="389">
                  <c:v>12347</c:v>
                </c:pt>
                <c:pt idx="390">
                  <c:v>12086</c:v>
                </c:pt>
                <c:pt idx="391">
                  <c:v>10561</c:v>
                </c:pt>
                <c:pt idx="392">
                  <c:v>10551</c:v>
                </c:pt>
                <c:pt idx="393">
                  <c:v>10412</c:v>
                </c:pt>
                <c:pt idx="394">
                  <c:v>10174</c:v>
                </c:pt>
                <c:pt idx="395">
                  <c:v>9270</c:v>
                </c:pt>
                <c:pt idx="396">
                  <c:v>8601</c:v>
                </c:pt>
                <c:pt idx="397">
                  <c:v>5813</c:v>
                </c:pt>
                <c:pt idx="398">
                  <c:v>5559</c:v>
                </c:pt>
                <c:pt idx="399">
                  <c:v>4218</c:v>
                </c:pt>
                <c:pt idx="400">
                  <c:v>3674</c:v>
                </c:pt>
                <c:pt idx="401">
                  <c:v>3544</c:v>
                </c:pt>
                <c:pt idx="402">
                  <c:v>3019</c:v>
                </c:pt>
                <c:pt idx="403">
                  <c:v>6082317</c:v>
                </c:pt>
                <c:pt idx="404">
                  <c:v>5784160</c:v>
                </c:pt>
                <c:pt idx="405">
                  <c:v>2053308</c:v>
                </c:pt>
                <c:pt idx="406">
                  <c:v>1915672</c:v>
                </c:pt>
                <c:pt idx="407">
                  <c:v>1508164</c:v>
                </c:pt>
                <c:pt idx="408">
                  <c:v>508045</c:v>
                </c:pt>
                <c:pt idx="409">
                  <c:v>47201</c:v>
                </c:pt>
                <c:pt idx="410">
                  <c:v>33790</c:v>
                </c:pt>
                <c:pt idx="411">
                  <c:v>19139</c:v>
                </c:pt>
                <c:pt idx="412">
                  <c:v>10334</c:v>
                </c:pt>
                <c:pt idx="413">
                  <c:v>9635</c:v>
                </c:pt>
                <c:pt idx="414">
                  <c:v>7046088</c:v>
                </c:pt>
                <c:pt idx="415">
                  <c:v>1736074</c:v>
                </c:pt>
                <c:pt idx="416">
                  <c:v>1189791</c:v>
                </c:pt>
                <c:pt idx="417">
                  <c:v>674301</c:v>
                </c:pt>
                <c:pt idx="418">
                  <c:v>664211</c:v>
                </c:pt>
                <c:pt idx="419">
                  <c:v>347581</c:v>
                </c:pt>
                <c:pt idx="420">
                  <c:v>253410</c:v>
                </c:pt>
                <c:pt idx="421">
                  <c:v>230892</c:v>
                </c:pt>
                <c:pt idx="422">
                  <c:v>186710</c:v>
                </c:pt>
                <c:pt idx="423">
                  <c:v>184094</c:v>
                </c:pt>
                <c:pt idx="424">
                  <c:v>181098</c:v>
                </c:pt>
                <c:pt idx="425">
                  <c:v>167852</c:v>
                </c:pt>
                <c:pt idx="426">
                  <c:v>148492</c:v>
                </c:pt>
                <c:pt idx="427">
                  <c:v>143479</c:v>
                </c:pt>
                <c:pt idx="428">
                  <c:v>122944</c:v>
                </c:pt>
                <c:pt idx="429">
                  <c:v>97388</c:v>
                </c:pt>
                <c:pt idx="430">
                  <c:v>86715</c:v>
                </c:pt>
                <c:pt idx="431">
                  <c:v>64392</c:v>
                </c:pt>
                <c:pt idx="432">
                  <c:v>32616</c:v>
                </c:pt>
                <c:pt idx="433">
                  <c:v>31006</c:v>
                </c:pt>
                <c:pt idx="434">
                  <c:v>21574</c:v>
                </c:pt>
                <c:pt idx="435">
                  <c:v>17675</c:v>
                </c:pt>
                <c:pt idx="436">
                  <c:v>13796</c:v>
                </c:pt>
                <c:pt idx="437">
                  <c:v>10905</c:v>
                </c:pt>
                <c:pt idx="438">
                  <c:v>10195</c:v>
                </c:pt>
                <c:pt idx="439">
                  <c:v>9667</c:v>
                </c:pt>
                <c:pt idx="440">
                  <c:v>6938</c:v>
                </c:pt>
                <c:pt idx="441">
                  <c:v>5601</c:v>
                </c:pt>
                <c:pt idx="442">
                  <c:v>3660</c:v>
                </c:pt>
                <c:pt idx="443">
                  <c:v>302121</c:v>
                </c:pt>
                <c:pt idx="444">
                  <c:v>27469</c:v>
                </c:pt>
                <c:pt idx="445">
                  <c:v>26112</c:v>
                </c:pt>
                <c:pt idx="446">
                  <c:v>24707</c:v>
                </c:pt>
                <c:pt idx="447">
                  <c:v>24686</c:v>
                </c:pt>
                <c:pt idx="448">
                  <c:v>15443</c:v>
                </c:pt>
                <c:pt idx="449">
                  <c:v>1971399</c:v>
                </c:pt>
                <c:pt idx="450">
                  <c:v>1699776</c:v>
                </c:pt>
                <c:pt idx="451">
                  <c:v>1638197</c:v>
                </c:pt>
                <c:pt idx="452">
                  <c:v>1388345</c:v>
                </c:pt>
                <c:pt idx="453">
                  <c:v>1356087</c:v>
                </c:pt>
                <c:pt idx="454">
                  <c:v>1135391</c:v>
                </c:pt>
                <c:pt idx="455">
                  <c:v>1092479</c:v>
                </c:pt>
                <c:pt idx="456">
                  <c:v>1033810</c:v>
                </c:pt>
                <c:pt idx="457">
                  <c:v>1014779</c:v>
                </c:pt>
                <c:pt idx="458">
                  <c:v>951359</c:v>
                </c:pt>
                <c:pt idx="459">
                  <c:v>712186</c:v>
                </c:pt>
                <c:pt idx="460">
                  <c:v>708246</c:v>
                </c:pt>
                <c:pt idx="461">
                  <c:v>669074</c:v>
                </c:pt>
                <c:pt idx="462">
                  <c:v>620929</c:v>
                </c:pt>
                <c:pt idx="463">
                  <c:v>553177</c:v>
                </c:pt>
                <c:pt idx="464">
                  <c:v>500348</c:v>
                </c:pt>
                <c:pt idx="465">
                  <c:v>349220</c:v>
                </c:pt>
                <c:pt idx="466">
                  <c:v>333895</c:v>
                </c:pt>
                <c:pt idx="467">
                  <c:v>317566</c:v>
                </c:pt>
                <c:pt idx="468">
                  <c:v>292888</c:v>
                </c:pt>
                <c:pt idx="469">
                  <c:v>252989</c:v>
                </c:pt>
                <c:pt idx="470">
                  <c:v>251270</c:v>
                </c:pt>
                <c:pt idx="471">
                  <c:v>223381</c:v>
                </c:pt>
                <c:pt idx="472">
                  <c:v>141210</c:v>
                </c:pt>
                <c:pt idx="473">
                  <c:v>129088</c:v>
                </c:pt>
                <c:pt idx="474">
                  <c:v>122815</c:v>
                </c:pt>
                <c:pt idx="475">
                  <c:v>106471</c:v>
                </c:pt>
                <c:pt idx="476">
                  <c:v>93841</c:v>
                </c:pt>
                <c:pt idx="477">
                  <c:v>84663</c:v>
                </c:pt>
                <c:pt idx="478">
                  <c:v>64978</c:v>
                </c:pt>
                <c:pt idx="479">
                  <c:v>47172</c:v>
                </c:pt>
                <c:pt idx="480">
                  <c:v>47004</c:v>
                </c:pt>
                <c:pt idx="481">
                  <c:v>43991</c:v>
                </c:pt>
                <c:pt idx="482">
                  <c:v>42683</c:v>
                </c:pt>
                <c:pt idx="483">
                  <c:v>41242</c:v>
                </c:pt>
                <c:pt idx="484">
                  <c:v>38108</c:v>
                </c:pt>
                <c:pt idx="485">
                  <c:v>36501</c:v>
                </c:pt>
                <c:pt idx="486">
                  <c:v>34946</c:v>
                </c:pt>
                <c:pt idx="487">
                  <c:v>30547</c:v>
                </c:pt>
                <c:pt idx="488">
                  <c:v>25563</c:v>
                </c:pt>
                <c:pt idx="489">
                  <c:v>24796</c:v>
                </c:pt>
                <c:pt idx="490">
                  <c:v>23306</c:v>
                </c:pt>
                <c:pt idx="491">
                  <c:v>20969</c:v>
                </c:pt>
                <c:pt idx="492">
                  <c:v>20890</c:v>
                </c:pt>
                <c:pt idx="493">
                  <c:v>17003</c:v>
                </c:pt>
                <c:pt idx="494">
                  <c:v>15248</c:v>
                </c:pt>
                <c:pt idx="495">
                  <c:v>14080</c:v>
                </c:pt>
                <c:pt idx="496">
                  <c:v>7261</c:v>
                </c:pt>
                <c:pt idx="497">
                  <c:v>6257</c:v>
                </c:pt>
                <c:pt idx="498">
                  <c:v>5603</c:v>
                </c:pt>
                <c:pt idx="499">
                  <c:v>5447</c:v>
                </c:pt>
                <c:pt idx="500">
                  <c:v>4497</c:v>
                </c:pt>
                <c:pt idx="501">
                  <c:v>3891</c:v>
                </c:pt>
                <c:pt idx="502">
                  <c:v>128142</c:v>
                </c:pt>
              </c:numCache>
            </c:numRef>
          </c:xVal>
          <c:yVal>
            <c:numRef>
              <c:f>'[Abundance vs mass accuracy.xlsx]Negative Annotated Lipids 1-6'!$Q$2:$Q$504</c:f>
              <c:numCache>
                <c:formatCode>General</c:formatCode>
                <c:ptCount val="503"/>
                <c:pt idx="0">
                  <c:v>-1.1000000000000001</c:v>
                </c:pt>
                <c:pt idx="1">
                  <c:v>0</c:v>
                </c:pt>
                <c:pt idx="2">
                  <c:v>-0.1</c:v>
                </c:pt>
                <c:pt idx="3">
                  <c:v>0</c:v>
                </c:pt>
                <c:pt idx="4">
                  <c:v>-0.2</c:v>
                </c:pt>
                <c:pt idx="5">
                  <c:v>0</c:v>
                </c:pt>
                <c:pt idx="6">
                  <c:v>0.2</c:v>
                </c:pt>
                <c:pt idx="7">
                  <c:v>0</c:v>
                </c:pt>
                <c:pt idx="8">
                  <c:v>-0.1</c:v>
                </c:pt>
                <c:pt idx="9">
                  <c:v>-0.1</c:v>
                </c:pt>
                <c:pt idx="10">
                  <c:v>-0.1</c:v>
                </c:pt>
                <c:pt idx="11">
                  <c:v>-0.9</c:v>
                </c:pt>
                <c:pt idx="12">
                  <c:v>-0.1</c:v>
                </c:pt>
                <c:pt idx="13">
                  <c:v>0.1</c:v>
                </c:pt>
                <c:pt idx="14">
                  <c:v>0.1</c:v>
                </c:pt>
                <c:pt idx="15">
                  <c:v>-0.3</c:v>
                </c:pt>
                <c:pt idx="16">
                  <c:v>-0.2</c:v>
                </c:pt>
                <c:pt idx="17">
                  <c:v>0.1</c:v>
                </c:pt>
                <c:pt idx="18">
                  <c:v>-0.1</c:v>
                </c:pt>
                <c:pt idx="19">
                  <c:v>-0.1</c:v>
                </c:pt>
                <c:pt idx="20">
                  <c:v>-1</c:v>
                </c:pt>
                <c:pt idx="21">
                  <c:v>-0.2</c:v>
                </c:pt>
                <c:pt idx="22">
                  <c:v>-0.8</c:v>
                </c:pt>
                <c:pt idx="23">
                  <c:v>-0.1</c:v>
                </c:pt>
                <c:pt idx="24">
                  <c:v>-0.4</c:v>
                </c:pt>
                <c:pt idx="25">
                  <c:v>-0.3</c:v>
                </c:pt>
                <c:pt idx="26">
                  <c:v>-0.2</c:v>
                </c:pt>
                <c:pt idx="27">
                  <c:v>-0.3</c:v>
                </c:pt>
                <c:pt idx="28">
                  <c:v>-0.2</c:v>
                </c:pt>
                <c:pt idx="29">
                  <c:v>0</c:v>
                </c:pt>
                <c:pt idx="30">
                  <c:v>-0.5</c:v>
                </c:pt>
                <c:pt idx="31">
                  <c:v>-0.2</c:v>
                </c:pt>
                <c:pt idx="32">
                  <c:v>-0.3</c:v>
                </c:pt>
                <c:pt idx="33">
                  <c:v>-1.1000000000000001</c:v>
                </c:pt>
                <c:pt idx="34">
                  <c:v>-0.6</c:v>
                </c:pt>
                <c:pt idx="35">
                  <c:v>-0.2</c:v>
                </c:pt>
                <c:pt idx="36">
                  <c:v>-0.2</c:v>
                </c:pt>
                <c:pt idx="37">
                  <c:v>-2.7</c:v>
                </c:pt>
                <c:pt idx="38">
                  <c:v>-0.3</c:v>
                </c:pt>
                <c:pt idx="39">
                  <c:v>-0.2</c:v>
                </c:pt>
                <c:pt idx="40">
                  <c:v>-0.6</c:v>
                </c:pt>
                <c:pt idx="41">
                  <c:v>-0.4</c:v>
                </c:pt>
                <c:pt idx="42">
                  <c:v>-0.7</c:v>
                </c:pt>
                <c:pt idx="43">
                  <c:v>0.1</c:v>
                </c:pt>
                <c:pt idx="44">
                  <c:v>-0.1</c:v>
                </c:pt>
                <c:pt idx="45">
                  <c:v>-0.8</c:v>
                </c:pt>
                <c:pt idx="46">
                  <c:v>-0.5</c:v>
                </c:pt>
                <c:pt idx="47">
                  <c:v>-0.7</c:v>
                </c:pt>
                <c:pt idx="48">
                  <c:v>-0.2</c:v>
                </c:pt>
                <c:pt idx="49">
                  <c:v>-1.4</c:v>
                </c:pt>
                <c:pt idx="50">
                  <c:v>0.3</c:v>
                </c:pt>
                <c:pt idx="51">
                  <c:v>2.9</c:v>
                </c:pt>
                <c:pt idx="52">
                  <c:v>-0.3</c:v>
                </c:pt>
                <c:pt idx="53">
                  <c:v>-0.2</c:v>
                </c:pt>
                <c:pt idx="54">
                  <c:v>-0.2</c:v>
                </c:pt>
                <c:pt idx="55">
                  <c:v>-0.2</c:v>
                </c:pt>
                <c:pt idx="56">
                  <c:v>-0.1</c:v>
                </c:pt>
                <c:pt idx="57">
                  <c:v>-0.1</c:v>
                </c:pt>
                <c:pt idx="58">
                  <c:v>-0.2</c:v>
                </c:pt>
                <c:pt idx="59">
                  <c:v>-0.3</c:v>
                </c:pt>
                <c:pt idx="60">
                  <c:v>-0.2</c:v>
                </c:pt>
                <c:pt idx="61">
                  <c:v>-0.3</c:v>
                </c:pt>
                <c:pt idx="62">
                  <c:v>-0.3</c:v>
                </c:pt>
                <c:pt idx="63">
                  <c:v>-0.4</c:v>
                </c:pt>
                <c:pt idx="64">
                  <c:v>-0.3</c:v>
                </c:pt>
                <c:pt idx="65">
                  <c:v>-0.4</c:v>
                </c:pt>
                <c:pt idx="66">
                  <c:v>0.1</c:v>
                </c:pt>
                <c:pt idx="67">
                  <c:v>-0.3</c:v>
                </c:pt>
                <c:pt idx="68">
                  <c:v>-0.1</c:v>
                </c:pt>
                <c:pt idx="69">
                  <c:v>-0.3</c:v>
                </c:pt>
                <c:pt idx="70">
                  <c:v>-0.3</c:v>
                </c:pt>
                <c:pt idx="71">
                  <c:v>-0.4</c:v>
                </c:pt>
                <c:pt idx="72">
                  <c:v>-0.5</c:v>
                </c:pt>
                <c:pt idx="73">
                  <c:v>-1.2</c:v>
                </c:pt>
                <c:pt idx="74">
                  <c:v>-0.5</c:v>
                </c:pt>
                <c:pt idx="75">
                  <c:v>-0.3</c:v>
                </c:pt>
                <c:pt idx="76">
                  <c:v>-0.4</c:v>
                </c:pt>
                <c:pt idx="77">
                  <c:v>-0.3</c:v>
                </c:pt>
                <c:pt idx="78">
                  <c:v>-0.4</c:v>
                </c:pt>
                <c:pt idx="79">
                  <c:v>-0.5</c:v>
                </c:pt>
                <c:pt idx="80">
                  <c:v>-0.8</c:v>
                </c:pt>
                <c:pt idx="81">
                  <c:v>-0.4</c:v>
                </c:pt>
                <c:pt idx="82">
                  <c:v>-0.5</c:v>
                </c:pt>
                <c:pt idx="83">
                  <c:v>0.1</c:v>
                </c:pt>
                <c:pt idx="84">
                  <c:v>-0.6</c:v>
                </c:pt>
                <c:pt idx="85">
                  <c:v>-0.6</c:v>
                </c:pt>
                <c:pt idx="86">
                  <c:v>-0.3</c:v>
                </c:pt>
                <c:pt idx="87">
                  <c:v>-0.8</c:v>
                </c:pt>
                <c:pt idx="88">
                  <c:v>1.7</c:v>
                </c:pt>
                <c:pt idx="89">
                  <c:v>-0.4</c:v>
                </c:pt>
                <c:pt idx="90">
                  <c:v>-0.4</c:v>
                </c:pt>
                <c:pt idx="91">
                  <c:v>-0.6</c:v>
                </c:pt>
                <c:pt idx="92">
                  <c:v>-0.7</c:v>
                </c:pt>
                <c:pt idx="93">
                  <c:v>0</c:v>
                </c:pt>
                <c:pt idx="94">
                  <c:v>-2.5</c:v>
                </c:pt>
                <c:pt idx="95">
                  <c:v>-0.3</c:v>
                </c:pt>
                <c:pt idx="96">
                  <c:v>0</c:v>
                </c:pt>
                <c:pt idx="97">
                  <c:v>-1.1000000000000001</c:v>
                </c:pt>
                <c:pt idx="98">
                  <c:v>0</c:v>
                </c:pt>
                <c:pt idx="99">
                  <c:v>-0.3</c:v>
                </c:pt>
                <c:pt idx="100">
                  <c:v>-0.2</c:v>
                </c:pt>
                <c:pt idx="101">
                  <c:v>-0.3</c:v>
                </c:pt>
                <c:pt idx="102">
                  <c:v>-0.1</c:v>
                </c:pt>
                <c:pt idx="103">
                  <c:v>-0.2</c:v>
                </c:pt>
                <c:pt idx="104">
                  <c:v>-0.2</c:v>
                </c:pt>
                <c:pt idx="105">
                  <c:v>-0.2</c:v>
                </c:pt>
                <c:pt idx="106">
                  <c:v>-0.3</c:v>
                </c:pt>
                <c:pt idx="107">
                  <c:v>-0.3</c:v>
                </c:pt>
                <c:pt idx="108">
                  <c:v>-0.4</c:v>
                </c:pt>
                <c:pt idx="109">
                  <c:v>-0.5</c:v>
                </c:pt>
                <c:pt idx="110">
                  <c:v>-0.4</c:v>
                </c:pt>
                <c:pt idx="111">
                  <c:v>-0.4</c:v>
                </c:pt>
                <c:pt idx="112">
                  <c:v>-0.5</c:v>
                </c:pt>
                <c:pt idx="113">
                  <c:v>-0.6</c:v>
                </c:pt>
                <c:pt idx="114">
                  <c:v>-0.4</c:v>
                </c:pt>
                <c:pt idx="115">
                  <c:v>-0.6</c:v>
                </c:pt>
                <c:pt idx="116">
                  <c:v>-0.5</c:v>
                </c:pt>
                <c:pt idx="117">
                  <c:v>-0.8</c:v>
                </c:pt>
                <c:pt idx="118">
                  <c:v>-1</c:v>
                </c:pt>
                <c:pt idx="119">
                  <c:v>-0.5</c:v>
                </c:pt>
                <c:pt idx="120">
                  <c:v>-0.6</c:v>
                </c:pt>
                <c:pt idx="121">
                  <c:v>-1.4</c:v>
                </c:pt>
                <c:pt idx="122">
                  <c:v>-0.1</c:v>
                </c:pt>
                <c:pt idx="123">
                  <c:v>0</c:v>
                </c:pt>
                <c:pt idx="124">
                  <c:v>-0.1</c:v>
                </c:pt>
                <c:pt idx="125">
                  <c:v>-0.3</c:v>
                </c:pt>
                <c:pt idx="126">
                  <c:v>-4.5999999999999996</c:v>
                </c:pt>
                <c:pt idx="127">
                  <c:v>-0.1</c:v>
                </c:pt>
                <c:pt idx="128">
                  <c:v>-4.5</c:v>
                </c:pt>
                <c:pt idx="129">
                  <c:v>-0.2</c:v>
                </c:pt>
                <c:pt idx="130">
                  <c:v>-4.8</c:v>
                </c:pt>
                <c:pt idx="131">
                  <c:v>0</c:v>
                </c:pt>
                <c:pt idx="132">
                  <c:v>-4.7</c:v>
                </c:pt>
                <c:pt idx="133">
                  <c:v>1.6</c:v>
                </c:pt>
                <c:pt idx="134">
                  <c:v>-0.4</c:v>
                </c:pt>
                <c:pt idx="135">
                  <c:v>0.1</c:v>
                </c:pt>
                <c:pt idx="136">
                  <c:v>-0.2</c:v>
                </c:pt>
                <c:pt idx="137">
                  <c:v>1.4</c:v>
                </c:pt>
                <c:pt idx="138">
                  <c:v>0</c:v>
                </c:pt>
                <c:pt idx="139">
                  <c:v>1.5</c:v>
                </c:pt>
                <c:pt idx="140">
                  <c:v>-0.5</c:v>
                </c:pt>
                <c:pt idx="141">
                  <c:v>-0.3</c:v>
                </c:pt>
                <c:pt idx="142">
                  <c:v>-0.1</c:v>
                </c:pt>
                <c:pt idx="143">
                  <c:v>-0.1</c:v>
                </c:pt>
                <c:pt idx="144">
                  <c:v>1.4</c:v>
                </c:pt>
                <c:pt idx="145">
                  <c:v>-0.4</c:v>
                </c:pt>
                <c:pt idx="146">
                  <c:v>-0.5</c:v>
                </c:pt>
                <c:pt idx="147">
                  <c:v>1.5</c:v>
                </c:pt>
                <c:pt idx="148">
                  <c:v>-0.5</c:v>
                </c:pt>
                <c:pt idx="149">
                  <c:v>0</c:v>
                </c:pt>
                <c:pt idx="150">
                  <c:v>-0.5</c:v>
                </c:pt>
                <c:pt idx="151">
                  <c:v>1</c:v>
                </c:pt>
                <c:pt idx="152">
                  <c:v>-0.8</c:v>
                </c:pt>
                <c:pt idx="153">
                  <c:v>-0.1</c:v>
                </c:pt>
                <c:pt idx="154">
                  <c:v>-0.2</c:v>
                </c:pt>
                <c:pt idx="155">
                  <c:v>-0.8</c:v>
                </c:pt>
                <c:pt idx="156">
                  <c:v>-6.1</c:v>
                </c:pt>
                <c:pt idx="157">
                  <c:v>-0.5</c:v>
                </c:pt>
                <c:pt idx="158">
                  <c:v>-0.8</c:v>
                </c:pt>
                <c:pt idx="159">
                  <c:v>0.5</c:v>
                </c:pt>
                <c:pt idx="160">
                  <c:v>0.1</c:v>
                </c:pt>
                <c:pt idx="161">
                  <c:v>0.4</c:v>
                </c:pt>
                <c:pt idx="162">
                  <c:v>0.3</c:v>
                </c:pt>
                <c:pt idx="163">
                  <c:v>0.7</c:v>
                </c:pt>
                <c:pt idx="164">
                  <c:v>0.3</c:v>
                </c:pt>
                <c:pt idx="165">
                  <c:v>0.2</c:v>
                </c:pt>
                <c:pt idx="166">
                  <c:v>0.3</c:v>
                </c:pt>
                <c:pt idx="167">
                  <c:v>0.6</c:v>
                </c:pt>
                <c:pt idx="168">
                  <c:v>0.2</c:v>
                </c:pt>
                <c:pt idx="169">
                  <c:v>0.3</c:v>
                </c:pt>
                <c:pt idx="170">
                  <c:v>0.3</c:v>
                </c:pt>
                <c:pt idx="171">
                  <c:v>0.1</c:v>
                </c:pt>
                <c:pt idx="172">
                  <c:v>0.1</c:v>
                </c:pt>
                <c:pt idx="173">
                  <c:v>0</c:v>
                </c:pt>
                <c:pt idx="174">
                  <c:v>0.2</c:v>
                </c:pt>
                <c:pt idx="175">
                  <c:v>-0.1</c:v>
                </c:pt>
                <c:pt idx="176">
                  <c:v>0.3</c:v>
                </c:pt>
                <c:pt idx="177">
                  <c:v>0.1</c:v>
                </c:pt>
                <c:pt idx="178">
                  <c:v>-0.1</c:v>
                </c:pt>
                <c:pt idx="179">
                  <c:v>0.1</c:v>
                </c:pt>
                <c:pt idx="180">
                  <c:v>0.5</c:v>
                </c:pt>
                <c:pt idx="181">
                  <c:v>0.2</c:v>
                </c:pt>
                <c:pt idx="182">
                  <c:v>-0.2</c:v>
                </c:pt>
                <c:pt idx="183">
                  <c:v>0.2</c:v>
                </c:pt>
                <c:pt idx="184">
                  <c:v>0</c:v>
                </c:pt>
                <c:pt idx="185">
                  <c:v>0.1</c:v>
                </c:pt>
                <c:pt idx="186">
                  <c:v>0.1</c:v>
                </c:pt>
                <c:pt idx="187">
                  <c:v>0.2</c:v>
                </c:pt>
                <c:pt idx="188">
                  <c:v>0.1</c:v>
                </c:pt>
                <c:pt idx="189">
                  <c:v>0.1</c:v>
                </c:pt>
                <c:pt idx="190">
                  <c:v>0.1</c:v>
                </c:pt>
                <c:pt idx="191">
                  <c:v>0.3</c:v>
                </c:pt>
                <c:pt idx="192">
                  <c:v>0.3</c:v>
                </c:pt>
                <c:pt idx="193">
                  <c:v>0.3</c:v>
                </c:pt>
                <c:pt idx="194">
                  <c:v>0.3</c:v>
                </c:pt>
                <c:pt idx="195">
                  <c:v>-0.2</c:v>
                </c:pt>
                <c:pt idx="196">
                  <c:v>0.2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-0.2</c:v>
                </c:pt>
                <c:pt idx="201">
                  <c:v>-0.1</c:v>
                </c:pt>
                <c:pt idx="202">
                  <c:v>-0.3</c:v>
                </c:pt>
                <c:pt idx="203">
                  <c:v>-0.3</c:v>
                </c:pt>
                <c:pt idx="204">
                  <c:v>-0.1</c:v>
                </c:pt>
                <c:pt idx="205">
                  <c:v>-0.3</c:v>
                </c:pt>
                <c:pt idx="206">
                  <c:v>-0.6</c:v>
                </c:pt>
                <c:pt idx="207">
                  <c:v>-0.9</c:v>
                </c:pt>
                <c:pt idx="208">
                  <c:v>4.7</c:v>
                </c:pt>
                <c:pt idx="209">
                  <c:v>1.2</c:v>
                </c:pt>
                <c:pt idx="210">
                  <c:v>0</c:v>
                </c:pt>
                <c:pt idx="211">
                  <c:v>-0.1</c:v>
                </c:pt>
                <c:pt idx="212">
                  <c:v>-0.3</c:v>
                </c:pt>
                <c:pt idx="213">
                  <c:v>-0.4</c:v>
                </c:pt>
                <c:pt idx="214">
                  <c:v>-0.4</c:v>
                </c:pt>
                <c:pt idx="215">
                  <c:v>-0.2</c:v>
                </c:pt>
                <c:pt idx="216">
                  <c:v>-0.4</c:v>
                </c:pt>
                <c:pt idx="217">
                  <c:v>-0.3</c:v>
                </c:pt>
                <c:pt idx="218">
                  <c:v>-0.3</c:v>
                </c:pt>
                <c:pt idx="219">
                  <c:v>-0.5</c:v>
                </c:pt>
                <c:pt idx="220">
                  <c:v>-0.3</c:v>
                </c:pt>
                <c:pt idx="221">
                  <c:v>-1</c:v>
                </c:pt>
                <c:pt idx="222">
                  <c:v>-1.1000000000000001</c:v>
                </c:pt>
                <c:pt idx="223">
                  <c:v>0</c:v>
                </c:pt>
                <c:pt idx="224">
                  <c:v>0</c:v>
                </c:pt>
                <c:pt idx="225">
                  <c:v>0.1</c:v>
                </c:pt>
                <c:pt idx="226">
                  <c:v>-0.1</c:v>
                </c:pt>
                <c:pt idx="227">
                  <c:v>0</c:v>
                </c:pt>
                <c:pt idx="228">
                  <c:v>0</c:v>
                </c:pt>
                <c:pt idx="229">
                  <c:v>-0.1</c:v>
                </c:pt>
                <c:pt idx="230">
                  <c:v>-0.2</c:v>
                </c:pt>
                <c:pt idx="231">
                  <c:v>-0.1</c:v>
                </c:pt>
                <c:pt idx="232">
                  <c:v>-0.3</c:v>
                </c:pt>
                <c:pt idx="233">
                  <c:v>-0.1</c:v>
                </c:pt>
                <c:pt idx="234">
                  <c:v>-0.1</c:v>
                </c:pt>
                <c:pt idx="235">
                  <c:v>-0.1</c:v>
                </c:pt>
                <c:pt idx="236">
                  <c:v>-0.1</c:v>
                </c:pt>
                <c:pt idx="237">
                  <c:v>0</c:v>
                </c:pt>
                <c:pt idx="238">
                  <c:v>-0.1</c:v>
                </c:pt>
                <c:pt idx="239">
                  <c:v>-0.3</c:v>
                </c:pt>
                <c:pt idx="240">
                  <c:v>0</c:v>
                </c:pt>
                <c:pt idx="241">
                  <c:v>-0.2</c:v>
                </c:pt>
                <c:pt idx="242">
                  <c:v>-0.1</c:v>
                </c:pt>
                <c:pt idx="243">
                  <c:v>-0.3</c:v>
                </c:pt>
                <c:pt idx="244">
                  <c:v>-0.2</c:v>
                </c:pt>
                <c:pt idx="245">
                  <c:v>-0.1</c:v>
                </c:pt>
                <c:pt idx="246">
                  <c:v>-0.3</c:v>
                </c:pt>
                <c:pt idx="247">
                  <c:v>-0.6</c:v>
                </c:pt>
                <c:pt idx="248">
                  <c:v>-0.4</c:v>
                </c:pt>
                <c:pt idx="249">
                  <c:v>-0.3</c:v>
                </c:pt>
                <c:pt idx="250">
                  <c:v>-0.4</c:v>
                </c:pt>
                <c:pt idx="251">
                  <c:v>-0.5</c:v>
                </c:pt>
                <c:pt idx="252">
                  <c:v>-0.2</c:v>
                </c:pt>
                <c:pt idx="253">
                  <c:v>0.4</c:v>
                </c:pt>
                <c:pt idx="254">
                  <c:v>0.1</c:v>
                </c:pt>
                <c:pt idx="255">
                  <c:v>-0.1</c:v>
                </c:pt>
                <c:pt idx="256">
                  <c:v>-0.1</c:v>
                </c:pt>
                <c:pt idx="257">
                  <c:v>0.1</c:v>
                </c:pt>
                <c:pt idx="258">
                  <c:v>-0.2</c:v>
                </c:pt>
                <c:pt idx="259">
                  <c:v>0</c:v>
                </c:pt>
                <c:pt idx="260">
                  <c:v>0</c:v>
                </c:pt>
                <c:pt idx="261">
                  <c:v>-0.2</c:v>
                </c:pt>
                <c:pt idx="262">
                  <c:v>0.3</c:v>
                </c:pt>
                <c:pt idx="263">
                  <c:v>-0.4</c:v>
                </c:pt>
                <c:pt idx="264">
                  <c:v>-0.5</c:v>
                </c:pt>
                <c:pt idx="265">
                  <c:v>-0.5</c:v>
                </c:pt>
                <c:pt idx="266">
                  <c:v>-0.5</c:v>
                </c:pt>
                <c:pt idx="267">
                  <c:v>0</c:v>
                </c:pt>
                <c:pt idx="268">
                  <c:v>-0.1</c:v>
                </c:pt>
                <c:pt idx="269">
                  <c:v>-0.2</c:v>
                </c:pt>
                <c:pt idx="270">
                  <c:v>-0.1</c:v>
                </c:pt>
                <c:pt idx="271">
                  <c:v>-0.2</c:v>
                </c:pt>
                <c:pt idx="272">
                  <c:v>-0.1</c:v>
                </c:pt>
                <c:pt idx="273">
                  <c:v>0</c:v>
                </c:pt>
                <c:pt idx="274">
                  <c:v>-0.3</c:v>
                </c:pt>
                <c:pt idx="275">
                  <c:v>-0.1</c:v>
                </c:pt>
                <c:pt idx="276">
                  <c:v>-0.2</c:v>
                </c:pt>
                <c:pt idx="277">
                  <c:v>-0.5</c:v>
                </c:pt>
                <c:pt idx="278">
                  <c:v>-0.6</c:v>
                </c:pt>
                <c:pt idx="279">
                  <c:v>-0.5</c:v>
                </c:pt>
                <c:pt idx="280">
                  <c:v>0.1</c:v>
                </c:pt>
                <c:pt idx="281">
                  <c:v>0.9</c:v>
                </c:pt>
                <c:pt idx="282">
                  <c:v>-0.1</c:v>
                </c:pt>
                <c:pt idx="283">
                  <c:v>-0.2</c:v>
                </c:pt>
                <c:pt idx="284">
                  <c:v>0.1</c:v>
                </c:pt>
                <c:pt idx="285">
                  <c:v>-0.5</c:v>
                </c:pt>
                <c:pt idx="286">
                  <c:v>-0.3</c:v>
                </c:pt>
                <c:pt idx="287">
                  <c:v>-4.0999999999999996</c:v>
                </c:pt>
                <c:pt idx="288">
                  <c:v>0.3</c:v>
                </c:pt>
                <c:pt idx="289">
                  <c:v>0</c:v>
                </c:pt>
                <c:pt idx="290">
                  <c:v>0.1</c:v>
                </c:pt>
                <c:pt idx="291">
                  <c:v>-0.1</c:v>
                </c:pt>
                <c:pt idx="292">
                  <c:v>0</c:v>
                </c:pt>
                <c:pt idx="293">
                  <c:v>-0.1</c:v>
                </c:pt>
                <c:pt idx="294">
                  <c:v>0</c:v>
                </c:pt>
                <c:pt idx="295">
                  <c:v>-0.1</c:v>
                </c:pt>
                <c:pt idx="296">
                  <c:v>0</c:v>
                </c:pt>
                <c:pt idx="297">
                  <c:v>-0.1</c:v>
                </c:pt>
                <c:pt idx="298">
                  <c:v>-0.1</c:v>
                </c:pt>
                <c:pt idx="299">
                  <c:v>-0.2</c:v>
                </c:pt>
                <c:pt idx="300">
                  <c:v>-0.1</c:v>
                </c:pt>
                <c:pt idx="301">
                  <c:v>-0.2</c:v>
                </c:pt>
                <c:pt idx="302">
                  <c:v>-0.3</c:v>
                </c:pt>
                <c:pt idx="303">
                  <c:v>-0.2</c:v>
                </c:pt>
                <c:pt idx="304">
                  <c:v>-0.2</c:v>
                </c:pt>
                <c:pt idx="305">
                  <c:v>-0.1</c:v>
                </c:pt>
                <c:pt idx="306">
                  <c:v>-0.2</c:v>
                </c:pt>
                <c:pt idx="307">
                  <c:v>-0.3</c:v>
                </c:pt>
                <c:pt idx="308">
                  <c:v>-0.1</c:v>
                </c:pt>
                <c:pt idx="309">
                  <c:v>-0.2</c:v>
                </c:pt>
                <c:pt idx="310">
                  <c:v>-0.1</c:v>
                </c:pt>
                <c:pt idx="311">
                  <c:v>-0.2</c:v>
                </c:pt>
                <c:pt idx="312">
                  <c:v>-0.1</c:v>
                </c:pt>
                <c:pt idx="313">
                  <c:v>-0.3</c:v>
                </c:pt>
                <c:pt idx="314">
                  <c:v>-0.1</c:v>
                </c:pt>
                <c:pt idx="315">
                  <c:v>-0.3</c:v>
                </c:pt>
                <c:pt idx="316">
                  <c:v>-0.1</c:v>
                </c:pt>
                <c:pt idx="317">
                  <c:v>-0.3</c:v>
                </c:pt>
                <c:pt idx="318">
                  <c:v>0</c:v>
                </c:pt>
                <c:pt idx="319">
                  <c:v>-0.3</c:v>
                </c:pt>
                <c:pt idx="320">
                  <c:v>-0.4</c:v>
                </c:pt>
                <c:pt idx="321">
                  <c:v>-0.4</c:v>
                </c:pt>
                <c:pt idx="322">
                  <c:v>-0.3</c:v>
                </c:pt>
                <c:pt idx="323">
                  <c:v>-0.2</c:v>
                </c:pt>
                <c:pt idx="324">
                  <c:v>-0.5</c:v>
                </c:pt>
                <c:pt idx="325">
                  <c:v>-0.3</c:v>
                </c:pt>
                <c:pt idx="326">
                  <c:v>-0.4</c:v>
                </c:pt>
                <c:pt idx="327">
                  <c:v>-0.2</c:v>
                </c:pt>
                <c:pt idx="328">
                  <c:v>0.6</c:v>
                </c:pt>
                <c:pt idx="329">
                  <c:v>-0.1</c:v>
                </c:pt>
                <c:pt idx="330">
                  <c:v>-0.7</c:v>
                </c:pt>
                <c:pt idx="331">
                  <c:v>-0.4</c:v>
                </c:pt>
                <c:pt idx="332">
                  <c:v>-0.3</c:v>
                </c:pt>
                <c:pt idx="333">
                  <c:v>-0.1</c:v>
                </c:pt>
                <c:pt idx="334">
                  <c:v>-0.1</c:v>
                </c:pt>
                <c:pt idx="335">
                  <c:v>-0.3</c:v>
                </c:pt>
                <c:pt idx="336">
                  <c:v>-1</c:v>
                </c:pt>
                <c:pt idx="337">
                  <c:v>-0.6</c:v>
                </c:pt>
                <c:pt idx="338">
                  <c:v>-0.3</c:v>
                </c:pt>
                <c:pt idx="339">
                  <c:v>0</c:v>
                </c:pt>
                <c:pt idx="340">
                  <c:v>-0.7</c:v>
                </c:pt>
                <c:pt idx="341">
                  <c:v>-0.5</c:v>
                </c:pt>
                <c:pt idx="342">
                  <c:v>-0.6</c:v>
                </c:pt>
                <c:pt idx="343">
                  <c:v>-0.8</c:v>
                </c:pt>
                <c:pt idx="344">
                  <c:v>0.7</c:v>
                </c:pt>
                <c:pt idx="345">
                  <c:v>-0.7</c:v>
                </c:pt>
                <c:pt idx="346">
                  <c:v>-0.7</c:v>
                </c:pt>
                <c:pt idx="347">
                  <c:v>-0.9</c:v>
                </c:pt>
                <c:pt idx="348">
                  <c:v>0</c:v>
                </c:pt>
                <c:pt idx="349">
                  <c:v>-0.6</c:v>
                </c:pt>
                <c:pt idx="350">
                  <c:v>-0.6</c:v>
                </c:pt>
                <c:pt idx="351">
                  <c:v>1.4</c:v>
                </c:pt>
                <c:pt idx="352">
                  <c:v>-0.4</c:v>
                </c:pt>
                <c:pt idx="353">
                  <c:v>-0.2</c:v>
                </c:pt>
                <c:pt idx="354">
                  <c:v>-1.1000000000000001</c:v>
                </c:pt>
                <c:pt idx="355">
                  <c:v>-0.5</c:v>
                </c:pt>
                <c:pt idx="356">
                  <c:v>-1</c:v>
                </c:pt>
                <c:pt idx="357">
                  <c:v>1.3</c:v>
                </c:pt>
                <c:pt idx="358">
                  <c:v>-0.4</c:v>
                </c:pt>
                <c:pt idx="359">
                  <c:v>-2.1</c:v>
                </c:pt>
                <c:pt idx="360">
                  <c:v>-0.3</c:v>
                </c:pt>
                <c:pt idx="361">
                  <c:v>-0.2</c:v>
                </c:pt>
                <c:pt idx="362">
                  <c:v>-0.2</c:v>
                </c:pt>
                <c:pt idx="363">
                  <c:v>-0.2</c:v>
                </c:pt>
                <c:pt idx="364">
                  <c:v>-0.2</c:v>
                </c:pt>
                <c:pt idx="365">
                  <c:v>-0.3</c:v>
                </c:pt>
                <c:pt idx="366">
                  <c:v>-0.1</c:v>
                </c:pt>
                <c:pt idx="367">
                  <c:v>-0.2</c:v>
                </c:pt>
                <c:pt idx="368">
                  <c:v>-0.3</c:v>
                </c:pt>
                <c:pt idx="369">
                  <c:v>-0.3</c:v>
                </c:pt>
                <c:pt idx="370">
                  <c:v>-0.4</c:v>
                </c:pt>
                <c:pt idx="371">
                  <c:v>-0.3</c:v>
                </c:pt>
                <c:pt idx="372">
                  <c:v>1.1000000000000001</c:v>
                </c:pt>
                <c:pt idx="373">
                  <c:v>-0.5</c:v>
                </c:pt>
                <c:pt idx="374">
                  <c:v>-0.2</c:v>
                </c:pt>
                <c:pt idx="375">
                  <c:v>-0.2</c:v>
                </c:pt>
                <c:pt idx="376">
                  <c:v>-0.6</c:v>
                </c:pt>
                <c:pt idx="377">
                  <c:v>-0.4</c:v>
                </c:pt>
                <c:pt idx="378">
                  <c:v>-0.3</c:v>
                </c:pt>
                <c:pt idx="379">
                  <c:v>-0.3</c:v>
                </c:pt>
                <c:pt idx="380">
                  <c:v>-0.4</c:v>
                </c:pt>
                <c:pt idx="381">
                  <c:v>-0.4</c:v>
                </c:pt>
                <c:pt idx="382">
                  <c:v>-0.3</c:v>
                </c:pt>
                <c:pt idx="383">
                  <c:v>-0.7</c:v>
                </c:pt>
                <c:pt idx="384">
                  <c:v>-0.5</c:v>
                </c:pt>
                <c:pt idx="385">
                  <c:v>-0.4</c:v>
                </c:pt>
                <c:pt idx="386">
                  <c:v>-0.4</c:v>
                </c:pt>
                <c:pt idx="387">
                  <c:v>-0.7</c:v>
                </c:pt>
                <c:pt idx="388">
                  <c:v>0.4</c:v>
                </c:pt>
                <c:pt idx="389">
                  <c:v>-0.6</c:v>
                </c:pt>
                <c:pt idx="390">
                  <c:v>-0.1</c:v>
                </c:pt>
                <c:pt idx="391">
                  <c:v>-0.4</c:v>
                </c:pt>
                <c:pt idx="392">
                  <c:v>-0.4</c:v>
                </c:pt>
                <c:pt idx="393">
                  <c:v>-1.1000000000000001</c:v>
                </c:pt>
                <c:pt idx="394">
                  <c:v>-0.3</c:v>
                </c:pt>
                <c:pt idx="395">
                  <c:v>-0.7</c:v>
                </c:pt>
                <c:pt idx="396">
                  <c:v>-0.3</c:v>
                </c:pt>
                <c:pt idx="397">
                  <c:v>-0.5</c:v>
                </c:pt>
                <c:pt idx="398">
                  <c:v>-0.4</c:v>
                </c:pt>
                <c:pt idx="399">
                  <c:v>-0.5</c:v>
                </c:pt>
                <c:pt idx="400">
                  <c:v>0</c:v>
                </c:pt>
                <c:pt idx="401">
                  <c:v>0.2</c:v>
                </c:pt>
                <c:pt idx="402">
                  <c:v>-0.6</c:v>
                </c:pt>
                <c:pt idx="403">
                  <c:v>-0.1</c:v>
                </c:pt>
                <c:pt idx="404">
                  <c:v>0</c:v>
                </c:pt>
                <c:pt idx="405">
                  <c:v>0</c:v>
                </c:pt>
                <c:pt idx="406">
                  <c:v>0</c:v>
                </c:pt>
                <c:pt idx="407">
                  <c:v>0</c:v>
                </c:pt>
                <c:pt idx="408">
                  <c:v>-0.1</c:v>
                </c:pt>
                <c:pt idx="409">
                  <c:v>-0.6</c:v>
                </c:pt>
                <c:pt idx="410">
                  <c:v>-0.4</c:v>
                </c:pt>
                <c:pt idx="411">
                  <c:v>-1.2</c:v>
                </c:pt>
                <c:pt idx="412">
                  <c:v>-0.2</c:v>
                </c:pt>
                <c:pt idx="413">
                  <c:v>-1</c:v>
                </c:pt>
                <c:pt idx="414">
                  <c:v>0</c:v>
                </c:pt>
                <c:pt idx="415">
                  <c:v>-0.2</c:v>
                </c:pt>
                <c:pt idx="416">
                  <c:v>0</c:v>
                </c:pt>
                <c:pt idx="417">
                  <c:v>-0.1</c:v>
                </c:pt>
                <c:pt idx="418">
                  <c:v>0.1</c:v>
                </c:pt>
                <c:pt idx="419">
                  <c:v>-0.2</c:v>
                </c:pt>
                <c:pt idx="420">
                  <c:v>-0.1</c:v>
                </c:pt>
                <c:pt idx="421">
                  <c:v>-0.1</c:v>
                </c:pt>
                <c:pt idx="422">
                  <c:v>-0.1</c:v>
                </c:pt>
                <c:pt idx="423">
                  <c:v>-0.1</c:v>
                </c:pt>
                <c:pt idx="424">
                  <c:v>-0.1</c:v>
                </c:pt>
                <c:pt idx="425">
                  <c:v>-0.2</c:v>
                </c:pt>
                <c:pt idx="426">
                  <c:v>-0.2</c:v>
                </c:pt>
                <c:pt idx="427">
                  <c:v>-0.2</c:v>
                </c:pt>
                <c:pt idx="428">
                  <c:v>-0.2</c:v>
                </c:pt>
                <c:pt idx="429">
                  <c:v>-0.1</c:v>
                </c:pt>
                <c:pt idx="430">
                  <c:v>-0.4</c:v>
                </c:pt>
                <c:pt idx="431">
                  <c:v>-0.4</c:v>
                </c:pt>
                <c:pt idx="432">
                  <c:v>-0.4</c:v>
                </c:pt>
                <c:pt idx="433">
                  <c:v>1</c:v>
                </c:pt>
                <c:pt idx="434">
                  <c:v>-0.5</c:v>
                </c:pt>
                <c:pt idx="435">
                  <c:v>-0.3</c:v>
                </c:pt>
                <c:pt idx="436">
                  <c:v>-1.2</c:v>
                </c:pt>
                <c:pt idx="437">
                  <c:v>-0.6</c:v>
                </c:pt>
                <c:pt idx="438">
                  <c:v>-0.4</c:v>
                </c:pt>
                <c:pt idx="439">
                  <c:v>-0.3</c:v>
                </c:pt>
                <c:pt idx="440">
                  <c:v>-0.9</c:v>
                </c:pt>
                <c:pt idx="441">
                  <c:v>-0.8</c:v>
                </c:pt>
                <c:pt idx="442">
                  <c:v>-1.1000000000000001</c:v>
                </c:pt>
                <c:pt idx="443">
                  <c:v>-0.3</c:v>
                </c:pt>
                <c:pt idx="444">
                  <c:v>-2</c:v>
                </c:pt>
                <c:pt idx="445">
                  <c:v>-0.6</c:v>
                </c:pt>
                <c:pt idx="446">
                  <c:v>-0.3</c:v>
                </c:pt>
                <c:pt idx="447">
                  <c:v>-0.5</c:v>
                </c:pt>
                <c:pt idx="448">
                  <c:v>-0.9</c:v>
                </c:pt>
                <c:pt idx="449">
                  <c:v>0</c:v>
                </c:pt>
                <c:pt idx="450">
                  <c:v>0.1</c:v>
                </c:pt>
                <c:pt idx="451">
                  <c:v>0</c:v>
                </c:pt>
                <c:pt idx="452">
                  <c:v>0</c:v>
                </c:pt>
                <c:pt idx="453">
                  <c:v>-0.1</c:v>
                </c:pt>
                <c:pt idx="454">
                  <c:v>-0.2</c:v>
                </c:pt>
                <c:pt idx="455">
                  <c:v>-0.1</c:v>
                </c:pt>
                <c:pt idx="456">
                  <c:v>0</c:v>
                </c:pt>
                <c:pt idx="457">
                  <c:v>0</c:v>
                </c:pt>
                <c:pt idx="458">
                  <c:v>0.1</c:v>
                </c:pt>
                <c:pt idx="459">
                  <c:v>-0.1</c:v>
                </c:pt>
                <c:pt idx="460">
                  <c:v>0</c:v>
                </c:pt>
                <c:pt idx="461">
                  <c:v>-0.1</c:v>
                </c:pt>
                <c:pt idx="462">
                  <c:v>-0.2</c:v>
                </c:pt>
                <c:pt idx="463">
                  <c:v>-0.1</c:v>
                </c:pt>
                <c:pt idx="464">
                  <c:v>-0.3</c:v>
                </c:pt>
                <c:pt idx="465">
                  <c:v>-0.3</c:v>
                </c:pt>
                <c:pt idx="466">
                  <c:v>-0.1</c:v>
                </c:pt>
                <c:pt idx="467">
                  <c:v>-0.3</c:v>
                </c:pt>
                <c:pt idx="468">
                  <c:v>-0.5</c:v>
                </c:pt>
                <c:pt idx="469">
                  <c:v>-0.3</c:v>
                </c:pt>
                <c:pt idx="470">
                  <c:v>-0.3</c:v>
                </c:pt>
                <c:pt idx="471">
                  <c:v>-0.1</c:v>
                </c:pt>
                <c:pt idx="472">
                  <c:v>-0.1</c:v>
                </c:pt>
                <c:pt idx="473">
                  <c:v>-0.1</c:v>
                </c:pt>
                <c:pt idx="474">
                  <c:v>-0.3</c:v>
                </c:pt>
                <c:pt idx="475">
                  <c:v>-0.3</c:v>
                </c:pt>
                <c:pt idx="476">
                  <c:v>-0.4</c:v>
                </c:pt>
                <c:pt idx="477">
                  <c:v>-0.7</c:v>
                </c:pt>
                <c:pt idx="478">
                  <c:v>0.2</c:v>
                </c:pt>
                <c:pt idx="479">
                  <c:v>-0.4</c:v>
                </c:pt>
                <c:pt idx="480">
                  <c:v>-1.8</c:v>
                </c:pt>
                <c:pt idx="481">
                  <c:v>-1.3</c:v>
                </c:pt>
                <c:pt idx="482">
                  <c:v>-0.8</c:v>
                </c:pt>
                <c:pt idx="483">
                  <c:v>-0.4</c:v>
                </c:pt>
                <c:pt idx="484">
                  <c:v>-0.4</c:v>
                </c:pt>
                <c:pt idx="485">
                  <c:v>-0.7</c:v>
                </c:pt>
                <c:pt idx="486">
                  <c:v>-0.5</c:v>
                </c:pt>
                <c:pt idx="487">
                  <c:v>-0.2</c:v>
                </c:pt>
                <c:pt idx="488">
                  <c:v>-0.3</c:v>
                </c:pt>
                <c:pt idx="489">
                  <c:v>-0.6</c:v>
                </c:pt>
                <c:pt idx="490">
                  <c:v>-0.4</c:v>
                </c:pt>
                <c:pt idx="491">
                  <c:v>-0.5</c:v>
                </c:pt>
                <c:pt idx="492">
                  <c:v>-1</c:v>
                </c:pt>
                <c:pt idx="493">
                  <c:v>-0.6</c:v>
                </c:pt>
                <c:pt idx="494">
                  <c:v>-0.7</c:v>
                </c:pt>
                <c:pt idx="495">
                  <c:v>-0.2</c:v>
                </c:pt>
                <c:pt idx="496">
                  <c:v>-0.8</c:v>
                </c:pt>
                <c:pt idx="497">
                  <c:v>0</c:v>
                </c:pt>
                <c:pt idx="498">
                  <c:v>-1</c:v>
                </c:pt>
                <c:pt idx="499">
                  <c:v>-0.3</c:v>
                </c:pt>
                <c:pt idx="500">
                  <c:v>0</c:v>
                </c:pt>
                <c:pt idx="501">
                  <c:v>-0.5</c:v>
                </c:pt>
                <c:pt idx="502">
                  <c:v>-0.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EF9-48FF-9DB1-F70022BEDC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8577192"/>
        <c:axId val="668575232"/>
      </c:scatterChart>
      <c:valAx>
        <c:axId val="668577192"/>
        <c:scaling>
          <c:logBase val="10"/>
          <c:orientation val="minMax"/>
          <c:min val="1000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65000"/>
                  <a:lumOff val="35000"/>
                  <a:alpha val="7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lt1">
                        <a:lumMod val="7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bundanc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lt1">
                      <a:lumMod val="7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E+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lt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lt1">
                    <a:lumMod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68575232"/>
        <c:crosses val="autoZero"/>
        <c:crossBetween val="midCat"/>
      </c:valAx>
      <c:valAx>
        <c:axId val="668575232"/>
        <c:scaling>
          <c:orientation val="minMax"/>
          <c:max val="5"/>
          <c:min val="-5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65000"/>
                  <a:lumOff val="35000"/>
                  <a:alpha val="7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lt1">
                        <a:lumMod val="7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ppm</a:t>
                </a:r>
                <a:r>
                  <a:rPr lang="en-US" sz="12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error</a:t>
                </a:r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lt1">
                      <a:lumMod val="7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lt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lt1">
                    <a:lumMod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685771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dk1">
        <a:lumMod val="75000"/>
        <a:lumOff val="25000"/>
      </a:schemeClr>
    </a:soli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cap="none" baseline="0">
              <a:solidFill>
                <a:schemeClr val="lt1">
                  <a:lumMod val="8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Positive</c:v>
          </c:tx>
          <c:spPr>
            <a:ln w="25400" cap="rnd">
              <a:noFill/>
            </a:ln>
            <a:effectLst>
              <a:glow rad="139700">
                <a:srgbClr val="00B050">
                  <a:alpha val="14000"/>
                </a:srgbClr>
              </a:glow>
            </a:effectLst>
          </c:spPr>
          <c:marker>
            <c:symbol val="circle"/>
            <c:size val="3"/>
            <c:spPr>
              <a:solidFill>
                <a:srgbClr val="00B050"/>
              </a:solidFill>
              <a:ln>
                <a:solidFill>
                  <a:srgbClr val="00B050"/>
                </a:solidFill>
              </a:ln>
              <a:effectLst>
                <a:glow rad="139700">
                  <a:srgbClr val="00B050">
                    <a:alpha val="14000"/>
                  </a:srgbClr>
                </a:glow>
              </a:effectLst>
            </c:spPr>
          </c:marker>
          <c:xVal>
            <c:numRef>
              <c:f>'[Abundance vs mass accuracy.xlsx]Positive Annotated Lipids 1-6'!$G$2:$G$414</c:f>
              <c:numCache>
                <c:formatCode>General</c:formatCode>
                <c:ptCount val="413"/>
                <c:pt idx="0">
                  <c:v>528828</c:v>
                </c:pt>
                <c:pt idx="1">
                  <c:v>397367</c:v>
                </c:pt>
                <c:pt idx="2">
                  <c:v>284021</c:v>
                </c:pt>
                <c:pt idx="3">
                  <c:v>258641</c:v>
                </c:pt>
                <c:pt idx="4">
                  <c:v>255275</c:v>
                </c:pt>
                <c:pt idx="5">
                  <c:v>253571</c:v>
                </c:pt>
                <c:pt idx="6">
                  <c:v>229129</c:v>
                </c:pt>
                <c:pt idx="7">
                  <c:v>154306</c:v>
                </c:pt>
                <c:pt idx="8">
                  <c:v>140729</c:v>
                </c:pt>
                <c:pt idx="9">
                  <c:v>117635</c:v>
                </c:pt>
                <c:pt idx="10">
                  <c:v>79934</c:v>
                </c:pt>
                <c:pt idx="11">
                  <c:v>73310</c:v>
                </c:pt>
                <c:pt idx="12">
                  <c:v>57820</c:v>
                </c:pt>
                <c:pt idx="13">
                  <c:v>55107</c:v>
                </c:pt>
                <c:pt idx="14">
                  <c:v>54024</c:v>
                </c:pt>
                <c:pt idx="15">
                  <c:v>48892</c:v>
                </c:pt>
                <c:pt idx="16">
                  <c:v>47018</c:v>
                </c:pt>
                <c:pt idx="17">
                  <c:v>44762</c:v>
                </c:pt>
                <c:pt idx="18">
                  <c:v>44199</c:v>
                </c:pt>
                <c:pt idx="19">
                  <c:v>34096</c:v>
                </c:pt>
                <c:pt idx="20">
                  <c:v>29529</c:v>
                </c:pt>
                <c:pt idx="21">
                  <c:v>28864</c:v>
                </c:pt>
                <c:pt idx="22">
                  <c:v>28854</c:v>
                </c:pt>
                <c:pt idx="23">
                  <c:v>22747</c:v>
                </c:pt>
                <c:pt idx="24">
                  <c:v>20765</c:v>
                </c:pt>
                <c:pt idx="25">
                  <c:v>19768</c:v>
                </c:pt>
                <c:pt idx="26">
                  <c:v>18647</c:v>
                </c:pt>
                <c:pt idx="27">
                  <c:v>18313</c:v>
                </c:pt>
                <c:pt idx="28">
                  <c:v>16656</c:v>
                </c:pt>
                <c:pt idx="29">
                  <c:v>15374</c:v>
                </c:pt>
                <c:pt idx="30">
                  <c:v>10795</c:v>
                </c:pt>
                <c:pt idx="31">
                  <c:v>6995</c:v>
                </c:pt>
                <c:pt idx="32">
                  <c:v>592448</c:v>
                </c:pt>
                <c:pt idx="33">
                  <c:v>6449</c:v>
                </c:pt>
                <c:pt idx="34">
                  <c:v>1226309</c:v>
                </c:pt>
                <c:pt idx="35">
                  <c:v>436182</c:v>
                </c:pt>
                <c:pt idx="36">
                  <c:v>291590</c:v>
                </c:pt>
                <c:pt idx="37">
                  <c:v>235546</c:v>
                </c:pt>
                <c:pt idx="38">
                  <c:v>102232</c:v>
                </c:pt>
                <c:pt idx="39">
                  <c:v>87534</c:v>
                </c:pt>
                <c:pt idx="40">
                  <c:v>79505</c:v>
                </c:pt>
                <c:pt idx="41">
                  <c:v>54971</c:v>
                </c:pt>
                <c:pt idx="42">
                  <c:v>40684</c:v>
                </c:pt>
                <c:pt idx="43">
                  <c:v>40498</c:v>
                </c:pt>
                <c:pt idx="44">
                  <c:v>39457</c:v>
                </c:pt>
                <c:pt idx="45">
                  <c:v>34864</c:v>
                </c:pt>
                <c:pt idx="46">
                  <c:v>28406</c:v>
                </c:pt>
                <c:pt idx="47">
                  <c:v>23164</c:v>
                </c:pt>
                <c:pt idx="48">
                  <c:v>12712</c:v>
                </c:pt>
                <c:pt idx="49">
                  <c:v>2756</c:v>
                </c:pt>
                <c:pt idx="50">
                  <c:v>545507</c:v>
                </c:pt>
                <c:pt idx="51">
                  <c:v>360413</c:v>
                </c:pt>
                <c:pt idx="52">
                  <c:v>226521</c:v>
                </c:pt>
                <c:pt idx="53">
                  <c:v>158111</c:v>
                </c:pt>
                <c:pt idx="54">
                  <c:v>31517</c:v>
                </c:pt>
                <c:pt idx="55">
                  <c:v>396815</c:v>
                </c:pt>
                <c:pt idx="56">
                  <c:v>231466</c:v>
                </c:pt>
                <c:pt idx="57">
                  <c:v>39285</c:v>
                </c:pt>
                <c:pt idx="58">
                  <c:v>18061</c:v>
                </c:pt>
                <c:pt idx="59">
                  <c:v>122845</c:v>
                </c:pt>
                <c:pt idx="60">
                  <c:v>72596</c:v>
                </c:pt>
                <c:pt idx="61">
                  <c:v>54857</c:v>
                </c:pt>
                <c:pt idx="62">
                  <c:v>4491</c:v>
                </c:pt>
                <c:pt idx="63">
                  <c:v>8744284</c:v>
                </c:pt>
                <c:pt idx="64">
                  <c:v>8560155</c:v>
                </c:pt>
                <c:pt idx="65">
                  <c:v>8469703</c:v>
                </c:pt>
                <c:pt idx="66">
                  <c:v>8300582</c:v>
                </c:pt>
                <c:pt idx="67">
                  <c:v>7304314</c:v>
                </c:pt>
                <c:pt idx="68">
                  <c:v>6026410</c:v>
                </c:pt>
                <c:pt idx="69">
                  <c:v>4049129</c:v>
                </c:pt>
                <c:pt idx="70">
                  <c:v>4019675</c:v>
                </c:pt>
                <c:pt idx="71">
                  <c:v>3409212</c:v>
                </c:pt>
                <c:pt idx="72">
                  <c:v>3145344</c:v>
                </c:pt>
                <c:pt idx="73">
                  <c:v>1856534</c:v>
                </c:pt>
                <c:pt idx="74">
                  <c:v>977837</c:v>
                </c:pt>
                <c:pt idx="75">
                  <c:v>891852</c:v>
                </c:pt>
                <c:pt idx="76">
                  <c:v>845498</c:v>
                </c:pt>
                <c:pt idx="77">
                  <c:v>735984</c:v>
                </c:pt>
                <c:pt idx="78">
                  <c:v>695123</c:v>
                </c:pt>
                <c:pt idx="79">
                  <c:v>649451</c:v>
                </c:pt>
                <c:pt idx="80">
                  <c:v>493606</c:v>
                </c:pt>
                <c:pt idx="81">
                  <c:v>454905</c:v>
                </c:pt>
                <c:pt idx="82">
                  <c:v>414009</c:v>
                </c:pt>
                <c:pt idx="83">
                  <c:v>250112</c:v>
                </c:pt>
                <c:pt idx="84">
                  <c:v>233329</c:v>
                </c:pt>
                <c:pt idx="85">
                  <c:v>176082</c:v>
                </c:pt>
                <c:pt idx="86">
                  <c:v>151774</c:v>
                </c:pt>
                <c:pt idx="87">
                  <c:v>143544</c:v>
                </c:pt>
                <c:pt idx="88">
                  <c:v>127540</c:v>
                </c:pt>
                <c:pt idx="89">
                  <c:v>123966</c:v>
                </c:pt>
                <c:pt idx="90">
                  <c:v>117558</c:v>
                </c:pt>
                <c:pt idx="91">
                  <c:v>113882</c:v>
                </c:pt>
                <c:pt idx="92">
                  <c:v>113247</c:v>
                </c:pt>
                <c:pt idx="93">
                  <c:v>112727</c:v>
                </c:pt>
                <c:pt idx="94">
                  <c:v>84777</c:v>
                </c:pt>
                <c:pt idx="95">
                  <c:v>78426</c:v>
                </c:pt>
                <c:pt idx="96">
                  <c:v>50027</c:v>
                </c:pt>
                <c:pt idx="97">
                  <c:v>49820</c:v>
                </c:pt>
                <c:pt idx="98">
                  <c:v>40416</c:v>
                </c:pt>
                <c:pt idx="99">
                  <c:v>33024</c:v>
                </c:pt>
                <c:pt idx="100">
                  <c:v>24054</c:v>
                </c:pt>
                <c:pt idx="101">
                  <c:v>16892</c:v>
                </c:pt>
                <c:pt idx="102">
                  <c:v>13154</c:v>
                </c:pt>
                <c:pt idx="103">
                  <c:v>6546</c:v>
                </c:pt>
                <c:pt idx="104">
                  <c:v>75153</c:v>
                </c:pt>
                <c:pt idx="105">
                  <c:v>53891</c:v>
                </c:pt>
                <c:pt idx="106">
                  <c:v>9024955</c:v>
                </c:pt>
                <c:pt idx="107">
                  <c:v>8969513</c:v>
                </c:pt>
                <c:pt idx="108">
                  <c:v>8920140</c:v>
                </c:pt>
                <c:pt idx="109">
                  <c:v>8876525</c:v>
                </c:pt>
                <c:pt idx="110">
                  <c:v>8818004</c:v>
                </c:pt>
                <c:pt idx="111">
                  <c:v>8767565</c:v>
                </c:pt>
                <c:pt idx="112">
                  <c:v>8394234</c:v>
                </c:pt>
                <c:pt idx="113">
                  <c:v>8333442</c:v>
                </c:pt>
                <c:pt idx="114">
                  <c:v>8119666</c:v>
                </c:pt>
                <c:pt idx="115">
                  <c:v>7622079</c:v>
                </c:pt>
                <c:pt idx="116">
                  <c:v>7003306</c:v>
                </c:pt>
                <c:pt idx="117">
                  <c:v>6909237</c:v>
                </c:pt>
                <c:pt idx="118">
                  <c:v>5961166</c:v>
                </c:pt>
                <c:pt idx="119">
                  <c:v>5241948</c:v>
                </c:pt>
                <c:pt idx="120">
                  <c:v>4577797</c:v>
                </c:pt>
                <c:pt idx="121">
                  <c:v>4199253</c:v>
                </c:pt>
                <c:pt idx="122">
                  <c:v>3271186</c:v>
                </c:pt>
                <c:pt idx="123">
                  <c:v>2899705</c:v>
                </c:pt>
                <c:pt idx="124">
                  <c:v>2893085</c:v>
                </c:pt>
                <c:pt idx="125">
                  <c:v>2797405</c:v>
                </c:pt>
                <c:pt idx="126">
                  <c:v>2369919</c:v>
                </c:pt>
                <c:pt idx="127">
                  <c:v>2160691</c:v>
                </c:pt>
                <c:pt idx="128">
                  <c:v>2133545</c:v>
                </c:pt>
                <c:pt idx="129">
                  <c:v>1995598</c:v>
                </c:pt>
                <c:pt idx="130">
                  <c:v>1905383</c:v>
                </c:pt>
                <c:pt idx="131">
                  <c:v>1873224</c:v>
                </c:pt>
                <c:pt idx="132">
                  <c:v>1783578</c:v>
                </c:pt>
                <c:pt idx="133">
                  <c:v>1677758</c:v>
                </c:pt>
                <c:pt idx="134">
                  <c:v>1594341</c:v>
                </c:pt>
                <c:pt idx="135">
                  <c:v>1514096</c:v>
                </c:pt>
                <c:pt idx="136">
                  <c:v>1487759</c:v>
                </c:pt>
                <c:pt idx="137">
                  <c:v>1443160</c:v>
                </c:pt>
                <c:pt idx="138">
                  <c:v>1273477</c:v>
                </c:pt>
                <c:pt idx="139">
                  <c:v>1165058</c:v>
                </c:pt>
                <c:pt idx="140">
                  <c:v>1135771</c:v>
                </c:pt>
                <c:pt idx="141">
                  <c:v>1038865</c:v>
                </c:pt>
                <c:pt idx="142">
                  <c:v>1012340</c:v>
                </c:pt>
                <c:pt idx="143">
                  <c:v>774411</c:v>
                </c:pt>
                <c:pt idx="144">
                  <c:v>751059</c:v>
                </c:pt>
                <c:pt idx="145">
                  <c:v>709668</c:v>
                </c:pt>
                <c:pt idx="146">
                  <c:v>698618</c:v>
                </c:pt>
                <c:pt idx="147">
                  <c:v>618908</c:v>
                </c:pt>
                <c:pt idx="148">
                  <c:v>598275</c:v>
                </c:pt>
                <c:pt idx="149">
                  <c:v>459196</c:v>
                </c:pt>
                <c:pt idx="150">
                  <c:v>439748</c:v>
                </c:pt>
                <c:pt idx="151">
                  <c:v>394595</c:v>
                </c:pt>
                <c:pt idx="152">
                  <c:v>366706</c:v>
                </c:pt>
                <c:pt idx="153">
                  <c:v>352927</c:v>
                </c:pt>
                <c:pt idx="154">
                  <c:v>350163</c:v>
                </c:pt>
                <c:pt idx="155">
                  <c:v>308723</c:v>
                </c:pt>
                <c:pt idx="156">
                  <c:v>306927</c:v>
                </c:pt>
                <c:pt idx="157">
                  <c:v>305030</c:v>
                </c:pt>
                <c:pt idx="158">
                  <c:v>269141</c:v>
                </c:pt>
                <c:pt idx="159">
                  <c:v>265410</c:v>
                </c:pt>
                <c:pt idx="160">
                  <c:v>263437</c:v>
                </c:pt>
                <c:pt idx="161">
                  <c:v>260677</c:v>
                </c:pt>
                <c:pt idx="162">
                  <c:v>249724</c:v>
                </c:pt>
                <c:pt idx="163">
                  <c:v>221227</c:v>
                </c:pt>
                <c:pt idx="164">
                  <c:v>210671</c:v>
                </c:pt>
                <c:pt idx="165">
                  <c:v>186731</c:v>
                </c:pt>
                <c:pt idx="166">
                  <c:v>175190</c:v>
                </c:pt>
                <c:pt idx="167">
                  <c:v>159919</c:v>
                </c:pt>
                <c:pt idx="168">
                  <c:v>158623</c:v>
                </c:pt>
                <c:pt idx="169">
                  <c:v>150462</c:v>
                </c:pt>
                <c:pt idx="170">
                  <c:v>141892</c:v>
                </c:pt>
                <c:pt idx="171">
                  <c:v>127414</c:v>
                </c:pt>
                <c:pt idx="172">
                  <c:v>116563</c:v>
                </c:pt>
                <c:pt idx="173">
                  <c:v>110789</c:v>
                </c:pt>
                <c:pt idx="174">
                  <c:v>107587</c:v>
                </c:pt>
                <c:pt idx="175">
                  <c:v>95324</c:v>
                </c:pt>
                <c:pt idx="176">
                  <c:v>94872</c:v>
                </c:pt>
                <c:pt idx="177">
                  <c:v>89797</c:v>
                </c:pt>
                <c:pt idx="178">
                  <c:v>84313</c:v>
                </c:pt>
                <c:pt idx="179">
                  <c:v>81608</c:v>
                </c:pt>
                <c:pt idx="180">
                  <c:v>74664</c:v>
                </c:pt>
                <c:pt idx="181">
                  <c:v>73621</c:v>
                </c:pt>
                <c:pt idx="182">
                  <c:v>66510</c:v>
                </c:pt>
                <c:pt idx="183">
                  <c:v>58192</c:v>
                </c:pt>
                <c:pt idx="184">
                  <c:v>53569</c:v>
                </c:pt>
                <c:pt idx="185">
                  <c:v>51866</c:v>
                </c:pt>
                <c:pt idx="186">
                  <c:v>49724</c:v>
                </c:pt>
                <c:pt idx="187">
                  <c:v>47715</c:v>
                </c:pt>
                <c:pt idx="188">
                  <c:v>47252</c:v>
                </c:pt>
                <c:pt idx="189">
                  <c:v>46983</c:v>
                </c:pt>
                <c:pt idx="190">
                  <c:v>43599</c:v>
                </c:pt>
                <c:pt idx="191">
                  <c:v>40647</c:v>
                </c:pt>
                <c:pt idx="192">
                  <c:v>39744</c:v>
                </c:pt>
                <c:pt idx="193">
                  <c:v>35537</c:v>
                </c:pt>
                <c:pt idx="194">
                  <c:v>32899</c:v>
                </c:pt>
                <c:pt idx="195">
                  <c:v>30177</c:v>
                </c:pt>
                <c:pt idx="196">
                  <c:v>28780</c:v>
                </c:pt>
                <c:pt idx="197">
                  <c:v>28593</c:v>
                </c:pt>
                <c:pt idx="198">
                  <c:v>27853</c:v>
                </c:pt>
                <c:pt idx="199">
                  <c:v>26486</c:v>
                </c:pt>
                <c:pt idx="200">
                  <c:v>26038</c:v>
                </c:pt>
                <c:pt idx="201">
                  <c:v>25028</c:v>
                </c:pt>
                <c:pt idx="202">
                  <c:v>24658</c:v>
                </c:pt>
                <c:pt idx="203">
                  <c:v>24483</c:v>
                </c:pt>
                <c:pt idx="204">
                  <c:v>24073</c:v>
                </c:pt>
                <c:pt idx="205">
                  <c:v>23530</c:v>
                </c:pt>
                <c:pt idx="206">
                  <c:v>23330</c:v>
                </c:pt>
                <c:pt idx="207">
                  <c:v>22977</c:v>
                </c:pt>
                <c:pt idx="208">
                  <c:v>22959</c:v>
                </c:pt>
                <c:pt idx="209">
                  <c:v>22619</c:v>
                </c:pt>
                <c:pt idx="210">
                  <c:v>22354</c:v>
                </c:pt>
                <c:pt idx="211">
                  <c:v>20135</c:v>
                </c:pt>
                <c:pt idx="212">
                  <c:v>19055</c:v>
                </c:pt>
                <c:pt idx="213">
                  <c:v>18274</c:v>
                </c:pt>
                <c:pt idx="214">
                  <c:v>17798</c:v>
                </c:pt>
                <c:pt idx="215">
                  <c:v>15533</c:v>
                </c:pt>
                <c:pt idx="216">
                  <c:v>15125</c:v>
                </c:pt>
                <c:pt idx="217">
                  <c:v>14900</c:v>
                </c:pt>
                <c:pt idx="218">
                  <c:v>14273</c:v>
                </c:pt>
                <c:pt idx="219">
                  <c:v>13466</c:v>
                </c:pt>
                <c:pt idx="220">
                  <c:v>13049</c:v>
                </c:pt>
                <c:pt idx="221">
                  <c:v>11002</c:v>
                </c:pt>
                <c:pt idx="222">
                  <c:v>10972</c:v>
                </c:pt>
                <c:pt idx="223">
                  <c:v>10748</c:v>
                </c:pt>
                <c:pt idx="224">
                  <c:v>8835</c:v>
                </c:pt>
                <c:pt idx="225">
                  <c:v>8540</c:v>
                </c:pt>
                <c:pt idx="226">
                  <c:v>8109</c:v>
                </c:pt>
                <c:pt idx="227">
                  <c:v>7859</c:v>
                </c:pt>
                <c:pt idx="228">
                  <c:v>7456</c:v>
                </c:pt>
                <c:pt idx="229">
                  <c:v>7434</c:v>
                </c:pt>
                <c:pt idx="230">
                  <c:v>7253</c:v>
                </c:pt>
                <c:pt idx="231">
                  <c:v>7141</c:v>
                </c:pt>
                <c:pt idx="232">
                  <c:v>6685</c:v>
                </c:pt>
                <c:pt idx="233">
                  <c:v>6501</c:v>
                </c:pt>
                <c:pt idx="234">
                  <c:v>6000</c:v>
                </c:pt>
                <c:pt idx="235">
                  <c:v>5988</c:v>
                </c:pt>
                <c:pt idx="236">
                  <c:v>5580</c:v>
                </c:pt>
                <c:pt idx="237">
                  <c:v>5559</c:v>
                </c:pt>
                <c:pt idx="238">
                  <c:v>4787</c:v>
                </c:pt>
                <c:pt idx="239">
                  <c:v>4088</c:v>
                </c:pt>
                <c:pt idx="240">
                  <c:v>3497</c:v>
                </c:pt>
                <c:pt idx="241">
                  <c:v>2770</c:v>
                </c:pt>
                <c:pt idx="242">
                  <c:v>341684</c:v>
                </c:pt>
                <c:pt idx="243">
                  <c:v>189797</c:v>
                </c:pt>
                <c:pt idx="244">
                  <c:v>106715</c:v>
                </c:pt>
                <c:pt idx="245">
                  <c:v>106366</c:v>
                </c:pt>
                <c:pt idx="246">
                  <c:v>83835</c:v>
                </c:pt>
                <c:pt idx="247">
                  <c:v>66466</c:v>
                </c:pt>
                <c:pt idx="248">
                  <c:v>59997</c:v>
                </c:pt>
                <c:pt idx="249">
                  <c:v>50851</c:v>
                </c:pt>
                <c:pt idx="250">
                  <c:v>32955</c:v>
                </c:pt>
                <c:pt idx="251">
                  <c:v>29873</c:v>
                </c:pt>
                <c:pt idx="252">
                  <c:v>26061</c:v>
                </c:pt>
                <c:pt idx="253">
                  <c:v>2569619</c:v>
                </c:pt>
                <c:pt idx="254">
                  <c:v>492575</c:v>
                </c:pt>
                <c:pt idx="255">
                  <c:v>339983</c:v>
                </c:pt>
                <c:pt idx="256">
                  <c:v>8989987</c:v>
                </c:pt>
                <c:pt idx="257">
                  <c:v>7744112</c:v>
                </c:pt>
                <c:pt idx="258">
                  <c:v>7347397</c:v>
                </c:pt>
                <c:pt idx="259">
                  <c:v>7302740</c:v>
                </c:pt>
                <c:pt idx="260">
                  <c:v>7227734</c:v>
                </c:pt>
                <c:pt idx="261">
                  <c:v>6909876</c:v>
                </c:pt>
                <c:pt idx="262">
                  <c:v>6661378</c:v>
                </c:pt>
                <c:pt idx="263">
                  <c:v>6237265</c:v>
                </c:pt>
                <c:pt idx="264">
                  <c:v>5084359</c:v>
                </c:pt>
                <c:pt idx="265">
                  <c:v>4883357</c:v>
                </c:pt>
                <c:pt idx="266">
                  <c:v>4605067</c:v>
                </c:pt>
                <c:pt idx="267">
                  <c:v>4376323</c:v>
                </c:pt>
                <c:pt idx="268">
                  <c:v>4357177</c:v>
                </c:pt>
                <c:pt idx="269">
                  <c:v>4262457</c:v>
                </c:pt>
                <c:pt idx="270">
                  <c:v>2953064</c:v>
                </c:pt>
                <c:pt idx="271">
                  <c:v>2946410</c:v>
                </c:pt>
                <c:pt idx="272">
                  <c:v>2562385</c:v>
                </c:pt>
                <c:pt idx="273">
                  <c:v>2339133</c:v>
                </c:pt>
                <c:pt idx="274">
                  <c:v>2303947</c:v>
                </c:pt>
                <c:pt idx="275">
                  <c:v>1196201</c:v>
                </c:pt>
                <c:pt idx="276">
                  <c:v>1035844</c:v>
                </c:pt>
                <c:pt idx="277">
                  <c:v>941233</c:v>
                </c:pt>
                <c:pt idx="278">
                  <c:v>688186</c:v>
                </c:pt>
                <c:pt idx="279">
                  <c:v>520509</c:v>
                </c:pt>
                <c:pt idx="280">
                  <c:v>514495</c:v>
                </c:pt>
                <c:pt idx="281">
                  <c:v>400176</c:v>
                </c:pt>
                <c:pt idx="282">
                  <c:v>344249</c:v>
                </c:pt>
                <c:pt idx="283">
                  <c:v>337546</c:v>
                </c:pt>
                <c:pt idx="284">
                  <c:v>312873</c:v>
                </c:pt>
                <c:pt idx="285">
                  <c:v>308638</c:v>
                </c:pt>
                <c:pt idx="286">
                  <c:v>284724</c:v>
                </c:pt>
                <c:pt idx="287">
                  <c:v>281724</c:v>
                </c:pt>
                <c:pt idx="288">
                  <c:v>260449</c:v>
                </c:pt>
                <c:pt idx="289">
                  <c:v>254104</c:v>
                </c:pt>
                <c:pt idx="290">
                  <c:v>244098</c:v>
                </c:pt>
                <c:pt idx="291">
                  <c:v>225231</c:v>
                </c:pt>
                <c:pt idx="292">
                  <c:v>210916</c:v>
                </c:pt>
                <c:pt idx="293">
                  <c:v>203168</c:v>
                </c:pt>
                <c:pt idx="294">
                  <c:v>186106</c:v>
                </c:pt>
                <c:pt idx="295">
                  <c:v>130625</c:v>
                </c:pt>
                <c:pt idx="296">
                  <c:v>122195</c:v>
                </c:pt>
                <c:pt idx="297">
                  <c:v>119153</c:v>
                </c:pt>
                <c:pt idx="298">
                  <c:v>105867</c:v>
                </c:pt>
                <c:pt idx="299">
                  <c:v>105691</c:v>
                </c:pt>
                <c:pt idx="300">
                  <c:v>83109</c:v>
                </c:pt>
                <c:pt idx="301">
                  <c:v>74716</c:v>
                </c:pt>
                <c:pt idx="302">
                  <c:v>67006</c:v>
                </c:pt>
                <c:pt idx="303">
                  <c:v>48130</c:v>
                </c:pt>
                <c:pt idx="304">
                  <c:v>38248</c:v>
                </c:pt>
                <c:pt idx="305">
                  <c:v>36987</c:v>
                </c:pt>
                <c:pt idx="306">
                  <c:v>31965</c:v>
                </c:pt>
                <c:pt idx="307">
                  <c:v>28647</c:v>
                </c:pt>
                <c:pt idx="308">
                  <c:v>27075</c:v>
                </c:pt>
                <c:pt idx="309">
                  <c:v>26734</c:v>
                </c:pt>
                <c:pt idx="310">
                  <c:v>21674</c:v>
                </c:pt>
                <c:pt idx="311">
                  <c:v>19748</c:v>
                </c:pt>
                <c:pt idx="312">
                  <c:v>19621</c:v>
                </c:pt>
                <c:pt idx="313">
                  <c:v>18214</c:v>
                </c:pt>
                <c:pt idx="314">
                  <c:v>15007</c:v>
                </c:pt>
                <c:pt idx="315">
                  <c:v>13667</c:v>
                </c:pt>
                <c:pt idx="316">
                  <c:v>12762</c:v>
                </c:pt>
                <c:pt idx="317">
                  <c:v>12467</c:v>
                </c:pt>
                <c:pt idx="318">
                  <c:v>12383</c:v>
                </c:pt>
                <c:pt idx="319">
                  <c:v>11045</c:v>
                </c:pt>
                <c:pt idx="320">
                  <c:v>8512</c:v>
                </c:pt>
                <c:pt idx="321">
                  <c:v>7891</c:v>
                </c:pt>
                <c:pt idx="322">
                  <c:v>7643</c:v>
                </c:pt>
                <c:pt idx="323">
                  <c:v>6159</c:v>
                </c:pt>
                <c:pt idx="324">
                  <c:v>4730</c:v>
                </c:pt>
                <c:pt idx="325">
                  <c:v>3422</c:v>
                </c:pt>
                <c:pt idx="326">
                  <c:v>7992974</c:v>
                </c:pt>
                <c:pt idx="327">
                  <c:v>7644599</c:v>
                </c:pt>
                <c:pt idx="328">
                  <c:v>7424228</c:v>
                </c:pt>
                <c:pt idx="329">
                  <c:v>6017987</c:v>
                </c:pt>
                <c:pt idx="330">
                  <c:v>4927732</c:v>
                </c:pt>
                <c:pt idx="331">
                  <c:v>4140243</c:v>
                </c:pt>
                <c:pt idx="332">
                  <c:v>3462735</c:v>
                </c:pt>
                <c:pt idx="333">
                  <c:v>3459861</c:v>
                </c:pt>
                <c:pt idx="334">
                  <c:v>3108992</c:v>
                </c:pt>
                <c:pt idx="335">
                  <c:v>3037453</c:v>
                </c:pt>
                <c:pt idx="336">
                  <c:v>2580778</c:v>
                </c:pt>
                <c:pt idx="337">
                  <c:v>2569919</c:v>
                </c:pt>
                <c:pt idx="338">
                  <c:v>2525929</c:v>
                </c:pt>
                <c:pt idx="339">
                  <c:v>2467872</c:v>
                </c:pt>
                <c:pt idx="340">
                  <c:v>2452716</c:v>
                </c:pt>
                <c:pt idx="341">
                  <c:v>2340423</c:v>
                </c:pt>
                <c:pt idx="342">
                  <c:v>2301349</c:v>
                </c:pt>
                <c:pt idx="343">
                  <c:v>2023592</c:v>
                </c:pt>
                <c:pt idx="344">
                  <c:v>1922360</c:v>
                </c:pt>
                <c:pt idx="345">
                  <c:v>1886338</c:v>
                </c:pt>
                <c:pt idx="346">
                  <c:v>1629194</c:v>
                </c:pt>
                <c:pt idx="347">
                  <c:v>1476640</c:v>
                </c:pt>
                <c:pt idx="348">
                  <c:v>1467094</c:v>
                </c:pt>
                <c:pt idx="349">
                  <c:v>1344727</c:v>
                </c:pt>
                <c:pt idx="350">
                  <c:v>1332416</c:v>
                </c:pt>
                <c:pt idx="351">
                  <c:v>1301553</c:v>
                </c:pt>
                <c:pt idx="352">
                  <c:v>963120</c:v>
                </c:pt>
                <c:pt idx="353">
                  <c:v>867062</c:v>
                </c:pt>
                <c:pt idx="354">
                  <c:v>787097</c:v>
                </c:pt>
                <c:pt idx="355">
                  <c:v>765950</c:v>
                </c:pt>
                <c:pt idx="356">
                  <c:v>715604</c:v>
                </c:pt>
                <c:pt idx="357">
                  <c:v>688480</c:v>
                </c:pt>
                <c:pt idx="358">
                  <c:v>665137</c:v>
                </c:pt>
                <c:pt idx="359">
                  <c:v>661303</c:v>
                </c:pt>
                <c:pt idx="360">
                  <c:v>636912</c:v>
                </c:pt>
                <c:pt idx="361">
                  <c:v>555301</c:v>
                </c:pt>
                <c:pt idx="362">
                  <c:v>549955</c:v>
                </c:pt>
                <c:pt idx="363">
                  <c:v>504655</c:v>
                </c:pt>
                <c:pt idx="364">
                  <c:v>459660</c:v>
                </c:pt>
                <c:pt idx="365">
                  <c:v>458959</c:v>
                </c:pt>
                <c:pt idx="366">
                  <c:v>388476</c:v>
                </c:pt>
                <c:pt idx="367">
                  <c:v>371009</c:v>
                </c:pt>
                <c:pt idx="368">
                  <c:v>363339</c:v>
                </c:pt>
                <c:pt idx="369">
                  <c:v>341072</c:v>
                </c:pt>
                <c:pt idx="370">
                  <c:v>328130</c:v>
                </c:pt>
                <c:pt idx="371">
                  <c:v>307027</c:v>
                </c:pt>
                <c:pt idx="372">
                  <c:v>294825</c:v>
                </c:pt>
                <c:pt idx="373">
                  <c:v>278878</c:v>
                </c:pt>
                <c:pt idx="374">
                  <c:v>257623</c:v>
                </c:pt>
                <c:pt idx="375">
                  <c:v>200573</c:v>
                </c:pt>
                <c:pt idx="376">
                  <c:v>195051</c:v>
                </c:pt>
                <c:pt idx="377">
                  <c:v>184037</c:v>
                </c:pt>
                <c:pt idx="378">
                  <c:v>179009</c:v>
                </c:pt>
                <c:pt idx="379">
                  <c:v>174674</c:v>
                </c:pt>
                <c:pt idx="380">
                  <c:v>154192</c:v>
                </c:pt>
                <c:pt idx="381">
                  <c:v>143647</c:v>
                </c:pt>
                <c:pt idx="382">
                  <c:v>141416</c:v>
                </c:pt>
                <c:pt idx="383">
                  <c:v>139843</c:v>
                </c:pt>
                <c:pt idx="384">
                  <c:v>106294</c:v>
                </c:pt>
                <c:pt idx="385">
                  <c:v>95655</c:v>
                </c:pt>
                <c:pt idx="386">
                  <c:v>84793</c:v>
                </c:pt>
                <c:pt idx="387">
                  <c:v>82636</c:v>
                </c:pt>
                <c:pt idx="388">
                  <c:v>80526</c:v>
                </c:pt>
                <c:pt idx="389">
                  <c:v>67537</c:v>
                </c:pt>
                <c:pt idx="390">
                  <c:v>64338</c:v>
                </c:pt>
                <c:pt idx="391">
                  <c:v>63578</c:v>
                </c:pt>
                <c:pt idx="392">
                  <c:v>62701</c:v>
                </c:pt>
                <c:pt idx="393">
                  <c:v>61843</c:v>
                </c:pt>
                <c:pt idx="394">
                  <c:v>46830</c:v>
                </c:pt>
                <c:pt idx="395">
                  <c:v>42305</c:v>
                </c:pt>
                <c:pt idx="396">
                  <c:v>40055</c:v>
                </c:pt>
                <c:pt idx="397">
                  <c:v>38885</c:v>
                </c:pt>
                <c:pt idx="398">
                  <c:v>29049</c:v>
                </c:pt>
                <c:pt idx="399">
                  <c:v>25590</c:v>
                </c:pt>
                <c:pt idx="400">
                  <c:v>23468</c:v>
                </c:pt>
                <c:pt idx="401">
                  <c:v>19094</c:v>
                </c:pt>
                <c:pt idx="402">
                  <c:v>17768</c:v>
                </c:pt>
                <c:pt idx="403">
                  <c:v>16182</c:v>
                </c:pt>
                <c:pt idx="404">
                  <c:v>14733</c:v>
                </c:pt>
                <c:pt idx="405">
                  <c:v>13884</c:v>
                </c:pt>
                <c:pt idx="406">
                  <c:v>11481</c:v>
                </c:pt>
                <c:pt idx="407">
                  <c:v>9614</c:v>
                </c:pt>
                <c:pt idx="408">
                  <c:v>9136</c:v>
                </c:pt>
                <c:pt idx="409">
                  <c:v>7926</c:v>
                </c:pt>
                <c:pt idx="410">
                  <c:v>6715</c:v>
                </c:pt>
                <c:pt idx="411">
                  <c:v>4217</c:v>
                </c:pt>
                <c:pt idx="412">
                  <c:v>3689</c:v>
                </c:pt>
              </c:numCache>
            </c:numRef>
          </c:xVal>
          <c:yVal>
            <c:numRef>
              <c:f>'[Abundance vs mass accuracy.xlsx]Negative Annotated Lipids 1-6'!$Q$2:$Q$504</c:f>
              <c:numCache>
                <c:formatCode>General</c:formatCode>
                <c:ptCount val="503"/>
                <c:pt idx="0">
                  <c:v>-1.1000000000000001</c:v>
                </c:pt>
                <c:pt idx="1">
                  <c:v>0</c:v>
                </c:pt>
                <c:pt idx="2">
                  <c:v>-0.1</c:v>
                </c:pt>
                <c:pt idx="3">
                  <c:v>0</c:v>
                </c:pt>
                <c:pt idx="4">
                  <c:v>-0.2</c:v>
                </c:pt>
                <c:pt idx="5">
                  <c:v>0</c:v>
                </c:pt>
                <c:pt idx="6">
                  <c:v>0.2</c:v>
                </c:pt>
                <c:pt idx="7">
                  <c:v>0</c:v>
                </c:pt>
                <c:pt idx="8">
                  <c:v>-0.1</c:v>
                </c:pt>
                <c:pt idx="9">
                  <c:v>-0.1</c:v>
                </c:pt>
                <c:pt idx="10">
                  <c:v>-0.1</c:v>
                </c:pt>
                <c:pt idx="11">
                  <c:v>-0.9</c:v>
                </c:pt>
                <c:pt idx="12">
                  <c:v>-0.1</c:v>
                </c:pt>
                <c:pt idx="13">
                  <c:v>0.1</c:v>
                </c:pt>
                <c:pt idx="14">
                  <c:v>0.1</c:v>
                </c:pt>
                <c:pt idx="15">
                  <c:v>-0.3</c:v>
                </c:pt>
                <c:pt idx="16">
                  <c:v>-0.2</c:v>
                </c:pt>
                <c:pt idx="17">
                  <c:v>0.1</c:v>
                </c:pt>
                <c:pt idx="18">
                  <c:v>-0.1</c:v>
                </c:pt>
                <c:pt idx="19">
                  <c:v>-0.1</c:v>
                </c:pt>
                <c:pt idx="20">
                  <c:v>-1</c:v>
                </c:pt>
                <c:pt idx="21">
                  <c:v>-0.2</c:v>
                </c:pt>
                <c:pt idx="22">
                  <c:v>-0.8</c:v>
                </c:pt>
                <c:pt idx="23">
                  <c:v>-0.1</c:v>
                </c:pt>
                <c:pt idx="24">
                  <c:v>-0.4</c:v>
                </c:pt>
                <c:pt idx="25">
                  <c:v>-0.3</c:v>
                </c:pt>
                <c:pt idx="26">
                  <c:v>-0.2</c:v>
                </c:pt>
                <c:pt idx="27">
                  <c:v>-0.3</c:v>
                </c:pt>
                <c:pt idx="28">
                  <c:v>-0.2</c:v>
                </c:pt>
                <c:pt idx="29">
                  <c:v>0</c:v>
                </c:pt>
                <c:pt idx="30">
                  <c:v>-0.5</c:v>
                </c:pt>
                <c:pt idx="31">
                  <c:v>-0.2</c:v>
                </c:pt>
                <c:pt idx="32">
                  <c:v>-0.3</c:v>
                </c:pt>
                <c:pt idx="33">
                  <c:v>-1.1000000000000001</c:v>
                </c:pt>
                <c:pt idx="34">
                  <c:v>-0.6</c:v>
                </c:pt>
                <c:pt idx="35">
                  <c:v>-0.2</c:v>
                </c:pt>
                <c:pt idx="36">
                  <c:v>-0.2</c:v>
                </c:pt>
                <c:pt idx="37">
                  <c:v>-2.7</c:v>
                </c:pt>
                <c:pt idx="38">
                  <c:v>-0.3</c:v>
                </c:pt>
                <c:pt idx="39">
                  <c:v>-0.2</c:v>
                </c:pt>
                <c:pt idx="40">
                  <c:v>-0.6</c:v>
                </c:pt>
                <c:pt idx="41">
                  <c:v>-0.4</c:v>
                </c:pt>
                <c:pt idx="42">
                  <c:v>-0.7</c:v>
                </c:pt>
                <c:pt idx="43">
                  <c:v>0.1</c:v>
                </c:pt>
                <c:pt idx="44">
                  <c:v>-0.1</c:v>
                </c:pt>
                <c:pt idx="45">
                  <c:v>-0.8</c:v>
                </c:pt>
                <c:pt idx="46">
                  <c:v>-0.5</c:v>
                </c:pt>
                <c:pt idx="47">
                  <c:v>-0.7</c:v>
                </c:pt>
                <c:pt idx="48">
                  <c:v>-0.2</c:v>
                </c:pt>
                <c:pt idx="49">
                  <c:v>-1.4</c:v>
                </c:pt>
                <c:pt idx="50">
                  <c:v>0.3</c:v>
                </c:pt>
                <c:pt idx="51">
                  <c:v>2.9</c:v>
                </c:pt>
                <c:pt idx="52">
                  <c:v>-0.3</c:v>
                </c:pt>
                <c:pt idx="53">
                  <c:v>-0.2</c:v>
                </c:pt>
                <c:pt idx="54">
                  <c:v>-0.2</c:v>
                </c:pt>
                <c:pt idx="55">
                  <c:v>-0.2</c:v>
                </c:pt>
                <c:pt idx="56">
                  <c:v>-0.1</c:v>
                </c:pt>
                <c:pt idx="57">
                  <c:v>-0.1</c:v>
                </c:pt>
                <c:pt idx="58">
                  <c:v>-0.2</c:v>
                </c:pt>
                <c:pt idx="59">
                  <c:v>-0.3</c:v>
                </c:pt>
                <c:pt idx="60">
                  <c:v>-0.2</c:v>
                </c:pt>
                <c:pt idx="61">
                  <c:v>-0.3</c:v>
                </c:pt>
                <c:pt idx="62">
                  <c:v>-0.3</c:v>
                </c:pt>
                <c:pt idx="63">
                  <c:v>-0.4</c:v>
                </c:pt>
                <c:pt idx="64">
                  <c:v>-0.3</c:v>
                </c:pt>
                <c:pt idx="65">
                  <c:v>-0.4</c:v>
                </c:pt>
                <c:pt idx="66">
                  <c:v>0.1</c:v>
                </c:pt>
                <c:pt idx="67">
                  <c:v>-0.3</c:v>
                </c:pt>
                <c:pt idx="68">
                  <c:v>-0.1</c:v>
                </c:pt>
                <c:pt idx="69">
                  <c:v>-0.3</c:v>
                </c:pt>
                <c:pt idx="70">
                  <c:v>-0.3</c:v>
                </c:pt>
                <c:pt idx="71">
                  <c:v>-0.4</c:v>
                </c:pt>
                <c:pt idx="72">
                  <c:v>-0.5</c:v>
                </c:pt>
                <c:pt idx="73">
                  <c:v>-1.2</c:v>
                </c:pt>
                <c:pt idx="74">
                  <c:v>-0.5</c:v>
                </c:pt>
                <c:pt idx="75">
                  <c:v>-0.3</c:v>
                </c:pt>
                <c:pt idx="76">
                  <c:v>-0.4</c:v>
                </c:pt>
                <c:pt idx="77">
                  <c:v>-0.3</c:v>
                </c:pt>
                <c:pt idx="78">
                  <c:v>-0.4</c:v>
                </c:pt>
                <c:pt idx="79">
                  <c:v>-0.5</c:v>
                </c:pt>
                <c:pt idx="80">
                  <c:v>-0.8</c:v>
                </c:pt>
                <c:pt idx="81">
                  <c:v>-0.4</c:v>
                </c:pt>
                <c:pt idx="82">
                  <c:v>-0.5</c:v>
                </c:pt>
                <c:pt idx="83">
                  <c:v>0.1</c:v>
                </c:pt>
                <c:pt idx="84">
                  <c:v>-0.6</c:v>
                </c:pt>
                <c:pt idx="85">
                  <c:v>-0.6</c:v>
                </c:pt>
                <c:pt idx="86">
                  <c:v>-0.3</c:v>
                </c:pt>
                <c:pt idx="87">
                  <c:v>-0.8</c:v>
                </c:pt>
                <c:pt idx="88">
                  <c:v>1.7</c:v>
                </c:pt>
                <c:pt idx="89">
                  <c:v>-0.4</c:v>
                </c:pt>
                <c:pt idx="90">
                  <c:v>-0.4</c:v>
                </c:pt>
                <c:pt idx="91">
                  <c:v>-0.6</c:v>
                </c:pt>
                <c:pt idx="92">
                  <c:v>-0.7</c:v>
                </c:pt>
                <c:pt idx="93">
                  <c:v>0</c:v>
                </c:pt>
                <c:pt idx="94">
                  <c:v>-2.5</c:v>
                </c:pt>
                <c:pt idx="95">
                  <c:v>-0.3</c:v>
                </c:pt>
                <c:pt idx="96">
                  <c:v>0</c:v>
                </c:pt>
                <c:pt idx="97">
                  <c:v>-1.1000000000000001</c:v>
                </c:pt>
                <c:pt idx="98">
                  <c:v>0</c:v>
                </c:pt>
                <c:pt idx="99">
                  <c:v>-0.3</c:v>
                </c:pt>
                <c:pt idx="100">
                  <c:v>-0.2</c:v>
                </c:pt>
                <c:pt idx="101">
                  <c:v>-0.3</c:v>
                </c:pt>
                <c:pt idx="102">
                  <c:v>-0.1</c:v>
                </c:pt>
                <c:pt idx="103">
                  <c:v>-0.2</c:v>
                </c:pt>
                <c:pt idx="104">
                  <c:v>-0.2</c:v>
                </c:pt>
                <c:pt idx="105">
                  <c:v>-0.2</c:v>
                </c:pt>
                <c:pt idx="106">
                  <c:v>-0.3</c:v>
                </c:pt>
                <c:pt idx="107">
                  <c:v>-0.3</c:v>
                </c:pt>
                <c:pt idx="108">
                  <c:v>-0.4</c:v>
                </c:pt>
                <c:pt idx="109">
                  <c:v>-0.5</c:v>
                </c:pt>
                <c:pt idx="110">
                  <c:v>-0.4</c:v>
                </c:pt>
                <c:pt idx="111">
                  <c:v>-0.4</c:v>
                </c:pt>
                <c:pt idx="112">
                  <c:v>-0.5</c:v>
                </c:pt>
                <c:pt idx="113">
                  <c:v>-0.6</c:v>
                </c:pt>
                <c:pt idx="114">
                  <c:v>-0.4</c:v>
                </c:pt>
                <c:pt idx="115">
                  <c:v>-0.6</c:v>
                </c:pt>
                <c:pt idx="116">
                  <c:v>-0.5</c:v>
                </c:pt>
                <c:pt idx="117">
                  <c:v>-0.8</c:v>
                </c:pt>
                <c:pt idx="118">
                  <c:v>-1</c:v>
                </c:pt>
                <c:pt idx="119">
                  <c:v>-0.5</c:v>
                </c:pt>
                <c:pt idx="120">
                  <c:v>-0.6</c:v>
                </c:pt>
                <c:pt idx="121">
                  <c:v>-1.4</c:v>
                </c:pt>
                <c:pt idx="122">
                  <c:v>-0.1</c:v>
                </c:pt>
                <c:pt idx="123">
                  <c:v>0</c:v>
                </c:pt>
                <c:pt idx="124">
                  <c:v>-0.1</c:v>
                </c:pt>
                <c:pt idx="125">
                  <c:v>-0.3</c:v>
                </c:pt>
                <c:pt idx="126">
                  <c:v>-4.5999999999999996</c:v>
                </c:pt>
                <c:pt idx="127">
                  <c:v>-0.1</c:v>
                </c:pt>
                <c:pt idx="128">
                  <c:v>-4.5</c:v>
                </c:pt>
                <c:pt idx="129">
                  <c:v>-0.2</c:v>
                </c:pt>
                <c:pt idx="130">
                  <c:v>-4.8</c:v>
                </c:pt>
                <c:pt idx="131">
                  <c:v>0</c:v>
                </c:pt>
                <c:pt idx="132">
                  <c:v>-4.7</c:v>
                </c:pt>
                <c:pt idx="133">
                  <c:v>1.6</c:v>
                </c:pt>
                <c:pt idx="134">
                  <c:v>-0.4</c:v>
                </c:pt>
                <c:pt idx="135">
                  <c:v>0.1</c:v>
                </c:pt>
                <c:pt idx="136">
                  <c:v>-0.2</c:v>
                </c:pt>
                <c:pt idx="137">
                  <c:v>1.4</c:v>
                </c:pt>
                <c:pt idx="138">
                  <c:v>0</c:v>
                </c:pt>
                <c:pt idx="139">
                  <c:v>1.5</c:v>
                </c:pt>
                <c:pt idx="140">
                  <c:v>-0.5</c:v>
                </c:pt>
                <c:pt idx="141">
                  <c:v>-0.3</c:v>
                </c:pt>
                <c:pt idx="142">
                  <c:v>-0.1</c:v>
                </c:pt>
                <c:pt idx="143">
                  <c:v>-0.1</c:v>
                </c:pt>
                <c:pt idx="144">
                  <c:v>1.4</c:v>
                </c:pt>
                <c:pt idx="145">
                  <c:v>-0.4</c:v>
                </c:pt>
                <c:pt idx="146">
                  <c:v>-0.5</c:v>
                </c:pt>
                <c:pt idx="147">
                  <c:v>1.5</c:v>
                </c:pt>
                <c:pt idx="148">
                  <c:v>-0.5</c:v>
                </c:pt>
                <c:pt idx="149">
                  <c:v>0</c:v>
                </c:pt>
                <c:pt idx="150">
                  <c:v>-0.5</c:v>
                </c:pt>
                <c:pt idx="151">
                  <c:v>1</c:v>
                </c:pt>
                <c:pt idx="152">
                  <c:v>-0.8</c:v>
                </c:pt>
                <c:pt idx="153">
                  <c:v>-0.1</c:v>
                </c:pt>
                <c:pt idx="154">
                  <c:v>-0.2</c:v>
                </c:pt>
                <c:pt idx="155">
                  <c:v>-0.8</c:v>
                </c:pt>
                <c:pt idx="156">
                  <c:v>-6.1</c:v>
                </c:pt>
                <c:pt idx="157">
                  <c:v>-0.5</c:v>
                </c:pt>
                <c:pt idx="158">
                  <c:v>-0.8</c:v>
                </c:pt>
                <c:pt idx="159">
                  <c:v>0.5</c:v>
                </c:pt>
                <c:pt idx="160">
                  <c:v>0.1</c:v>
                </c:pt>
                <c:pt idx="161">
                  <c:v>0.4</c:v>
                </c:pt>
                <c:pt idx="162">
                  <c:v>0.3</c:v>
                </c:pt>
                <c:pt idx="163">
                  <c:v>0.7</c:v>
                </c:pt>
                <c:pt idx="164">
                  <c:v>0.3</c:v>
                </c:pt>
                <c:pt idx="165">
                  <c:v>0.2</c:v>
                </c:pt>
                <c:pt idx="166">
                  <c:v>0.3</c:v>
                </c:pt>
                <c:pt idx="167">
                  <c:v>0.6</c:v>
                </c:pt>
                <c:pt idx="168">
                  <c:v>0.2</c:v>
                </c:pt>
                <c:pt idx="169">
                  <c:v>0.3</c:v>
                </c:pt>
                <c:pt idx="170">
                  <c:v>0.3</c:v>
                </c:pt>
                <c:pt idx="171">
                  <c:v>0.1</c:v>
                </c:pt>
                <c:pt idx="172">
                  <c:v>0.1</c:v>
                </c:pt>
                <c:pt idx="173">
                  <c:v>0</c:v>
                </c:pt>
                <c:pt idx="174">
                  <c:v>0.2</c:v>
                </c:pt>
                <c:pt idx="175">
                  <c:v>-0.1</c:v>
                </c:pt>
                <c:pt idx="176">
                  <c:v>0.3</c:v>
                </c:pt>
                <c:pt idx="177">
                  <c:v>0.1</c:v>
                </c:pt>
                <c:pt idx="178">
                  <c:v>-0.1</c:v>
                </c:pt>
                <c:pt idx="179">
                  <c:v>0.1</c:v>
                </c:pt>
                <c:pt idx="180">
                  <c:v>0.5</c:v>
                </c:pt>
                <c:pt idx="181">
                  <c:v>0.2</c:v>
                </c:pt>
                <c:pt idx="182">
                  <c:v>-0.2</c:v>
                </c:pt>
                <c:pt idx="183">
                  <c:v>0.2</c:v>
                </c:pt>
                <c:pt idx="184">
                  <c:v>0</c:v>
                </c:pt>
                <c:pt idx="185">
                  <c:v>0.1</c:v>
                </c:pt>
                <c:pt idx="186">
                  <c:v>0.1</c:v>
                </c:pt>
                <c:pt idx="187">
                  <c:v>0.2</c:v>
                </c:pt>
                <c:pt idx="188">
                  <c:v>0.1</c:v>
                </c:pt>
                <c:pt idx="189">
                  <c:v>0.1</c:v>
                </c:pt>
                <c:pt idx="190">
                  <c:v>0.1</c:v>
                </c:pt>
                <c:pt idx="191">
                  <c:v>0.3</c:v>
                </c:pt>
                <c:pt idx="192">
                  <c:v>0.3</c:v>
                </c:pt>
                <c:pt idx="193">
                  <c:v>0.3</c:v>
                </c:pt>
                <c:pt idx="194">
                  <c:v>0.3</c:v>
                </c:pt>
                <c:pt idx="195">
                  <c:v>-0.2</c:v>
                </c:pt>
                <c:pt idx="196">
                  <c:v>0.2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-0.2</c:v>
                </c:pt>
                <c:pt idx="201">
                  <c:v>-0.1</c:v>
                </c:pt>
                <c:pt idx="202">
                  <c:v>-0.3</c:v>
                </c:pt>
                <c:pt idx="203">
                  <c:v>-0.3</c:v>
                </c:pt>
                <c:pt idx="204">
                  <c:v>-0.1</c:v>
                </c:pt>
                <c:pt idx="205">
                  <c:v>-0.3</c:v>
                </c:pt>
                <c:pt idx="206">
                  <c:v>-0.6</c:v>
                </c:pt>
                <c:pt idx="207">
                  <c:v>-0.9</c:v>
                </c:pt>
                <c:pt idx="208">
                  <c:v>4.7</c:v>
                </c:pt>
                <c:pt idx="209">
                  <c:v>1.2</c:v>
                </c:pt>
                <c:pt idx="210">
                  <c:v>0</c:v>
                </c:pt>
                <c:pt idx="211">
                  <c:v>-0.1</c:v>
                </c:pt>
                <c:pt idx="212">
                  <c:v>-0.3</c:v>
                </c:pt>
                <c:pt idx="213">
                  <c:v>-0.4</c:v>
                </c:pt>
                <c:pt idx="214">
                  <c:v>-0.4</c:v>
                </c:pt>
                <c:pt idx="215">
                  <c:v>-0.2</c:v>
                </c:pt>
                <c:pt idx="216">
                  <c:v>-0.4</c:v>
                </c:pt>
                <c:pt idx="217">
                  <c:v>-0.3</c:v>
                </c:pt>
                <c:pt idx="218">
                  <c:v>-0.3</c:v>
                </c:pt>
                <c:pt idx="219">
                  <c:v>-0.5</c:v>
                </c:pt>
                <c:pt idx="220">
                  <c:v>-0.3</c:v>
                </c:pt>
                <c:pt idx="221">
                  <c:v>-1</c:v>
                </c:pt>
                <c:pt idx="222">
                  <c:v>-1.1000000000000001</c:v>
                </c:pt>
                <c:pt idx="223">
                  <c:v>0</c:v>
                </c:pt>
                <c:pt idx="224">
                  <c:v>0</c:v>
                </c:pt>
                <c:pt idx="225">
                  <c:v>0.1</c:v>
                </c:pt>
                <c:pt idx="226">
                  <c:v>-0.1</c:v>
                </c:pt>
                <c:pt idx="227">
                  <c:v>0</c:v>
                </c:pt>
                <c:pt idx="228">
                  <c:v>0</c:v>
                </c:pt>
                <c:pt idx="229">
                  <c:v>-0.1</c:v>
                </c:pt>
                <c:pt idx="230">
                  <c:v>-0.2</c:v>
                </c:pt>
                <c:pt idx="231">
                  <c:v>-0.1</c:v>
                </c:pt>
                <c:pt idx="232">
                  <c:v>-0.3</c:v>
                </c:pt>
                <c:pt idx="233">
                  <c:v>-0.1</c:v>
                </c:pt>
                <c:pt idx="234">
                  <c:v>-0.1</c:v>
                </c:pt>
                <c:pt idx="235">
                  <c:v>-0.1</c:v>
                </c:pt>
                <c:pt idx="236">
                  <c:v>-0.1</c:v>
                </c:pt>
                <c:pt idx="237">
                  <c:v>0</c:v>
                </c:pt>
                <c:pt idx="238">
                  <c:v>-0.1</c:v>
                </c:pt>
                <c:pt idx="239">
                  <c:v>-0.3</c:v>
                </c:pt>
                <c:pt idx="240">
                  <c:v>0</c:v>
                </c:pt>
                <c:pt idx="241">
                  <c:v>-0.2</c:v>
                </c:pt>
                <c:pt idx="242">
                  <c:v>-0.1</c:v>
                </c:pt>
                <c:pt idx="243">
                  <c:v>-0.3</c:v>
                </c:pt>
                <c:pt idx="244">
                  <c:v>-0.2</c:v>
                </c:pt>
                <c:pt idx="245">
                  <c:v>-0.1</c:v>
                </c:pt>
                <c:pt idx="246">
                  <c:v>-0.3</c:v>
                </c:pt>
                <c:pt idx="247">
                  <c:v>-0.6</c:v>
                </c:pt>
                <c:pt idx="248">
                  <c:v>-0.4</c:v>
                </c:pt>
                <c:pt idx="249">
                  <c:v>-0.3</c:v>
                </c:pt>
                <c:pt idx="250">
                  <c:v>-0.4</c:v>
                </c:pt>
                <c:pt idx="251">
                  <c:v>-0.5</c:v>
                </c:pt>
                <c:pt idx="252">
                  <c:v>-0.2</c:v>
                </c:pt>
                <c:pt idx="253">
                  <c:v>0.4</c:v>
                </c:pt>
                <c:pt idx="254">
                  <c:v>0.1</c:v>
                </c:pt>
                <c:pt idx="255">
                  <c:v>-0.1</c:v>
                </c:pt>
                <c:pt idx="256">
                  <c:v>-0.1</c:v>
                </c:pt>
                <c:pt idx="257">
                  <c:v>0.1</c:v>
                </c:pt>
                <c:pt idx="258">
                  <c:v>-0.2</c:v>
                </c:pt>
                <c:pt idx="259">
                  <c:v>0</c:v>
                </c:pt>
                <c:pt idx="260">
                  <c:v>0</c:v>
                </c:pt>
                <c:pt idx="261">
                  <c:v>-0.2</c:v>
                </c:pt>
                <c:pt idx="262">
                  <c:v>0.3</c:v>
                </c:pt>
                <c:pt idx="263">
                  <c:v>-0.4</c:v>
                </c:pt>
                <c:pt idx="264">
                  <c:v>-0.5</c:v>
                </c:pt>
                <c:pt idx="265">
                  <c:v>-0.5</c:v>
                </c:pt>
                <c:pt idx="266">
                  <c:v>-0.5</c:v>
                </c:pt>
                <c:pt idx="267">
                  <c:v>0</c:v>
                </c:pt>
                <c:pt idx="268">
                  <c:v>-0.1</c:v>
                </c:pt>
                <c:pt idx="269">
                  <c:v>-0.2</c:v>
                </c:pt>
                <c:pt idx="270">
                  <c:v>-0.1</c:v>
                </c:pt>
                <c:pt idx="271">
                  <c:v>-0.2</c:v>
                </c:pt>
                <c:pt idx="272">
                  <c:v>-0.1</c:v>
                </c:pt>
                <c:pt idx="273">
                  <c:v>0</c:v>
                </c:pt>
                <c:pt idx="274">
                  <c:v>-0.3</c:v>
                </c:pt>
                <c:pt idx="275">
                  <c:v>-0.1</c:v>
                </c:pt>
                <c:pt idx="276">
                  <c:v>-0.2</c:v>
                </c:pt>
                <c:pt idx="277">
                  <c:v>-0.5</c:v>
                </c:pt>
                <c:pt idx="278">
                  <c:v>-0.6</c:v>
                </c:pt>
                <c:pt idx="279">
                  <c:v>-0.5</c:v>
                </c:pt>
                <c:pt idx="280">
                  <c:v>0.1</c:v>
                </c:pt>
                <c:pt idx="281">
                  <c:v>0.9</c:v>
                </c:pt>
                <c:pt idx="282">
                  <c:v>-0.1</c:v>
                </c:pt>
                <c:pt idx="283">
                  <c:v>-0.2</c:v>
                </c:pt>
                <c:pt idx="284">
                  <c:v>0.1</c:v>
                </c:pt>
                <c:pt idx="285">
                  <c:v>-0.5</c:v>
                </c:pt>
                <c:pt idx="286">
                  <c:v>-0.3</c:v>
                </c:pt>
                <c:pt idx="287">
                  <c:v>-4.0999999999999996</c:v>
                </c:pt>
                <c:pt idx="288">
                  <c:v>0.3</c:v>
                </c:pt>
                <c:pt idx="289">
                  <c:v>0</c:v>
                </c:pt>
                <c:pt idx="290">
                  <c:v>0.1</c:v>
                </c:pt>
                <c:pt idx="291">
                  <c:v>-0.1</c:v>
                </c:pt>
                <c:pt idx="292">
                  <c:v>0</c:v>
                </c:pt>
                <c:pt idx="293">
                  <c:v>-0.1</c:v>
                </c:pt>
                <c:pt idx="294">
                  <c:v>0</c:v>
                </c:pt>
                <c:pt idx="295">
                  <c:v>-0.1</c:v>
                </c:pt>
                <c:pt idx="296">
                  <c:v>0</c:v>
                </c:pt>
                <c:pt idx="297">
                  <c:v>-0.1</c:v>
                </c:pt>
                <c:pt idx="298">
                  <c:v>-0.1</c:v>
                </c:pt>
                <c:pt idx="299">
                  <c:v>-0.2</c:v>
                </c:pt>
                <c:pt idx="300">
                  <c:v>-0.1</c:v>
                </c:pt>
                <c:pt idx="301">
                  <c:v>-0.2</c:v>
                </c:pt>
                <c:pt idx="302">
                  <c:v>-0.3</c:v>
                </c:pt>
                <c:pt idx="303">
                  <c:v>-0.2</c:v>
                </c:pt>
                <c:pt idx="304">
                  <c:v>-0.2</c:v>
                </c:pt>
                <c:pt idx="305">
                  <c:v>-0.1</c:v>
                </c:pt>
                <c:pt idx="306">
                  <c:v>-0.2</c:v>
                </c:pt>
                <c:pt idx="307">
                  <c:v>-0.3</c:v>
                </c:pt>
                <c:pt idx="308">
                  <c:v>-0.1</c:v>
                </c:pt>
                <c:pt idx="309">
                  <c:v>-0.2</c:v>
                </c:pt>
                <c:pt idx="310">
                  <c:v>-0.1</c:v>
                </c:pt>
                <c:pt idx="311">
                  <c:v>-0.2</c:v>
                </c:pt>
                <c:pt idx="312">
                  <c:v>-0.1</c:v>
                </c:pt>
                <c:pt idx="313">
                  <c:v>-0.3</c:v>
                </c:pt>
                <c:pt idx="314">
                  <c:v>-0.1</c:v>
                </c:pt>
                <c:pt idx="315">
                  <c:v>-0.3</c:v>
                </c:pt>
                <c:pt idx="316">
                  <c:v>-0.1</c:v>
                </c:pt>
                <c:pt idx="317">
                  <c:v>-0.3</c:v>
                </c:pt>
                <c:pt idx="318">
                  <c:v>0</c:v>
                </c:pt>
                <c:pt idx="319">
                  <c:v>-0.3</c:v>
                </c:pt>
                <c:pt idx="320">
                  <c:v>-0.4</c:v>
                </c:pt>
                <c:pt idx="321">
                  <c:v>-0.4</c:v>
                </c:pt>
                <c:pt idx="322">
                  <c:v>-0.3</c:v>
                </c:pt>
                <c:pt idx="323">
                  <c:v>-0.2</c:v>
                </c:pt>
                <c:pt idx="324">
                  <c:v>-0.5</c:v>
                </c:pt>
                <c:pt idx="325">
                  <c:v>-0.3</c:v>
                </c:pt>
                <c:pt idx="326">
                  <c:v>-0.4</c:v>
                </c:pt>
                <c:pt idx="327">
                  <c:v>-0.2</c:v>
                </c:pt>
                <c:pt idx="328">
                  <c:v>0.6</c:v>
                </c:pt>
                <c:pt idx="329">
                  <c:v>-0.1</c:v>
                </c:pt>
                <c:pt idx="330">
                  <c:v>-0.7</c:v>
                </c:pt>
                <c:pt idx="331">
                  <c:v>-0.4</c:v>
                </c:pt>
                <c:pt idx="332">
                  <c:v>-0.3</c:v>
                </c:pt>
                <c:pt idx="333">
                  <c:v>-0.1</c:v>
                </c:pt>
                <c:pt idx="334">
                  <c:v>-0.1</c:v>
                </c:pt>
                <c:pt idx="335">
                  <c:v>-0.3</c:v>
                </c:pt>
                <c:pt idx="336">
                  <c:v>-1</c:v>
                </c:pt>
                <c:pt idx="337">
                  <c:v>-0.6</c:v>
                </c:pt>
                <c:pt idx="338">
                  <c:v>-0.3</c:v>
                </c:pt>
                <c:pt idx="339">
                  <c:v>0</c:v>
                </c:pt>
                <c:pt idx="340">
                  <c:v>-0.7</c:v>
                </c:pt>
                <c:pt idx="341">
                  <c:v>-0.5</c:v>
                </c:pt>
                <c:pt idx="342">
                  <c:v>-0.6</c:v>
                </c:pt>
                <c:pt idx="343">
                  <c:v>-0.8</c:v>
                </c:pt>
                <c:pt idx="344">
                  <c:v>0.7</c:v>
                </c:pt>
                <c:pt idx="345">
                  <c:v>-0.7</c:v>
                </c:pt>
                <c:pt idx="346">
                  <c:v>-0.7</c:v>
                </c:pt>
                <c:pt idx="347">
                  <c:v>-0.9</c:v>
                </c:pt>
                <c:pt idx="348">
                  <c:v>0</c:v>
                </c:pt>
                <c:pt idx="349">
                  <c:v>-0.6</c:v>
                </c:pt>
                <c:pt idx="350">
                  <c:v>-0.6</c:v>
                </c:pt>
                <c:pt idx="351">
                  <c:v>1.4</c:v>
                </c:pt>
                <c:pt idx="352">
                  <c:v>-0.4</c:v>
                </c:pt>
                <c:pt idx="353">
                  <c:v>-0.2</c:v>
                </c:pt>
                <c:pt idx="354">
                  <c:v>-1.1000000000000001</c:v>
                </c:pt>
                <c:pt idx="355">
                  <c:v>-0.5</c:v>
                </c:pt>
                <c:pt idx="356">
                  <c:v>-1</c:v>
                </c:pt>
                <c:pt idx="357">
                  <c:v>1.3</c:v>
                </c:pt>
                <c:pt idx="358">
                  <c:v>-0.4</c:v>
                </c:pt>
                <c:pt idx="359">
                  <c:v>-2.1</c:v>
                </c:pt>
                <c:pt idx="360">
                  <c:v>-0.3</c:v>
                </c:pt>
                <c:pt idx="361">
                  <c:v>-0.2</c:v>
                </c:pt>
                <c:pt idx="362">
                  <c:v>-0.2</c:v>
                </c:pt>
                <c:pt idx="363">
                  <c:v>-0.2</c:v>
                </c:pt>
                <c:pt idx="364">
                  <c:v>-0.2</c:v>
                </c:pt>
                <c:pt idx="365">
                  <c:v>-0.3</c:v>
                </c:pt>
                <c:pt idx="366">
                  <c:v>-0.1</c:v>
                </c:pt>
                <c:pt idx="367">
                  <c:v>-0.2</c:v>
                </c:pt>
                <c:pt idx="368">
                  <c:v>-0.3</c:v>
                </c:pt>
                <c:pt idx="369">
                  <c:v>-0.3</c:v>
                </c:pt>
                <c:pt idx="370">
                  <c:v>-0.4</c:v>
                </c:pt>
                <c:pt idx="371">
                  <c:v>-0.3</c:v>
                </c:pt>
                <c:pt idx="372">
                  <c:v>1.1000000000000001</c:v>
                </c:pt>
                <c:pt idx="373">
                  <c:v>-0.5</c:v>
                </c:pt>
                <c:pt idx="374">
                  <c:v>-0.2</c:v>
                </c:pt>
                <c:pt idx="375">
                  <c:v>-0.2</c:v>
                </c:pt>
                <c:pt idx="376">
                  <c:v>-0.6</c:v>
                </c:pt>
                <c:pt idx="377">
                  <c:v>-0.4</c:v>
                </c:pt>
                <c:pt idx="378">
                  <c:v>-0.3</c:v>
                </c:pt>
                <c:pt idx="379">
                  <c:v>-0.3</c:v>
                </c:pt>
                <c:pt idx="380">
                  <c:v>-0.4</c:v>
                </c:pt>
                <c:pt idx="381">
                  <c:v>-0.4</c:v>
                </c:pt>
                <c:pt idx="382">
                  <c:v>-0.3</c:v>
                </c:pt>
                <c:pt idx="383">
                  <c:v>-0.7</c:v>
                </c:pt>
                <c:pt idx="384">
                  <c:v>-0.5</c:v>
                </c:pt>
                <c:pt idx="385">
                  <c:v>-0.4</c:v>
                </c:pt>
                <c:pt idx="386">
                  <c:v>-0.4</c:v>
                </c:pt>
                <c:pt idx="387">
                  <c:v>-0.7</c:v>
                </c:pt>
                <c:pt idx="388">
                  <c:v>0.4</c:v>
                </c:pt>
                <c:pt idx="389">
                  <c:v>-0.6</c:v>
                </c:pt>
                <c:pt idx="390">
                  <c:v>-0.1</c:v>
                </c:pt>
                <c:pt idx="391">
                  <c:v>-0.4</c:v>
                </c:pt>
                <c:pt idx="392">
                  <c:v>-0.4</c:v>
                </c:pt>
                <c:pt idx="393">
                  <c:v>-1.1000000000000001</c:v>
                </c:pt>
                <c:pt idx="394">
                  <c:v>-0.3</c:v>
                </c:pt>
                <c:pt idx="395">
                  <c:v>-0.7</c:v>
                </c:pt>
                <c:pt idx="396">
                  <c:v>-0.3</c:v>
                </c:pt>
                <c:pt idx="397">
                  <c:v>-0.5</c:v>
                </c:pt>
                <c:pt idx="398">
                  <c:v>-0.4</c:v>
                </c:pt>
                <c:pt idx="399">
                  <c:v>-0.5</c:v>
                </c:pt>
                <c:pt idx="400">
                  <c:v>0</c:v>
                </c:pt>
                <c:pt idx="401">
                  <c:v>0.2</c:v>
                </c:pt>
                <c:pt idx="402">
                  <c:v>-0.6</c:v>
                </c:pt>
                <c:pt idx="403">
                  <c:v>-0.1</c:v>
                </c:pt>
                <c:pt idx="404">
                  <c:v>0</c:v>
                </c:pt>
                <c:pt idx="405">
                  <c:v>0</c:v>
                </c:pt>
                <c:pt idx="406">
                  <c:v>0</c:v>
                </c:pt>
                <c:pt idx="407">
                  <c:v>0</c:v>
                </c:pt>
                <c:pt idx="408">
                  <c:v>-0.1</c:v>
                </c:pt>
                <c:pt idx="409">
                  <c:v>-0.6</c:v>
                </c:pt>
                <c:pt idx="410">
                  <c:v>-0.4</c:v>
                </c:pt>
                <c:pt idx="411">
                  <c:v>-1.2</c:v>
                </c:pt>
                <c:pt idx="412">
                  <c:v>-0.2</c:v>
                </c:pt>
                <c:pt idx="413">
                  <c:v>-1</c:v>
                </c:pt>
                <c:pt idx="414">
                  <c:v>0</c:v>
                </c:pt>
                <c:pt idx="415">
                  <c:v>-0.2</c:v>
                </c:pt>
                <c:pt idx="416">
                  <c:v>0</c:v>
                </c:pt>
                <c:pt idx="417">
                  <c:v>-0.1</c:v>
                </c:pt>
                <c:pt idx="418">
                  <c:v>0.1</c:v>
                </c:pt>
                <c:pt idx="419">
                  <c:v>-0.2</c:v>
                </c:pt>
                <c:pt idx="420">
                  <c:v>-0.1</c:v>
                </c:pt>
                <c:pt idx="421">
                  <c:v>-0.1</c:v>
                </c:pt>
                <c:pt idx="422">
                  <c:v>-0.1</c:v>
                </c:pt>
                <c:pt idx="423">
                  <c:v>-0.1</c:v>
                </c:pt>
                <c:pt idx="424">
                  <c:v>-0.1</c:v>
                </c:pt>
                <c:pt idx="425">
                  <c:v>-0.2</c:v>
                </c:pt>
                <c:pt idx="426">
                  <c:v>-0.2</c:v>
                </c:pt>
                <c:pt idx="427">
                  <c:v>-0.2</c:v>
                </c:pt>
                <c:pt idx="428">
                  <c:v>-0.2</c:v>
                </c:pt>
                <c:pt idx="429">
                  <c:v>-0.1</c:v>
                </c:pt>
                <c:pt idx="430">
                  <c:v>-0.4</c:v>
                </c:pt>
                <c:pt idx="431">
                  <c:v>-0.4</c:v>
                </c:pt>
                <c:pt idx="432">
                  <c:v>-0.4</c:v>
                </c:pt>
                <c:pt idx="433">
                  <c:v>1</c:v>
                </c:pt>
                <c:pt idx="434">
                  <c:v>-0.5</c:v>
                </c:pt>
                <c:pt idx="435">
                  <c:v>-0.3</c:v>
                </c:pt>
                <c:pt idx="436">
                  <c:v>-1.2</c:v>
                </c:pt>
                <c:pt idx="437">
                  <c:v>-0.6</c:v>
                </c:pt>
                <c:pt idx="438">
                  <c:v>-0.4</c:v>
                </c:pt>
                <c:pt idx="439">
                  <c:v>-0.3</c:v>
                </c:pt>
                <c:pt idx="440">
                  <c:v>-0.9</c:v>
                </c:pt>
                <c:pt idx="441">
                  <c:v>-0.8</c:v>
                </c:pt>
                <c:pt idx="442">
                  <c:v>-1.1000000000000001</c:v>
                </c:pt>
                <c:pt idx="443">
                  <c:v>-0.3</c:v>
                </c:pt>
                <c:pt idx="444">
                  <c:v>-2</c:v>
                </c:pt>
                <c:pt idx="445">
                  <c:v>-0.6</c:v>
                </c:pt>
                <c:pt idx="446">
                  <c:v>-0.3</c:v>
                </c:pt>
                <c:pt idx="447">
                  <c:v>-0.5</c:v>
                </c:pt>
                <c:pt idx="448">
                  <c:v>-0.9</c:v>
                </c:pt>
                <c:pt idx="449">
                  <c:v>0</c:v>
                </c:pt>
                <c:pt idx="450">
                  <c:v>0.1</c:v>
                </c:pt>
                <c:pt idx="451">
                  <c:v>0</c:v>
                </c:pt>
                <c:pt idx="452">
                  <c:v>0</c:v>
                </c:pt>
                <c:pt idx="453">
                  <c:v>-0.1</c:v>
                </c:pt>
                <c:pt idx="454">
                  <c:v>-0.2</c:v>
                </c:pt>
                <c:pt idx="455">
                  <c:v>-0.1</c:v>
                </c:pt>
                <c:pt idx="456">
                  <c:v>0</c:v>
                </c:pt>
                <c:pt idx="457">
                  <c:v>0</c:v>
                </c:pt>
                <c:pt idx="458">
                  <c:v>0.1</c:v>
                </c:pt>
                <c:pt idx="459">
                  <c:v>-0.1</c:v>
                </c:pt>
                <c:pt idx="460">
                  <c:v>0</c:v>
                </c:pt>
                <c:pt idx="461">
                  <c:v>-0.1</c:v>
                </c:pt>
                <c:pt idx="462">
                  <c:v>-0.2</c:v>
                </c:pt>
                <c:pt idx="463">
                  <c:v>-0.1</c:v>
                </c:pt>
                <c:pt idx="464">
                  <c:v>-0.3</c:v>
                </c:pt>
                <c:pt idx="465">
                  <c:v>-0.3</c:v>
                </c:pt>
                <c:pt idx="466">
                  <c:v>-0.1</c:v>
                </c:pt>
                <c:pt idx="467">
                  <c:v>-0.3</c:v>
                </c:pt>
                <c:pt idx="468">
                  <c:v>-0.5</c:v>
                </c:pt>
                <c:pt idx="469">
                  <c:v>-0.3</c:v>
                </c:pt>
                <c:pt idx="470">
                  <c:v>-0.3</c:v>
                </c:pt>
                <c:pt idx="471">
                  <c:v>-0.1</c:v>
                </c:pt>
                <c:pt idx="472">
                  <c:v>-0.1</c:v>
                </c:pt>
                <c:pt idx="473">
                  <c:v>-0.1</c:v>
                </c:pt>
                <c:pt idx="474">
                  <c:v>-0.3</c:v>
                </c:pt>
                <c:pt idx="475">
                  <c:v>-0.3</c:v>
                </c:pt>
                <c:pt idx="476">
                  <c:v>-0.4</c:v>
                </c:pt>
                <c:pt idx="477">
                  <c:v>-0.7</c:v>
                </c:pt>
                <c:pt idx="478">
                  <c:v>0.2</c:v>
                </c:pt>
                <c:pt idx="479">
                  <c:v>-0.4</c:v>
                </c:pt>
                <c:pt idx="480">
                  <c:v>-1.8</c:v>
                </c:pt>
                <c:pt idx="481">
                  <c:v>-1.3</c:v>
                </c:pt>
                <c:pt idx="482">
                  <c:v>-0.8</c:v>
                </c:pt>
                <c:pt idx="483">
                  <c:v>-0.4</c:v>
                </c:pt>
                <c:pt idx="484">
                  <c:v>-0.4</c:v>
                </c:pt>
                <c:pt idx="485">
                  <c:v>-0.7</c:v>
                </c:pt>
                <c:pt idx="486">
                  <c:v>-0.5</c:v>
                </c:pt>
                <c:pt idx="487">
                  <c:v>-0.2</c:v>
                </c:pt>
                <c:pt idx="488">
                  <c:v>-0.3</c:v>
                </c:pt>
                <c:pt idx="489">
                  <c:v>-0.6</c:v>
                </c:pt>
                <c:pt idx="490">
                  <c:v>-0.4</c:v>
                </c:pt>
                <c:pt idx="491">
                  <c:v>-0.5</c:v>
                </c:pt>
                <c:pt idx="492">
                  <c:v>-1</c:v>
                </c:pt>
                <c:pt idx="493">
                  <c:v>-0.6</c:v>
                </c:pt>
                <c:pt idx="494">
                  <c:v>-0.7</c:v>
                </c:pt>
                <c:pt idx="495">
                  <c:v>-0.2</c:v>
                </c:pt>
                <c:pt idx="496">
                  <c:v>-0.8</c:v>
                </c:pt>
                <c:pt idx="497">
                  <c:v>0</c:v>
                </c:pt>
                <c:pt idx="498">
                  <c:v>-1</c:v>
                </c:pt>
                <c:pt idx="499">
                  <c:v>-0.3</c:v>
                </c:pt>
                <c:pt idx="500">
                  <c:v>0</c:v>
                </c:pt>
                <c:pt idx="501">
                  <c:v>-0.5</c:v>
                </c:pt>
                <c:pt idx="502">
                  <c:v>-0.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57B2-416E-9C1C-CDB0E4BCEA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68576408"/>
        <c:axId val="668570528"/>
      </c:scatterChart>
      <c:valAx>
        <c:axId val="668576408"/>
        <c:scaling>
          <c:logBase val="10"/>
          <c:orientation val="minMax"/>
          <c:min val="1000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65000"/>
                  <a:lumOff val="35000"/>
                  <a:alpha val="7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lt1">
                        <a:lumMod val="7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Abundanc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lt1">
                      <a:lumMod val="7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E+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lt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lt1">
                    <a:lumMod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68570528"/>
        <c:crosses val="autoZero"/>
        <c:crossBetween val="midCat"/>
      </c:valAx>
      <c:valAx>
        <c:axId val="668570528"/>
        <c:scaling>
          <c:orientation val="minMax"/>
          <c:max val="5"/>
          <c:min val="-5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65000"/>
                  <a:lumOff val="35000"/>
                  <a:alpha val="7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lt1">
                        <a:lumMod val="7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ppm</a:t>
                </a:r>
                <a:r>
                  <a:rPr lang="en-US" sz="12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error</a:t>
                </a:r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lt1">
                      <a:lumMod val="7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lt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lt1">
                    <a:lumMod val="7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685764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dk1">
        <a:lumMod val="75000"/>
        <a:lumOff val="25000"/>
      </a:schemeClr>
    </a:soli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5">
  <cs:axisTitle>
    <cs:lnRef idx="0"/>
    <cs:fillRef idx="0"/>
    <cs:effectRef idx="0"/>
    <cs:fontRef idx="minor">
      <a:schemeClr val="lt1">
        <a:lumMod val="75000"/>
      </a:schemeClr>
    </cs:fontRef>
    <cs:defRPr sz="900" b="1" kern="1200"/>
  </cs:axisTitle>
  <cs:categoryAxis>
    <cs:lnRef idx="0"/>
    <cs:fillRef idx="0"/>
    <cs:effectRef idx="0"/>
    <cs:fontRef idx="minor">
      <a:schemeClr val="lt1">
        <a:lumMod val="75000"/>
      </a:schemeClr>
    </cs:fontRef>
    <cs:defRPr sz="900" kern="1200"/>
  </cs:categoryAxis>
  <cs:chartArea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>
        <a:lumMod val="75000"/>
      </a:schemeClr>
    </cs:fontRef>
    <cs:defRPr sz="900" kern="1200"/>
  </cs:dataLabel>
  <cs:dataLabelCallout>
    <cs:lnRef idx="0"/>
    <cs:fillRef idx="0"/>
    <cs:effectRef idx="0"/>
    <cs:fontRef idx="minor">
      <a:schemeClr val="lt1">
        <a:lumMod val="15000"/>
        <a:lumOff val="85000"/>
      </a:schemeClr>
    </cs:fontRef>
    <cs:spPr>
      <a:solidFill>
        <a:schemeClr val="dk1">
          <a:lumMod val="65000"/>
          <a:lumOff val="3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/>
    <cs:effectRef idx="0">
      <cs:styleClr val="auto"/>
    </cs:effectRef>
    <cs:fontRef idx="minor">
      <a:schemeClr val="dk1"/>
    </cs:fontRef>
    <cs:spPr>
      <a:ln w="9525" cap="flat" cmpd="sng" algn="ctr">
        <a:solidFill>
          <a:schemeClr val="phClr"/>
        </a:solidFill>
        <a:miter lim="800000"/>
      </a:ln>
      <a:effectLst>
        <a:glow rad="63500">
          <a:schemeClr val="phClr">
            <a:satMod val="175000"/>
            <a:alpha val="25000"/>
          </a:schemeClr>
        </a:glow>
      </a:effectLst>
    </cs:spPr>
  </cs:dataPoint>
  <cs:dataPoint3D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ln w="9525" cap="flat" cmpd="sng" algn="ctr">
        <a:solidFill>
          <a:schemeClr val="phClr"/>
        </a:solidFill>
        <a:miter lim="800000"/>
      </a:ln>
      <a:effectLst>
        <a:glow rad="63500">
          <a:schemeClr val="phClr">
            <a:satMod val="175000"/>
            <a:alpha val="25000"/>
          </a:schemeClr>
        </a:glow>
      </a:effectLst>
    </cs:spPr>
  </cs:dataPoint3D>
  <cs:dataPointLine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ln w="22225" cap="rnd">
        <a:solidFill>
          <a:schemeClr val="phClr"/>
        </a:solidFill>
      </a:ln>
      <a:effectLst>
        <a:glow rad="139700">
          <a:schemeClr val="phClr">
            <a:satMod val="175000"/>
            <a:alpha val="14000"/>
          </a:schemeClr>
        </a:glow>
      </a:effectLst>
    </cs:spPr>
  </cs:dataPointLine>
  <cs:dataPointMarker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solidFill>
        <a:schemeClr val="phClr">
          <a:lumMod val="60000"/>
          <a:lumOff val="40000"/>
        </a:schemeClr>
      </a:solidFill>
      <a:effectLst>
        <a:glow rad="63500">
          <a:schemeClr val="phClr">
            <a:satMod val="175000"/>
            <a:alpha val="25000"/>
          </a:schemeClr>
        </a:glow>
      </a:effectLst>
    </cs:spPr>
  </cs:dataPointMarker>
  <cs:dataPointMarkerLayout symbol="circle" size="3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lt1">
        <a:lumMod val="75000"/>
      </a:schemeClr>
    </cs:fontRef>
    <cs:spPr>
      <a:ln w="9525">
        <a:solidFill>
          <a:schemeClr val="dk1">
            <a:lumMod val="50000"/>
            <a:lumOff val="50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lt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7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65000"/>
            <a:lumOff val="35000"/>
            <a:alpha val="7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65000"/>
            <a:lumOff val="35000"/>
            <a:alpha val="2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leaderLine>
  <cs:legend>
    <cs:lnRef idx="0"/>
    <cs:fillRef idx="0"/>
    <cs:effectRef idx="0"/>
    <cs:fontRef idx="minor">
      <a:schemeClr val="lt1">
        <a:lumMod val="75000"/>
      </a:schemeClr>
    </cs:fontRef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lt1">
        <a:lumMod val="7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seriesLine>
  <cs:title>
    <cs:lnRef idx="0"/>
    <cs:fillRef idx="0"/>
    <cs:effectRef idx="0"/>
    <cs:fontRef idx="minor">
      <a:schemeClr val="lt1">
        <a:lumMod val="85000"/>
      </a:schemeClr>
    </cs:fontRef>
    <cs:defRPr sz="1400" b="1" kern="1200" cap="none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25400" cap="rnd">
        <a:solidFill>
          <a:schemeClr val="phClr">
            <a:alpha val="50000"/>
          </a:schemeClr>
        </a:solidFill>
      </a:ln>
    </cs:spPr>
  </cs:trendline>
  <cs:trendlineLabel>
    <cs:lnRef idx="0"/>
    <cs:fillRef idx="0"/>
    <cs:effectRef idx="0"/>
    <cs:fontRef idx="minor">
      <a:schemeClr val="lt1">
        <a:lumMod val="7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>
          <a:lumMod val="85000"/>
        </a:schemeClr>
      </a:solidFill>
      <a:ln w="9525">
        <a:solidFill>
          <a:schemeClr val="dk1">
            <a:lumMod val="50000"/>
          </a:schemeClr>
        </a:solidFill>
        <a:round/>
      </a:ln>
    </cs:spPr>
  </cs:upBar>
  <cs:valueAxis>
    <cs:lnRef idx="0"/>
    <cs:fillRef idx="0"/>
    <cs:effectRef idx="0"/>
    <cs:fontRef idx="minor">
      <a:schemeClr val="lt1">
        <a:lumMod val="75000"/>
      </a:schemeClr>
    </cs:fontRef>
    <cs:spPr>
      <a:ln w="9525" cap="flat" cmpd="sng" algn="ctr">
        <a:solidFill>
          <a:schemeClr val="lt1">
            <a:lumMod val="50000"/>
          </a:schemeClr>
        </a:solidFill>
        <a:round/>
      </a:ln>
    </cs:spPr>
    <cs:defRPr sz="900" kern="1200"/>
    <cs:bodyPr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45">
  <cs:axisTitle>
    <cs:lnRef idx="0"/>
    <cs:fillRef idx="0"/>
    <cs:effectRef idx="0"/>
    <cs:fontRef idx="minor">
      <a:schemeClr val="lt1">
        <a:lumMod val="75000"/>
      </a:schemeClr>
    </cs:fontRef>
    <cs:defRPr sz="900" b="1" kern="1200"/>
  </cs:axisTitle>
  <cs:categoryAxis>
    <cs:lnRef idx="0"/>
    <cs:fillRef idx="0"/>
    <cs:effectRef idx="0"/>
    <cs:fontRef idx="minor">
      <a:schemeClr val="lt1">
        <a:lumMod val="75000"/>
      </a:schemeClr>
    </cs:fontRef>
    <cs:defRPr sz="900" kern="1200"/>
  </cs:categoryAxis>
  <cs:chartArea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>
        <a:lumMod val="75000"/>
      </a:schemeClr>
    </cs:fontRef>
    <cs:defRPr sz="900" kern="1200"/>
  </cs:dataLabel>
  <cs:dataLabelCallout>
    <cs:lnRef idx="0"/>
    <cs:fillRef idx="0"/>
    <cs:effectRef idx="0"/>
    <cs:fontRef idx="minor">
      <a:schemeClr val="lt1">
        <a:lumMod val="15000"/>
        <a:lumOff val="85000"/>
      </a:schemeClr>
    </cs:fontRef>
    <cs:spPr>
      <a:solidFill>
        <a:schemeClr val="dk1">
          <a:lumMod val="65000"/>
          <a:lumOff val="3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/>
    <cs:effectRef idx="0">
      <cs:styleClr val="auto"/>
    </cs:effectRef>
    <cs:fontRef idx="minor">
      <a:schemeClr val="dk1"/>
    </cs:fontRef>
    <cs:spPr>
      <a:ln w="9525" cap="flat" cmpd="sng" algn="ctr">
        <a:solidFill>
          <a:schemeClr val="phClr"/>
        </a:solidFill>
        <a:miter lim="800000"/>
      </a:ln>
      <a:effectLst>
        <a:glow rad="63500">
          <a:schemeClr val="phClr">
            <a:satMod val="175000"/>
            <a:alpha val="25000"/>
          </a:schemeClr>
        </a:glow>
      </a:effectLst>
    </cs:spPr>
  </cs:dataPoint>
  <cs:dataPoint3D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ln w="9525" cap="flat" cmpd="sng" algn="ctr">
        <a:solidFill>
          <a:schemeClr val="phClr"/>
        </a:solidFill>
        <a:miter lim="800000"/>
      </a:ln>
      <a:effectLst>
        <a:glow rad="63500">
          <a:schemeClr val="phClr">
            <a:satMod val="175000"/>
            <a:alpha val="25000"/>
          </a:schemeClr>
        </a:glow>
      </a:effectLst>
    </cs:spPr>
  </cs:dataPoint3D>
  <cs:dataPointLine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ln w="22225" cap="rnd">
        <a:solidFill>
          <a:schemeClr val="phClr"/>
        </a:solidFill>
      </a:ln>
      <a:effectLst>
        <a:glow rad="139700">
          <a:schemeClr val="phClr">
            <a:satMod val="175000"/>
            <a:alpha val="14000"/>
          </a:schemeClr>
        </a:glow>
      </a:effectLst>
    </cs:spPr>
  </cs:dataPointLine>
  <cs:dataPointMarker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solidFill>
        <a:schemeClr val="phClr">
          <a:lumMod val="60000"/>
          <a:lumOff val="40000"/>
        </a:schemeClr>
      </a:solidFill>
      <a:effectLst>
        <a:glow rad="63500">
          <a:schemeClr val="phClr">
            <a:satMod val="175000"/>
            <a:alpha val="25000"/>
          </a:schemeClr>
        </a:glow>
      </a:effectLst>
    </cs:spPr>
  </cs:dataPointMarker>
  <cs:dataPointMarkerLayout symbol="circle" size="3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lt1">
        <a:lumMod val="75000"/>
      </a:schemeClr>
    </cs:fontRef>
    <cs:spPr>
      <a:ln w="9525">
        <a:solidFill>
          <a:schemeClr val="dk1">
            <a:lumMod val="50000"/>
            <a:lumOff val="50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lt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7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65000"/>
            <a:lumOff val="35000"/>
            <a:alpha val="7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dk1">
            <a:lumMod val="65000"/>
            <a:lumOff val="35000"/>
            <a:alpha val="2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leaderLine>
  <cs:legend>
    <cs:lnRef idx="0"/>
    <cs:fillRef idx="0"/>
    <cs:effectRef idx="0"/>
    <cs:fontRef idx="minor">
      <a:schemeClr val="lt1">
        <a:lumMod val="75000"/>
      </a:schemeClr>
    </cs:fontRef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lt1">
        <a:lumMod val="7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lt1">
            <a:lumMod val="50000"/>
          </a:schemeClr>
        </a:solidFill>
        <a:round/>
      </a:ln>
    </cs:spPr>
  </cs:seriesLine>
  <cs:title>
    <cs:lnRef idx="0"/>
    <cs:fillRef idx="0"/>
    <cs:effectRef idx="0"/>
    <cs:fontRef idx="minor">
      <a:schemeClr val="lt1">
        <a:lumMod val="85000"/>
      </a:schemeClr>
    </cs:fontRef>
    <cs:defRPr sz="1400" b="1" kern="1200" cap="none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25400" cap="rnd">
        <a:solidFill>
          <a:schemeClr val="phClr">
            <a:alpha val="50000"/>
          </a:schemeClr>
        </a:solidFill>
      </a:ln>
    </cs:spPr>
  </cs:trendline>
  <cs:trendlineLabel>
    <cs:lnRef idx="0"/>
    <cs:fillRef idx="0"/>
    <cs:effectRef idx="0"/>
    <cs:fontRef idx="minor">
      <a:schemeClr val="lt1">
        <a:lumMod val="7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>
          <a:lumMod val="85000"/>
        </a:schemeClr>
      </a:solidFill>
      <a:ln w="9525">
        <a:solidFill>
          <a:schemeClr val="dk1">
            <a:lumMod val="50000"/>
          </a:schemeClr>
        </a:solidFill>
        <a:round/>
      </a:ln>
    </cs:spPr>
  </cs:upBar>
  <cs:valueAxis>
    <cs:lnRef idx="0"/>
    <cs:fillRef idx="0"/>
    <cs:effectRef idx="0"/>
    <cs:fontRef idx="minor">
      <a:schemeClr val="lt1">
        <a:lumMod val="75000"/>
      </a:schemeClr>
    </cs:fontRef>
    <cs:spPr>
      <a:ln w="9525" cap="flat" cmpd="sng" algn="ctr">
        <a:solidFill>
          <a:schemeClr val="lt1">
            <a:lumMod val="50000"/>
          </a:schemeClr>
        </a:solidFill>
        <a:round/>
      </a:ln>
    </cs:spPr>
    <cs:defRPr sz="900" kern="1200"/>
    <cs:bodyPr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275" y="0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6BDA8F-9BD9-49C0-AF26-6EAFE203CF6C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30425" y="1163638"/>
            <a:ext cx="2762250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9925"/>
            <a:ext cx="5619750" cy="36655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375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275" y="8842375"/>
            <a:ext cx="3043238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5AC5D2-9C5D-4058-ACD4-7D44D2A0A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9185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166530"/>
            <a:ext cx="5324634" cy="2481556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3743785"/>
            <a:ext cx="4698206" cy="1720919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832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595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379493"/>
            <a:ext cx="1350734" cy="604054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379493"/>
            <a:ext cx="3973899" cy="604054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822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713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1777021"/>
            <a:ext cx="5402937" cy="2964997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4770068"/>
            <a:ext cx="5402937" cy="1559222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934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1897467"/>
            <a:ext cx="2662317" cy="45225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1897467"/>
            <a:ext cx="2662317" cy="452257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24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379495"/>
            <a:ext cx="5402937" cy="13777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1747320"/>
            <a:ext cx="2650082" cy="856334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2603655"/>
            <a:ext cx="2650082" cy="38295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1747320"/>
            <a:ext cx="2663133" cy="856334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2603655"/>
            <a:ext cx="2663133" cy="38295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955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038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347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75192"/>
            <a:ext cx="2020392" cy="166317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026284"/>
            <a:ext cx="3171289" cy="5065411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138363"/>
            <a:ext cx="2020392" cy="3961581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625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75192"/>
            <a:ext cx="2020392" cy="166317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026284"/>
            <a:ext cx="3171289" cy="5065411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138363"/>
            <a:ext cx="2020392" cy="3961581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955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379495"/>
            <a:ext cx="5402937" cy="13777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1897467"/>
            <a:ext cx="5402937" cy="45225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6606486"/>
            <a:ext cx="1409462" cy="37949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6B422C-AAB2-4072-85A0-4E98C28B89C7}" type="datetimeFigureOut">
              <a:rPr lang="en-US" smtClean="0"/>
              <a:t>7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6606486"/>
            <a:ext cx="2114193" cy="37949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6606486"/>
            <a:ext cx="1409462" cy="37949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FD98BA-BB72-409B-B9A4-043FCC7BF1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851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emf"/><Relationship Id="rId4" Type="http://schemas.openxmlformats.org/officeDocument/2006/relationships/image" Target="../media/image17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3" Type="http://schemas.openxmlformats.org/officeDocument/2006/relationships/image" Target="../media/image2.png"/><Relationship Id="rId7" Type="http://schemas.openxmlformats.org/officeDocument/2006/relationships/image" Target="../media/image39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Relationship Id="rId9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0" y="148856"/>
            <a:ext cx="6264274" cy="1973858"/>
          </a:xfrm>
        </p:spPr>
        <p:txBody>
          <a:bodyPr>
            <a:normAutofit/>
          </a:bodyPr>
          <a:lstStyle/>
          <a:p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s </a:t>
            </a:r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and Tables </a:t>
            </a:r>
            <a:b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200" b="1" dirty="0">
                <a:latin typeface="Arial" panose="020B0604020202020204" pitchFamily="34" charset="0"/>
                <a:cs typeface="Arial" panose="020B0604020202020204" pitchFamily="34" charset="0"/>
              </a:rPr>
              <a:t>Lipid Annotator: a Rapid, Accurate, and User-Friendly Software for Comprehensive LC-HRMS/MS Lipidomics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ubtitle 3"/>
          <p:cNvSpPr>
            <a:spLocks noGrp="1"/>
          </p:cNvSpPr>
          <p:nvPr>
            <p:ph type="subTitle" idx="1"/>
          </p:nvPr>
        </p:nvSpPr>
        <p:spPr>
          <a:xfrm>
            <a:off x="70472" y="2158738"/>
            <a:ext cx="6076347" cy="4679384"/>
          </a:xfrm>
        </p:spPr>
        <p:txBody>
          <a:bodyPr>
            <a:normAutofit fontScale="92500" lnSpcReduction="20000"/>
          </a:bodyPr>
          <a:lstStyle/>
          <a:p>
            <a:r>
              <a:rPr lang="en-US" dirty="0"/>
              <a:t>Jeremy P. Koelmel</a:t>
            </a:r>
            <a:r>
              <a:rPr lang="en-US" baseline="30000" dirty="0"/>
              <a:t>*ǂ1,2</a:t>
            </a:r>
            <a:r>
              <a:rPr lang="en-US" dirty="0"/>
              <a:t>, </a:t>
            </a:r>
            <a:r>
              <a:rPr lang="en-US" dirty="0" err="1"/>
              <a:t>Xiangdong</a:t>
            </a:r>
            <a:r>
              <a:rPr lang="en-US" dirty="0"/>
              <a:t> Li</a:t>
            </a:r>
            <a:r>
              <a:rPr lang="en-US" baseline="30000" dirty="0"/>
              <a:t>ǂ3</a:t>
            </a:r>
            <a:r>
              <a:rPr lang="en-US" dirty="0"/>
              <a:t>, Sarah M. Stow</a:t>
            </a:r>
            <a:r>
              <a:rPr lang="en-US" baseline="30000" dirty="0"/>
              <a:t>3</a:t>
            </a:r>
            <a:r>
              <a:rPr lang="en-US" dirty="0"/>
              <a:t>, Mark Sartain</a:t>
            </a:r>
            <a:r>
              <a:rPr lang="en-US" baseline="30000" dirty="0"/>
              <a:t>3</a:t>
            </a:r>
            <a:r>
              <a:rPr lang="en-US" dirty="0"/>
              <a:t>, </a:t>
            </a:r>
            <a:r>
              <a:rPr lang="en-US" dirty="0" err="1"/>
              <a:t>Adithya</a:t>
            </a:r>
            <a:r>
              <a:rPr lang="en-US" dirty="0"/>
              <a:t> Murali</a:t>
            </a:r>
            <a:r>
              <a:rPr lang="en-US" baseline="30000" dirty="0"/>
              <a:t>3</a:t>
            </a:r>
            <a:r>
              <a:rPr lang="en-US" dirty="0"/>
              <a:t>, Robin Kemperman</a:t>
            </a:r>
            <a:r>
              <a:rPr lang="en-US" baseline="30000" dirty="0"/>
              <a:t>4</a:t>
            </a:r>
            <a:r>
              <a:rPr lang="en-US" dirty="0"/>
              <a:t>, Hiroshi Tsugawa</a:t>
            </a:r>
            <a:r>
              <a:rPr lang="en-US" baseline="30000" dirty="0"/>
              <a:t>5,6</a:t>
            </a:r>
            <a:r>
              <a:rPr lang="en-US" dirty="0"/>
              <a:t>, </a:t>
            </a:r>
            <a:r>
              <a:rPr lang="en-US" dirty="0" err="1"/>
              <a:t>Mikiko</a:t>
            </a:r>
            <a:r>
              <a:rPr lang="en-US" dirty="0"/>
              <a:t> Takahashi</a:t>
            </a:r>
            <a:r>
              <a:rPr lang="en-US" baseline="30000" dirty="0"/>
              <a:t>5</a:t>
            </a:r>
            <a:r>
              <a:rPr lang="en-US" dirty="0"/>
              <a:t>, Vasilis Vasiliou</a:t>
            </a:r>
            <a:r>
              <a:rPr lang="en-US" baseline="30000" dirty="0"/>
              <a:t>2</a:t>
            </a:r>
            <a:r>
              <a:rPr lang="en-US" dirty="0"/>
              <a:t>, John A. Bowden</a:t>
            </a:r>
            <a:r>
              <a:rPr lang="en-US" baseline="30000" dirty="0"/>
              <a:t>4,7</a:t>
            </a:r>
            <a:r>
              <a:rPr lang="en-US" dirty="0"/>
              <a:t>, Richard A. Yost</a:t>
            </a:r>
            <a:r>
              <a:rPr lang="en-US" baseline="30000" dirty="0"/>
              <a:t>1,4</a:t>
            </a:r>
            <a:r>
              <a:rPr lang="en-US" dirty="0"/>
              <a:t>, Timothy J. Garrett</a:t>
            </a:r>
            <a:r>
              <a:rPr lang="en-US" baseline="30000" dirty="0"/>
              <a:t>1,4</a:t>
            </a:r>
            <a:r>
              <a:rPr lang="en-US" dirty="0"/>
              <a:t>, Norton Kitagawa</a:t>
            </a:r>
            <a:r>
              <a:rPr lang="en-US" baseline="30000" dirty="0"/>
              <a:t>3</a:t>
            </a:r>
            <a:endParaRPr lang="en-US" dirty="0"/>
          </a:p>
          <a:p>
            <a:r>
              <a:rPr lang="en-US" dirty="0"/>
              <a:t> </a:t>
            </a:r>
          </a:p>
          <a:p>
            <a:r>
              <a:rPr lang="en-US" baseline="30000" dirty="0" err="1"/>
              <a:t>ǂ</a:t>
            </a:r>
            <a:r>
              <a:rPr lang="en-US" dirty="0" err="1"/>
              <a:t>These</a:t>
            </a:r>
            <a:r>
              <a:rPr lang="en-US" dirty="0"/>
              <a:t> authors contributed equally</a:t>
            </a:r>
          </a:p>
          <a:p>
            <a:r>
              <a:rPr lang="en-US" dirty="0"/>
              <a:t>*Corresponding author</a:t>
            </a:r>
          </a:p>
          <a:p>
            <a:r>
              <a:rPr lang="en-US" dirty="0"/>
              <a:t> </a:t>
            </a:r>
          </a:p>
          <a:p>
            <a:r>
              <a:rPr lang="en-US" baseline="30000" dirty="0"/>
              <a:t>1</a:t>
            </a:r>
            <a:r>
              <a:rPr lang="en-US" dirty="0"/>
              <a:t>Department of Pathology, Immunology and Laboratory Medicine, University of Florida, Gainesville, FL</a:t>
            </a:r>
          </a:p>
          <a:p>
            <a:r>
              <a:rPr lang="en-US" baseline="30000" dirty="0"/>
              <a:t>2</a:t>
            </a:r>
            <a:r>
              <a:rPr lang="en-US" dirty="0"/>
              <a:t>Department of Environmental Health Sciences, Yale School of Public Health, New Haven, CT</a:t>
            </a:r>
          </a:p>
          <a:p>
            <a:r>
              <a:rPr lang="en-US" baseline="30000" dirty="0"/>
              <a:t>3</a:t>
            </a:r>
            <a:r>
              <a:rPr lang="en-US" dirty="0"/>
              <a:t>Agilent Technologies, Santa Clara, CA</a:t>
            </a:r>
          </a:p>
          <a:p>
            <a:r>
              <a:rPr lang="en-US" baseline="30000" dirty="0"/>
              <a:t>4</a:t>
            </a:r>
            <a:r>
              <a:rPr lang="en-US" dirty="0"/>
              <a:t>Department of Chemistry, University of Florida, Gainesville, FL</a:t>
            </a:r>
          </a:p>
          <a:p>
            <a:r>
              <a:rPr lang="en-US" baseline="30000" dirty="0"/>
              <a:t>5</a:t>
            </a:r>
            <a:r>
              <a:rPr lang="en-US" dirty="0"/>
              <a:t>RIKEN Center for Sustainable Resource Science, 1-7-22 </a:t>
            </a:r>
            <a:r>
              <a:rPr lang="en-US" dirty="0" err="1"/>
              <a:t>Suehiro-cho</a:t>
            </a:r>
            <a:r>
              <a:rPr lang="en-US" dirty="0"/>
              <a:t>, Tsurumi-</a:t>
            </a:r>
            <a:r>
              <a:rPr lang="en-US" dirty="0" err="1"/>
              <a:t>ku</a:t>
            </a:r>
            <a:r>
              <a:rPr lang="en-US" dirty="0"/>
              <a:t>, Yokohama, Kanagawa 230-0045, Japan</a:t>
            </a:r>
          </a:p>
          <a:p>
            <a:r>
              <a:rPr lang="en-US" baseline="30000" dirty="0"/>
              <a:t>6</a:t>
            </a:r>
            <a:r>
              <a:rPr lang="en-US" dirty="0"/>
              <a:t>RIKEN Center for Integrative Medical Sciences, 1-7-22 </a:t>
            </a:r>
            <a:r>
              <a:rPr lang="en-US" dirty="0" err="1"/>
              <a:t>Suehiro-cho</a:t>
            </a:r>
            <a:r>
              <a:rPr lang="en-US" dirty="0"/>
              <a:t>, Tsurumi-</a:t>
            </a:r>
            <a:r>
              <a:rPr lang="en-US" dirty="0" err="1"/>
              <a:t>ku</a:t>
            </a:r>
            <a:r>
              <a:rPr lang="en-US" dirty="0"/>
              <a:t>, Yokohama, Kanagawa 230-0045, Japan</a:t>
            </a:r>
          </a:p>
          <a:p>
            <a:r>
              <a:rPr lang="en-US" baseline="30000" dirty="0"/>
              <a:t>7</a:t>
            </a:r>
            <a:r>
              <a:rPr lang="en-US" dirty="0"/>
              <a:t>Center for Environmental and Human Toxicology &amp; Department of Physiological Sciences, University of Florida, Gainesville, FL</a:t>
            </a:r>
          </a:p>
          <a:p>
            <a:r>
              <a:rPr lang="en-US" dirty="0"/>
              <a:t/>
            </a:r>
            <a:br>
              <a:rPr lang="en-US" dirty="0"/>
            </a:br>
            <a:r>
              <a:rPr lang="en-US" dirty="0"/>
              <a:t> </a:t>
            </a:r>
          </a:p>
          <a:p>
            <a:pPr algn="l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4086688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3265714"/>
            <a:ext cx="62642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Supplemental Tables</a:t>
            </a:r>
          </a:p>
        </p:txBody>
      </p:sp>
    </p:spTree>
    <p:extLst>
      <p:ext uri="{BB962C8B-B14F-4D97-AF65-F5344CB8AC3E}">
        <p14:creationId xmlns:p14="http://schemas.microsoft.com/office/powerpoint/2010/main" val="39025856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="" xmlns:a16="http://schemas.microsoft.com/office/drawing/2014/main" id="{0B8A7803-3BB5-459A-9CAB-C7D84B33668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22604" y="581590"/>
          <a:ext cx="5937250" cy="3645408"/>
        </p:xfrm>
        <a:graphic>
          <a:graphicData uri="http://schemas.openxmlformats.org/drawingml/2006/table">
            <a:tbl>
              <a:tblPr firstRow="1" firstCol="1" bandRow="1"/>
              <a:tblGrid>
                <a:gridCol w="1482725">
                  <a:extLst>
                    <a:ext uri="{9D8B030D-6E8A-4147-A177-3AD203B41FA5}">
                      <a16:colId xmlns="" xmlns:a16="http://schemas.microsoft.com/office/drawing/2014/main" val="1800508573"/>
                    </a:ext>
                  </a:extLst>
                </a:gridCol>
                <a:gridCol w="2475230">
                  <a:extLst>
                    <a:ext uri="{9D8B030D-6E8A-4147-A177-3AD203B41FA5}">
                      <a16:colId xmlns="" xmlns:a16="http://schemas.microsoft.com/office/drawing/2014/main" val="2785813325"/>
                    </a:ext>
                  </a:extLst>
                </a:gridCol>
                <a:gridCol w="1979295">
                  <a:extLst>
                    <a:ext uri="{9D8B030D-6E8A-4147-A177-3AD203B41FA5}">
                      <a16:colId xmlns="" xmlns:a16="http://schemas.microsoft.com/office/drawing/2014/main" val="252122351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FFFFFF"/>
                          </a:solidFill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rameter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5D5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FFFFFF"/>
                          </a:solidFill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gilent 1290 Infinity II LC system:</a:t>
                      </a:r>
                    </a:p>
                    <a:p>
                      <a:pPr marL="171450" marR="0" indent="-17145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US" sz="800" b="1" dirty="0">
                          <a:solidFill>
                            <a:srgbClr val="FFFFFF"/>
                          </a:solidFill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90 Infinity I High Speed Pump (G7120A)</a:t>
                      </a:r>
                    </a:p>
                    <a:p>
                      <a:pPr marL="171450" marR="0" indent="-17145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US" sz="800" b="1" dirty="0">
                          <a:solidFill>
                            <a:srgbClr val="FFFFFF"/>
                          </a:solidFill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90 Infinity II </a:t>
                      </a:r>
                      <a:r>
                        <a:rPr lang="en-US" sz="800" b="1" dirty="0" err="1">
                          <a:solidFill>
                            <a:srgbClr val="FFFFFF"/>
                          </a:solidFill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ialsampler</a:t>
                      </a:r>
                      <a:r>
                        <a:rPr lang="en-US" sz="800" b="1" dirty="0">
                          <a:solidFill>
                            <a:srgbClr val="FFFFFF"/>
                          </a:solidFill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with thermostat (G7129B)</a:t>
                      </a:r>
                    </a:p>
                    <a:p>
                      <a:pPr marL="171450" marR="0" indent="-17145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Arial" panose="020B0604020202020204" pitchFamily="34" charset="0"/>
                        <a:buChar char="•"/>
                      </a:pPr>
                      <a:r>
                        <a:rPr lang="en-US" sz="800" b="1" dirty="0">
                          <a:solidFill>
                            <a:srgbClr val="FFFFFF"/>
                          </a:solidFill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90 </a:t>
                      </a:r>
                      <a:r>
                        <a:rPr lang="en-US" sz="800" b="1" dirty="0" err="1">
                          <a:solidFill>
                            <a:srgbClr val="FFFFFF"/>
                          </a:solidFill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ifnity</a:t>
                      </a:r>
                      <a:r>
                        <a:rPr lang="en-US" sz="800" b="1" dirty="0">
                          <a:solidFill>
                            <a:srgbClr val="FFFFFF"/>
                          </a:solidFill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II Multicolumn Thermostat (G7116B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5D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4291734822"/>
                  </a:ext>
                </a:extLst>
              </a:tr>
              <a:tr h="254635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alytical colum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uard colum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gilent </a:t>
                      </a:r>
                      <a:r>
                        <a:rPr lang="en-US" sz="800" dirty="0" err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finityLab</a:t>
                      </a: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dirty="0" err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roshell</a:t>
                      </a: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120 EC-C18, 3.0x100mm, 2.7µm, P/N 695975-302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gilent </a:t>
                      </a:r>
                      <a:r>
                        <a:rPr lang="en-US" sz="800" dirty="0" err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finityLab</a:t>
                      </a: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dirty="0" err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roshell</a:t>
                      </a: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120 EC-C18, 3.0x5mm, 2.7µm, P/N 823750-911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5920681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lumn temperatur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0 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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8555832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jection volum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 </a:t>
                      </a: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µ</a:t>
                      </a: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0848267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utosampler temperatur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0 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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831913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edle wash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 seconds in wash port (50:50 methanol/isopropanol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8917045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bile phas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 = 10mM ammonium acetate, 0.2mM ammonium fluoride in 9:1 water/methanol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 = 10mM ammonium acetate, 0.2mM ammonium fluoride in 2:3:5 acetonitrile/methanol/isopropanol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403729257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low rat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 mL/mi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3191799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radient program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im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5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.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9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 (%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217383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op tim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9 mi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0220627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st tim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532859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bserved column pressur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0-330 bar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508848419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0193" y="4287560"/>
            <a:ext cx="6013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ble S1:  UHPLC parameters</a:t>
            </a:r>
          </a:p>
        </p:txBody>
      </p:sp>
    </p:spTree>
    <p:extLst>
      <p:ext uri="{BB962C8B-B14F-4D97-AF65-F5344CB8AC3E}">
        <p14:creationId xmlns:p14="http://schemas.microsoft.com/office/powerpoint/2010/main" val="31675397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="" xmlns:a16="http://schemas.microsoft.com/office/drawing/2014/main" id="{FA8AF8ED-F679-4A15-A640-834BEFF4DA71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941422" y="697146"/>
          <a:ext cx="4225925" cy="4626864"/>
        </p:xfrm>
        <a:graphic>
          <a:graphicData uri="http://schemas.openxmlformats.org/drawingml/2006/table">
            <a:tbl>
              <a:tblPr firstRow="1" firstCol="1" bandRow="1"/>
              <a:tblGrid>
                <a:gridCol w="2168525">
                  <a:extLst>
                    <a:ext uri="{9D8B030D-6E8A-4147-A177-3AD203B41FA5}">
                      <a16:colId xmlns="" xmlns:a16="http://schemas.microsoft.com/office/drawing/2014/main" val="3582726306"/>
                    </a:ext>
                  </a:extLst>
                </a:gridCol>
                <a:gridCol w="2057400">
                  <a:extLst>
                    <a:ext uri="{9D8B030D-6E8A-4147-A177-3AD203B41FA5}">
                      <a16:colId xmlns="" xmlns:a16="http://schemas.microsoft.com/office/drawing/2014/main" val="174241584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FFFFFF"/>
                          </a:solidFill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ramete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5D5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FFFFFF"/>
                          </a:solidFill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gilent 6546 LC/Q-TOF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85D5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85D5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9411199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as temperatur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0 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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0257600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as flow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 L/mi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0267547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bulizer (psig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115711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heath gas temperatur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00 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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5778361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heath gas flow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 L/mi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3338036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low rat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 mL/mi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3885253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Cap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,500 V (+), 3,000 V (-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402742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zzle voltag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 V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5647164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ragmento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0 V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863678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kimme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5 V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314461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 err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ctopoleRF</a:t>
                      </a:r>
                      <a:r>
                        <a:rPr lang="en-US" sz="800" b="1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1" dirty="0" err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pp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50 V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9923756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eference mas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/z 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1.050873, </a:t>
                      </a:r>
                      <a:r>
                        <a:rPr lang="en-US" sz="800" i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/z 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22.009798 (+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/z 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9.03632, </a:t>
                      </a:r>
                      <a:r>
                        <a:rPr lang="en-US" sz="800" i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/z 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80.016375 (-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6362008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S and MS/MS rang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/z 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0-1700 (+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7625124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in MS and MS/MS acquisition rat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spectra/se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1149317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solation width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arrow (~ 1.3 </a:t>
                      </a:r>
                      <a:r>
                        <a:rPr lang="en-US" sz="800" i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/z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9987739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llision Energy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 eV (+), 25 eV (-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803155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x precursors per cycl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013432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ecursor abundance-based scan speed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, target 25,000 counts/spectrum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5249956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se MS/MS accumulation time limit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6232021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eject precursors that cannot reach target TIC 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277466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hreshold for MS/M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,000 counts and 0.001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4873318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ctive exclusion enabled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, one repeat, then exclude for 0.05 mi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2094602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urity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ringency 70%, Cutoff 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4186822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sotope model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mmon organic molecul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702558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ort precursor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, 2, unknow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3786952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atic exclusion rang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/z 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0-151 (+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/z </a:t>
                      </a: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0-210 (-)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2689168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terative MS/MS mass error toleranc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 ppm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2312747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terative MS/MS RT exclusion toleranc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800" dirty="0">
                          <a:effectLst/>
                          <a:latin typeface="AgilentCond-Bold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0.1 min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48173873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0243" y="5476350"/>
            <a:ext cx="60139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ble S2:  Mass spectrometric parameters for the Agilent 6546 LC/Q-TOF. </a:t>
            </a:r>
          </a:p>
        </p:txBody>
      </p:sp>
    </p:spTree>
    <p:extLst>
      <p:ext uri="{BB962C8B-B14F-4D97-AF65-F5344CB8AC3E}">
        <p14:creationId xmlns:p14="http://schemas.microsoft.com/office/powerpoint/2010/main" val="157131082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055" y="4383085"/>
            <a:ext cx="2799602" cy="138455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27299" y="4403182"/>
            <a:ext cx="2852334" cy="138455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2201" y="67624"/>
            <a:ext cx="2799602" cy="115538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0243" y="3177790"/>
            <a:ext cx="601393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4: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tal number of unique lipids annotated per software and polarity. In this case unique lipids refers to the number of lipid species after combining differing adducts for a single molecular species and combining chromatographically resolved isomers which were indistinguishable by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S/M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0243" y="1272789"/>
            <a:ext cx="60139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3: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tal number of features annotated with iterative exclusion data-dependent analysis (IE-DDA), DDA, and IE-DDA with high injectio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olum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0243" y="5769312"/>
            <a:ext cx="601393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5: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rcent of features which have annotations across all software (excluding ether-lipids) with one or more additional software proving the same annotation at the level of lipid class, carbons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unsaturation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C:DB), and at the level of fatty acyl constituents (FA). “All” represents the percent of feature where all three software provided the same annotation. 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7570" y="2002288"/>
            <a:ext cx="2932346" cy="11566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6864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3265714"/>
            <a:ext cx="62642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Supplemental Figures</a:t>
            </a:r>
          </a:p>
        </p:txBody>
      </p:sp>
    </p:spTree>
    <p:extLst>
      <p:ext uri="{BB962C8B-B14F-4D97-AF65-F5344CB8AC3E}">
        <p14:creationId xmlns:p14="http://schemas.microsoft.com/office/powerpoint/2010/main" val="35741141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0805" y="3727189"/>
            <a:ext cx="4145639" cy="188992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84919" y="6152702"/>
            <a:ext cx="623460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: A figure describing the algorithm for determining MS/MS score. Note that two “artifact peaks” actually come from PC(18:1_20:4) and hence reduce the score due to mixed spectra. Therefore, after negative least squares is applied, the in-silico mixed spectra is used to obtain a new MS/MS score which takes into account co-eluting lipids. *A normalization factor is applied to have a scoring scale between 0 – 100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425" r="567" b="541"/>
          <a:stretch/>
        </p:blipFill>
        <p:spPr>
          <a:xfrm>
            <a:off x="540805" y="652456"/>
            <a:ext cx="4149690" cy="1884479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925411" y="1115880"/>
            <a:ext cx="2324805" cy="52138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C(16:0_22:5)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atch score: 75 </a:t>
            </a:r>
          </a:p>
        </p:txBody>
      </p:sp>
      <p:sp>
        <p:nvSpPr>
          <p:cNvPr id="7" name="Rectangle 6"/>
          <p:cNvSpPr/>
          <p:nvPr/>
        </p:nvSpPr>
        <p:spPr>
          <a:xfrm>
            <a:off x="1097023" y="2236763"/>
            <a:ext cx="849587" cy="3128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:0</a:t>
            </a:r>
            <a:endParaRPr lang="en-US" sz="12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1585519" y="2225288"/>
            <a:ext cx="849587" cy="3128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:5</a:t>
            </a:r>
            <a:endParaRPr lang="en-US" sz="1200" baseline="300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1" name="Rectangle 10"/>
              <p:cNvSpPr/>
              <p:nvPr/>
            </p:nvSpPr>
            <p:spPr>
              <a:xfrm>
                <a:off x="79587" y="-64604"/>
                <a:ext cx="3130665" cy="46814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Impurity MS/MS Value (</a:t>
                </a:r>
                <a14:m>
                  <m:oMath xmlns:m="http://schemas.openxmlformats.org/officeDocument/2006/math">
                    <m:r>
                      <a:rPr lang="en-US" sz="1200" i="1">
                        <a:latin typeface="Cambria Math" panose="02040503050406030204" pitchFamily="18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m:t>𝐼</m:t>
                    </m:r>
                  </m:oMath>
                </a14:m>
                <a:r>
                  <a:rPr lang="en-US" sz="1200" dirty="0" smtClean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 </a:t>
                </a:r>
                <a14:m>
                  <m:oMath xmlns:m="http://schemas.openxmlformats.org/officeDocument/2006/math">
                    <m:r>
                      <a:rPr lang="en-US" sz="1200" i="1">
                        <a:latin typeface="Cambria Math" panose="02040503050406030204" pitchFamily="18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m:t>=</m:t>
                    </m:r>
                    <m:rad>
                      <m:radPr>
                        <m:degHide m:val="on"/>
                        <m:ctrlPr>
                          <a:rPr lang="en-US" sz="1200" i="1">
                            <a:effectLst/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</m:ctrlPr>
                      </m:radPr>
                      <m:deg/>
                      <m:e>
                        <m:nary>
                          <m:naryPr>
                            <m:chr m:val="∑"/>
                            <m:limLoc m:val="subSup"/>
                            <m:supHide m:val="on"/>
                            <m:ctrlPr>
                              <a:rPr lang="en-US" sz="1200" i="1">
                                <a:effectLst/>
                                <a:latin typeface="Cambria Math" panose="02040503050406030204" pitchFamily="18" charset="0"/>
                                <a:cs typeface="Arial" panose="020B0604020202020204" pitchFamily="34" charset="0"/>
                              </a:rPr>
                            </m:ctrlPr>
                          </m:naryPr>
                          <m:sub>
                            <m:r>
                              <a:rPr lang="en-US" sz="1200" i="1">
                                <a:effectLst/>
                                <a:latin typeface="Cambria Math" panose="02040503050406030204" pitchFamily="18" charset="0"/>
                                <a:ea typeface="Calibri" panose="020F0502020204030204" pitchFamily="34" charset="0"/>
                                <a:cs typeface="Arial" panose="020B0604020202020204" pitchFamily="34" charset="0"/>
                              </a:rPr>
                              <m:t>𝑖</m:t>
                            </m:r>
                          </m:sub>
                          <m:sup/>
                          <m:e>
                            <m:sSubSup>
                              <m:sSubSupPr>
                                <m:ctrlPr>
                                  <a:rPr lang="en-US" sz="1200" i="1" smtClean="0">
                                    <a:solidFill>
                                      <a:srgbClr val="C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</m:ctrlPr>
                              </m:sSubSupPr>
                              <m:e>
                                <m:r>
                                  <a:rPr lang="en-US" sz="1200" i="1">
                                    <a:solidFill>
                                      <a:srgbClr val="C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Arial" panose="020B0604020202020204" pitchFamily="34" charset="0"/>
                                  </a:rPr>
                                  <m:t>h</m:t>
                                </m:r>
                              </m:e>
                              <m:sub>
                                <m:r>
                                  <a:rPr lang="en-US" sz="1200" i="1">
                                    <a:solidFill>
                                      <a:srgbClr val="C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Arial" panose="020B0604020202020204" pitchFamily="34" charset="0"/>
                                  </a:rPr>
                                  <m:t>𝑖</m:t>
                                </m:r>
                              </m:sub>
                              <m:sup>
                                <m:r>
                                  <a:rPr lang="en-US" sz="1200" i="1">
                                    <a:solidFill>
                                      <a:srgbClr val="C00000"/>
                                    </a:solidFill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Arial" panose="020B0604020202020204" pitchFamily="34" charset="0"/>
                                  </a:rPr>
                                  <m:t>2</m:t>
                                </m:r>
                              </m:sup>
                            </m:sSubSup>
                          </m:e>
                        </m:nary>
                        <m:r>
                          <a:rPr lang="en-US" sz="1200" i="1">
                            <a:effectLst/>
                            <a:latin typeface="Cambria Math" panose="02040503050406030204" pitchFamily="18" charset="0"/>
                            <a:ea typeface="Calibri" panose="020F0502020204030204" pitchFamily="34" charset="0"/>
                            <a:cs typeface="Arial" panose="020B0604020202020204" pitchFamily="34" charset="0"/>
                          </a:rPr>
                          <m:t>⁄</m:t>
                        </m:r>
                        <m:nary>
                          <m:naryPr>
                            <m:chr m:val="∑"/>
                            <m:limLoc m:val="subSup"/>
                            <m:supHide m:val="on"/>
                            <m:ctrlPr>
                              <a:rPr lang="en-US" sz="1200" i="1" smtClean="0">
                                <a:solidFill>
                                  <a:srgbClr val="41719C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naryPr>
                          <m:sub>
                            <m:r>
                              <a:rPr lang="en-US" sz="1200" i="1">
                                <a:solidFill>
                                  <a:srgbClr val="41719C"/>
                                </a:solidFill>
                                <a:latin typeface="Cambria Math" panose="02040503050406030204" pitchFamily="18" charset="0"/>
                              </a:rPr>
                              <m:t>𝑑</m:t>
                            </m:r>
                          </m:sub>
                          <m:sup/>
                          <m:e>
                            <m:sSubSup>
                              <m:sSubSupPr>
                                <m:ctrlPr>
                                  <a:rPr lang="en-US" sz="1200" i="1">
                                    <a:solidFill>
                                      <a:srgbClr val="41719C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sSubSupPr>
                              <m:e>
                                <m:acc>
                                  <m:accPr>
                                    <m:chr m:val="̂"/>
                                    <m:ctrlPr>
                                      <a:rPr lang="en-US" sz="1200" i="1">
                                        <a:solidFill>
                                          <a:srgbClr val="41719C"/>
                                        </a:solidFill>
                                        <a:latin typeface="Cambria Math" panose="02040503050406030204" pitchFamily="18" charset="0"/>
                                      </a:rPr>
                                    </m:ctrlPr>
                                  </m:accPr>
                                  <m:e>
                                    <m:r>
                                      <a:rPr lang="en-US" sz="1200" i="1">
                                        <a:solidFill>
                                          <a:srgbClr val="41719C"/>
                                        </a:solidFill>
                                        <a:latin typeface="Cambria Math" panose="02040503050406030204" pitchFamily="18" charset="0"/>
                                      </a:rPr>
                                      <m:t>h</m:t>
                                    </m:r>
                                  </m:e>
                                </m:acc>
                              </m:e>
                              <m:sub>
                                <m:r>
                                  <a:rPr lang="en-US" sz="1200" i="1">
                                    <a:solidFill>
                                      <a:srgbClr val="41719C"/>
                                    </a:solidFill>
                                    <a:latin typeface="Cambria Math" panose="02040503050406030204" pitchFamily="18" charset="0"/>
                                  </a:rPr>
                                  <m:t>𝑑</m:t>
                                </m:r>
                              </m:sub>
                              <m:sup>
                                <m:r>
                                  <a:rPr lang="en-US" sz="1200" i="1">
                                    <a:solidFill>
                                      <a:srgbClr val="41719C"/>
                                    </a:solidFill>
                                    <a:latin typeface="Cambria Math" panose="02040503050406030204" pitchFamily="18" charset="0"/>
                                  </a:rPr>
                                  <m:t>2</m:t>
                                </m:r>
                              </m:sup>
                            </m:sSubSup>
                          </m:e>
                        </m:nary>
                      </m:e>
                    </m:rad>
                    <m:r>
                      <a:rPr lang="en-US" sz="1200" i="1">
                        <a:effectLst/>
                        <a:latin typeface="Cambria Math" panose="02040503050406030204" pitchFamily="18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m:t> </m:t>
                    </m:r>
                  </m:oMath>
                </a14:m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11" name="Rectangle 10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9587" y="-64604"/>
                <a:ext cx="3130665" cy="468141"/>
              </a:xfrm>
              <a:prstGeom prst="rect">
                <a:avLst/>
              </a:prstGeom>
              <a:blipFill rotWithShape="0">
                <a:blip r:embed="rId4"/>
                <a:stretch>
                  <a:fillRect t="-33766" r="-5447" b="-76623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2" name="Rectangle 11"/>
              <p:cNvSpPr/>
              <p:nvPr/>
            </p:nvSpPr>
            <p:spPr>
              <a:xfrm>
                <a:off x="102763" y="3114912"/>
                <a:ext cx="3606180" cy="46814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atch MS/MS Value (</a:t>
                </a:r>
                <a14:m>
                  <m:oMath xmlns:m="http://schemas.openxmlformats.org/officeDocument/2006/math">
                    <m:r>
                      <a:rPr lang="en-US" sz="1200" b="0" i="1" smtClean="0">
                        <a:latin typeface="Cambria Math" panose="02040503050406030204" pitchFamily="18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m:t>𝑀</m:t>
                    </m:r>
                  </m:oMath>
                </a14:m>
                <a:r>
                  <a:rPr lang="en-US" sz="1200" dirty="0" smtClean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) </a:t>
                </a:r>
                <a14:m>
                  <m:oMath xmlns:m="http://schemas.openxmlformats.org/officeDocument/2006/math">
                    <m:r>
                      <a:rPr lang="en-US" sz="1200" i="1">
                        <a:latin typeface="Cambria Math" panose="02040503050406030204" pitchFamily="18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m:t>=</m:t>
                    </m:r>
                    <m:rad>
                      <m:radPr>
                        <m:degHide m:val="on"/>
                        <m:ctrlPr>
                          <a:rPr lang="en-US" sz="1200" i="1"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</m:ctrlPr>
                      </m:radPr>
                      <m:deg/>
                      <m:e>
                        <m:nary>
                          <m:naryPr>
                            <m:chr m:val="∑"/>
                            <m:limLoc m:val="subSup"/>
                            <m:supHide m:val="on"/>
                            <m:ctrlPr>
                              <a:rPr lang="en-US" sz="1200" i="1">
                                <a:latin typeface="Cambria Math" panose="02040503050406030204" pitchFamily="18" charset="0"/>
                                <a:cs typeface="Arial" panose="020B0604020202020204" pitchFamily="34" charset="0"/>
                              </a:rPr>
                            </m:ctrlPr>
                          </m:naryPr>
                          <m:sub>
                            <m:r>
                              <a:rPr lang="en-US" sz="1200" i="1">
                                <a:latin typeface="Cambria Math" panose="02040503050406030204" pitchFamily="18" charset="0"/>
                                <a:ea typeface="Calibri" panose="020F0502020204030204" pitchFamily="34" charset="0"/>
                                <a:cs typeface="Arial" panose="020B0604020202020204" pitchFamily="34" charset="0"/>
                              </a:rPr>
                              <m:t>𝑑</m:t>
                            </m:r>
                          </m:sub>
                          <m:sup/>
                          <m:e>
                            <m:sSup>
                              <m:sSupPr>
                                <m:ctrlPr>
                                  <a:rPr lang="en-US" sz="1200" i="1">
                                    <a:latin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</m:ctrlPr>
                              </m:sSupPr>
                              <m:e>
                                <m:r>
                                  <a:rPr lang="en-US" sz="1200" i="1"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Arial" panose="020B0604020202020204" pitchFamily="34" charset="0"/>
                                  </a:rPr>
                                  <m:t>(</m:t>
                                </m:r>
                                <m:sSub>
                                  <m:sSubPr>
                                    <m:ctrlPr>
                                      <a:rPr lang="en-US" sz="1200" i="1" smtClean="0">
                                        <a:solidFill>
                                          <a:schemeClr val="accent6">
                                            <a:lumMod val="50000"/>
                                          </a:schemeClr>
                                        </a:solidFill>
                                        <a:latin typeface="Cambria Math" panose="02040503050406030204" pitchFamily="18" charset="0"/>
                                        <a:cs typeface="Arial" panose="020B0604020202020204" pitchFamily="34" charset="0"/>
                                      </a:rPr>
                                    </m:ctrlPr>
                                  </m:sSubPr>
                                  <m:e>
                                    <m:r>
                                      <a:rPr lang="en-US" sz="1200" i="1">
                                        <a:solidFill>
                                          <a:schemeClr val="accent6">
                                            <a:lumMod val="50000"/>
                                          </a:schemeClr>
                                        </a:solidFill>
                                        <a:latin typeface="Cambria Math" panose="02040503050406030204" pitchFamily="18" charset="0"/>
                                        <a:ea typeface="Calibri" panose="020F0502020204030204" pitchFamily="34" charset="0"/>
                                        <a:cs typeface="Arial" panose="020B0604020202020204" pitchFamily="34" charset="0"/>
                                      </a:rPr>
                                      <m:t>h</m:t>
                                    </m:r>
                                  </m:e>
                                  <m:sub>
                                    <m:r>
                                      <a:rPr lang="en-US" sz="1200" i="1">
                                        <a:solidFill>
                                          <a:schemeClr val="accent6">
                                            <a:lumMod val="50000"/>
                                          </a:schemeClr>
                                        </a:solidFill>
                                        <a:latin typeface="Cambria Math" panose="02040503050406030204" pitchFamily="18" charset="0"/>
                                        <a:ea typeface="Calibri" panose="020F0502020204030204" pitchFamily="34" charset="0"/>
                                        <a:cs typeface="Arial" panose="020B0604020202020204" pitchFamily="34" charset="0"/>
                                      </a:rPr>
                                      <m:t>𝑑</m:t>
                                    </m:r>
                                  </m:sub>
                                </m:sSub>
                                <m:r>
                                  <a:rPr lang="en-US" sz="1200" i="1"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Arial" panose="020B0604020202020204" pitchFamily="34" charset="0"/>
                                  </a:rPr>
                                  <m:t>−</m:t>
                                </m:r>
                                <m:sSub>
                                  <m:sSubPr>
                                    <m:ctrlPr>
                                      <a:rPr lang="en-US" sz="1200" i="1" smtClean="0">
                                        <a:solidFill>
                                          <a:srgbClr val="41719C"/>
                                        </a:solidFill>
                                        <a:latin typeface="Cambria Math" panose="02040503050406030204" pitchFamily="18" charset="0"/>
                                        <a:cs typeface="Arial" panose="020B0604020202020204" pitchFamily="34" charset="0"/>
                                      </a:rPr>
                                    </m:ctrlPr>
                                  </m:sSubPr>
                                  <m:e>
                                    <m:acc>
                                      <m:accPr>
                                        <m:chr m:val="̂"/>
                                        <m:ctrlPr>
                                          <a:rPr lang="en-US" sz="1200" i="1">
                                            <a:solidFill>
                                              <a:srgbClr val="41719C"/>
                                            </a:solidFill>
                                            <a:latin typeface="Cambria Math" panose="02040503050406030204" pitchFamily="18" charset="0"/>
                                            <a:cs typeface="Arial" panose="020B0604020202020204" pitchFamily="34" charset="0"/>
                                          </a:rPr>
                                        </m:ctrlPr>
                                      </m:accPr>
                                      <m:e>
                                        <m:r>
                                          <a:rPr lang="en-US" sz="1200" i="1">
                                            <a:solidFill>
                                              <a:srgbClr val="41719C"/>
                                            </a:solidFill>
                                            <a:latin typeface="Cambria Math" panose="02040503050406030204" pitchFamily="18" charset="0"/>
                                            <a:ea typeface="Calibri" panose="020F0502020204030204" pitchFamily="34" charset="0"/>
                                            <a:cs typeface="Arial" panose="020B0604020202020204" pitchFamily="34" charset="0"/>
                                          </a:rPr>
                                          <m:t>h</m:t>
                                        </m:r>
                                      </m:e>
                                    </m:acc>
                                  </m:e>
                                  <m:sub>
                                    <m:r>
                                      <a:rPr lang="en-US" sz="1200" i="1">
                                        <a:solidFill>
                                          <a:srgbClr val="41719C"/>
                                        </a:solidFill>
                                        <a:latin typeface="Cambria Math" panose="02040503050406030204" pitchFamily="18" charset="0"/>
                                        <a:ea typeface="Calibri" panose="020F0502020204030204" pitchFamily="34" charset="0"/>
                                        <a:cs typeface="Arial" panose="020B0604020202020204" pitchFamily="34" charset="0"/>
                                      </a:rPr>
                                      <m:t>𝑑</m:t>
                                    </m:r>
                                  </m:sub>
                                </m:sSub>
                                <m:r>
                                  <a:rPr lang="en-US" sz="1200" i="1"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Arial" panose="020B0604020202020204" pitchFamily="34" charset="0"/>
                                  </a:rPr>
                                  <m:t>)</m:t>
                                </m:r>
                              </m:e>
                              <m:sup>
                                <m:r>
                                  <a:rPr lang="en-US" sz="1200" i="1"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Arial" panose="020B0604020202020204" pitchFamily="34" charset="0"/>
                                  </a:rPr>
                                  <m:t>2</m:t>
                                </m:r>
                              </m:sup>
                            </m:sSup>
                          </m:e>
                        </m:nary>
                        <m:r>
                          <a:rPr lang="en-US" sz="1200" i="1">
                            <a:latin typeface="Cambria Math" panose="02040503050406030204" pitchFamily="18" charset="0"/>
                            <a:ea typeface="Calibri" panose="020F0502020204030204" pitchFamily="34" charset="0"/>
                            <a:cs typeface="Arial" panose="020B0604020202020204" pitchFamily="34" charset="0"/>
                          </a:rPr>
                          <m:t>⁄</m:t>
                        </m:r>
                        <m:nary>
                          <m:naryPr>
                            <m:chr m:val="∑"/>
                            <m:limLoc m:val="subSup"/>
                            <m:supHide m:val="on"/>
                            <m:ctrlPr>
                              <a:rPr lang="en-US" sz="1200" i="1" smtClean="0">
                                <a:solidFill>
                                  <a:srgbClr val="41719C"/>
                                </a:solidFill>
                                <a:latin typeface="Cambria Math" panose="02040503050406030204" pitchFamily="18" charset="0"/>
                              </a:rPr>
                            </m:ctrlPr>
                          </m:naryPr>
                          <m:sub>
                            <m:r>
                              <a:rPr lang="en-US" sz="1200" i="1">
                                <a:solidFill>
                                  <a:srgbClr val="41719C"/>
                                </a:solidFill>
                                <a:latin typeface="Cambria Math" panose="02040503050406030204" pitchFamily="18" charset="0"/>
                              </a:rPr>
                              <m:t>𝑑</m:t>
                            </m:r>
                          </m:sub>
                          <m:sup/>
                          <m:e>
                            <m:sSubSup>
                              <m:sSubSupPr>
                                <m:ctrlPr>
                                  <a:rPr lang="en-US" sz="1200" i="1">
                                    <a:solidFill>
                                      <a:srgbClr val="41719C"/>
                                    </a:solidFill>
                                    <a:latin typeface="Cambria Math" panose="02040503050406030204" pitchFamily="18" charset="0"/>
                                  </a:rPr>
                                </m:ctrlPr>
                              </m:sSubSupPr>
                              <m:e>
                                <m:acc>
                                  <m:accPr>
                                    <m:chr m:val="̂"/>
                                    <m:ctrlPr>
                                      <a:rPr lang="en-US" sz="1200" i="1">
                                        <a:solidFill>
                                          <a:srgbClr val="41719C"/>
                                        </a:solidFill>
                                        <a:latin typeface="Cambria Math" panose="02040503050406030204" pitchFamily="18" charset="0"/>
                                      </a:rPr>
                                    </m:ctrlPr>
                                  </m:accPr>
                                  <m:e>
                                    <m:r>
                                      <a:rPr lang="en-US" sz="1200" i="1">
                                        <a:solidFill>
                                          <a:srgbClr val="41719C"/>
                                        </a:solidFill>
                                        <a:latin typeface="Cambria Math" panose="02040503050406030204" pitchFamily="18" charset="0"/>
                                      </a:rPr>
                                      <m:t>h</m:t>
                                    </m:r>
                                  </m:e>
                                </m:acc>
                              </m:e>
                              <m:sub>
                                <m:r>
                                  <a:rPr lang="en-US" sz="1200" i="1">
                                    <a:solidFill>
                                      <a:srgbClr val="41719C"/>
                                    </a:solidFill>
                                    <a:latin typeface="Cambria Math" panose="02040503050406030204" pitchFamily="18" charset="0"/>
                                  </a:rPr>
                                  <m:t>𝑑</m:t>
                                </m:r>
                              </m:sub>
                              <m:sup>
                                <m:r>
                                  <a:rPr lang="en-US" sz="1200" i="1">
                                    <a:solidFill>
                                      <a:srgbClr val="41719C"/>
                                    </a:solidFill>
                                    <a:latin typeface="Cambria Math" panose="02040503050406030204" pitchFamily="18" charset="0"/>
                                  </a:rPr>
                                  <m:t>2</m:t>
                                </m:r>
                              </m:sup>
                            </m:sSubSup>
                          </m:e>
                        </m:nary>
                      </m:e>
                    </m:rad>
                  </m:oMath>
                </a14:m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12" name="Rectangle 11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2763" y="3114912"/>
                <a:ext cx="3606180" cy="468141"/>
              </a:xfrm>
              <a:prstGeom prst="rect">
                <a:avLst/>
              </a:prstGeom>
              <a:blipFill rotWithShape="0">
                <a:blip r:embed="rId5"/>
                <a:stretch>
                  <a:fillRect l="-169" t="-32468" r="-5584" b="-77922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3" name="Rectangle 12"/>
              <p:cNvSpPr/>
              <p:nvPr/>
            </p:nvSpPr>
            <p:spPr>
              <a:xfrm>
                <a:off x="2449085" y="358831"/>
                <a:ext cx="639167" cy="31283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200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a:rPr lang="en-US" sz="1200" b="0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h</m:t>
                          </m:r>
                        </m:e>
                        <m:sub>
                          <m:r>
                            <a:rPr lang="en-US" sz="1200" b="0" i="1" smtClean="0"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𝑖</m:t>
                          </m:r>
                        </m:sub>
                      </m:sSub>
                    </m:oMath>
                  </m:oMathPara>
                </a14:m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13" name="Rectangle 12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449085" y="358831"/>
                <a:ext cx="639167" cy="312830"/>
              </a:xfrm>
              <a:prstGeom prst="rect">
                <a:avLst/>
              </a:prstGeom>
              <a:blipFill rotWithShape="0">
                <a:blip r:embed="rId6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4" name="Rectangle 13"/>
              <p:cNvSpPr/>
              <p:nvPr/>
            </p:nvSpPr>
            <p:spPr>
              <a:xfrm>
                <a:off x="2471560" y="2684637"/>
                <a:ext cx="747028" cy="33962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Sup>
                        <m:sSubSupPr>
                          <m:ctrlPr>
                            <a:rPr lang="en-US" sz="1200" i="1">
                              <a:latin typeface="Cambria Math" panose="02040503050406030204" pitchFamily="18" charset="0"/>
                            </a:rPr>
                          </m:ctrlPr>
                        </m:sSubSupPr>
                        <m:e>
                          <m:acc>
                            <m:accPr>
                              <m:chr m:val="̂"/>
                              <m:ctrlPr>
                                <a:rPr lang="en-US" sz="1200" i="1">
                                  <a:latin typeface="Cambria Math" panose="02040503050406030204" pitchFamily="18" charset="0"/>
                                </a:rPr>
                              </m:ctrlPr>
                            </m:accPr>
                            <m:e>
                              <m:r>
                                <a:rPr lang="en-US" sz="1200" i="1">
                                  <a:latin typeface="Cambria Math" panose="02040503050406030204" pitchFamily="18" charset="0"/>
                                </a:rPr>
                                <m:t>h</m:t>
                              </m:r>
                            </m:e>
                          </m:acc>
                        </m:e>
                        <m:sub>
                          <m:r>
                            <a:rPr lang="en-US" sz="1200" i="1">
                              <a:latin typeface="Cambria Math" panose="02040503050406030204" pitchFamily="18" charset="0"/>
                            </a:rPr>
                            <m:t>𝑑</m:t>
                          </m:r>
                        </m:sub>
                        <m:sup/>
                      </m:sSubSup>
                    </m:oMath>
                  </m:oMathPara>
                </a14:m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14" name="Rectangle 13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471560" y="2684637"/>
                <a:ext cx="747028" cy="339622"/>
              </a:xfrm>
              <a:prstGeom prst="rect">
                <a:avLst/>
              </a:prstGeom>
              <a:blipFill rotWithShape="0">
                <a:blip r:embed="rId7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15" name="Elbow Connector 14"/>
          <p:cNvCxnSpPr>
            <a:stCxn id="14" idx="3"/>
          </p:cNvCxnSpPr>
          <p:nvPr/>
        </p:nvCxnSpPr>
        <p:spPr>
          <a:xfrm flipV="1">
            <a:off x="3218589" y="2574284"/>
            <a:ext cx="603817" cy="280166"/>
          </a:xfrm>
          <a:prstGeom prst="bentConnector3">
            <a:avLst>
              <a:gd name="adj1" fmla="val 100205"/>
            </a:avLst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Elbow Connector 15"/>
          <p:cNvCxnSpPr>
            <a:stCxn id="14" idx="3"/>
          </p:cNvCxnSpPr>
          <p:nvPr/>
        </p:nvCxnSpPr>
        <p:spPr>
          <a:xfrm flipV="1">
            <a:off x="3218589" y="2085100"/>
            <a:ext cx="895241" cy="769350"/>
          </a:xfrm>
          <a:prstGeom prst="bentConnector2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Elbow Connector 16"/>
          <p:cNvCxnSpPr>
            <a:stCxn id="14" idx="1"/>
          </p:cNvCxnSpPr>
          <p:nvPr/>
        </p:nvCxnSpPr>
        <p:spPr>
          <a:xfrm rot="10800000">
            <a:off x="1754413" y="2416016"/>
            <a:ext cx="717148" cy="438433"/>
          </a:xfrm>
          <a:prstGeom prst="bentConnector3">
            <a:avLst>
              <a:gd name="adj1" fmla="val 99893"/>
            </a:avLst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Elbow Connector 17"/>
          <p:cNvCxnSpPr>
            <a:stCxn id="14" idx="1"/>
          </p:cNvCxnSpPr>
          <p:nvPr/>
        </p:nvCxnSpPr>
        <p:spPr>
          <a:xfrm rot="10800000">
            <a:off x="1418162" y="2434009"/>
            <a:ext cx="1053399" cy="420441"/>
          </a:xfrm>
          <a:prstGeom prst="bentConnector3">
            <a:avLst>
              <a:gd name="adj1" fmla="val 100007"/>
            </a:avLst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Elbow Connector 18"/>
          <p:cNvCxnSpPr>
            <a:stCxn id="14" idx="1"/>
          </p:cNvCxnSpPr>
          <p:nvPr/>
        </p:nvCxnSpPr>
        <p:spPr>
          <a:xfrm rot="10800000">
            <a:off x="1289256" y="2038344"/>
            <a:ext cx="1182304" cy="816106"/>
          </a:xfrm>
          <a:prstGeom prst="bentConnector2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886200" y="414511"/>
            <a:ext cx="16273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mpurities (no match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084237" y="2531734"/>
            <a:ext cx="16009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redicted Spectr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Elbow Connector 21"/>
          <p:cNvCxnSpPr>
            <a:stCxn id="13" idx="3"/>
          </p:cNvCxnSpPr>
          <p:nvPr/>
        </p:nvCxnSpPr>
        <p:spPr>
          <a:xfrm>
            <a:off x="3088251" y="515247"/>
            <a:ext cx="795800" cy="1307273"/>
          </a:xfrm>
          <a:prstGeom prst="bentConnector2">
            <a:avLst/>
          </a:prstGeom>
          <a:ln w="127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Elbow Connector 22"/>
          <p:cNvCxnSpPr>
            <a:stCxn id="13" idx="1"/>
          </p:cNvCxnSpPr>
          <p:nvPr/>
        </p:nvCxnSpPr>
        <p:spPr>
          <a:xfrm rot="10800000" flipV="1">
            <a:off x="1642330" y="515246"/>
            <a:ext cx="806757" cy="1123828"/>
          </a:xfrm>
          <a:prstGeom prst="bentConnector2">
            <a:avLst/>
          </a:prstGeom>
          <a:ln w="127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Elbow Connector 23"/>
          <p:cNvCxnSpPr>
            <a:stCxn id="13" idx="1"/>
          </p:cNvCxnSpPr>
          <p:nvPr/>
        </p:nvCxnSpPr>
        <p:spPr>
          <a:xfrm rot="10800000" flipV="1">
            <a:off x="1541462" y="515246"/>
            <a:ext cx="907622" cy="1289285"/>
          </a:xfrm>
          <a:prstGeom prst="bentConnector2">
            <a:avLst/>
          </a:prstGeom>
          <a:ln w="1270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25" name="Rectangle 24"/>
              <p:cNvSpPr/>
              <p:nvPr/>
            </p:nvSpPr>
            <p:spPr>
              <a:xfrm>
                <a:off x="2431505" y="3492266"/>
                <a:ext cx="395045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200" i="1" smtClean="0">
                              <a:solidFill>
                                <a:schemeClr val="accent6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</m:ctrlPr>
                        </m:sSubPr>
                        <m:e>
                          <m:r>
                            <a:rPr lang="en-US" sz="1200" b="0" i="1" smtClean="0">
                              <a:solidFill>
                                <a:schemeClr val="accent6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h</m:t>
                          </m:r>
                        </m:e>
                        <m:sub>
                          <m:r>
                            <a:rPr lang="en-US" sz="1200" b="0" i="1" smtClean="0">
                              <a:solidFill>
                                <a:schemeClr val="accent6">
                                  <a:lumMod val="50000"/>
                                </a:schemeClr>
                              </a:solidFill>
                              <a:latin typeface="Cambria Math" panose="02040503050406030204" pitchFamily="18" charset="0"/>
                              <a:cs typeface="Arial" panose="020B0604020202020204" pitchFamily="34" charset="0"/>
                            </a:rPr>
                            <m:t>𝑑</m:t>
                          </m:r>
                        </m:sub>
                      </m:sSub>
                    </m:oMath>
                  </m:oMathPara>
                </a14:m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25" name="Rectangle 24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431505" y="3492266"/>
                <a:ext cx="395045" cy="276999"/>
              </a:xfrm>
              <a:prstGeom prst="rect">
                <a:avLst/>
              </a:prstGeom>
              <a:blipFill rotWithShape="0">
                <a:blip r:embed="rId8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6" name="TextBox 25"/>
          <p:cNvSpPr txBox="1"/>
          <p:nvPr/>
        </p:nvSpPr>
        <p:spPr>
          <a:xfrm>
            <a:off x="4098194" y="3498251"/>
            <a:ext cx="3972080" cy="312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al matched spectr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Elbow Connector 26"/>
          <p:cNvCxnSpPr>
            <a:stCxn id="25" idx="3"/>
          </p:cNvCxnSpPr>
          <p:nvPr/>
        </p:nvCxnSpPr>
        <p:spPr>
          <a:xfrm>
            <a:off x="2826550" y="3630766"/>
            <a:ext cx="970198" cy="195800"/>
          </a:xfrm>
          <a:prstGeom prst="bentConnector3">
            <a:avLst>
              <a:gd name="adj1" fmla="val 99958"/>
            </a:avLst>
          </a:prstGeom>
          <a:ln w="12700">
            <a:solidFill>
              <a:schemeClr val="accent6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Elbow Connector 27"/>
          <p:cNvCxnSpPr>
            <a:stCxn id="25" idx="1"/>
          </p:cNvCxnSpPr>
          <p:nvPr/>
        </p:nvCxnSpPr>
        <p:spPr>
          <a:xfrm rot="10800000" flipV="1">
            <a:off x="1749287" y="3630765"/>
            <a:ext cx="682218" cy="1169835"/>
          </a:xfrm>
          <a:prstGeom prst="bentConnector2">
            <a:avLst/>
          </a:prstGeom>
          <a:ln w="12700">
            <a:solidFill>
              <a:schemeClr val="accent6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Elbow Connector 28"/>
          <p:cNvCxnSpPr>
            <a:stCxn id="25" idx="1"/>
          </p:cNvCxnSpPr>
          <p:nvPr/>
        </p:nvCxnSpPr>
        <p:spPr>
          <a:xfrm rot="10800000" flipV="1">
            <a:off x="1426265" y="3630765"/>
            <a:ext cx="1005240" cy="1264257"/>
          </a:xfrm>
          <a:prstGeom prst="bentConnector2">
            <a:avLst/>
          </a:prstGeom>
          <a:ln w="12700">
            <a:solidFill>
              <a:schemeClr val="accent6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Elbow Connector 29"/>
          <p:cNvCxnSpPr>
            <a:stCxn id="25" idx="3"/>
          </p:cNvCxnSpPr>
          <p:nvPr/>
        </p:nvCxnSpPr>
        <p:spPr>
          <a:xfrm>
            <a:off x="2826550" y="3630766"/>
            <a:ext cx="1289316" cy="1309004"/>
          </a:xfrm>
          <a:prstGeom prst="bentConnector2">
            <a:avLst/>
          </a:prstGeom>
          <a:ln w="12700">
            <a:solidFill>
              <a:schemeClr val="accent6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mc:AlternateContent xmlns:mc="http://schemas.openxmlformats.org/markup-compatibility/2006" xmlns:a14="http://schemas.microsoft.com/office/drawing/2010/main">
        <mc:Choice Requires="a14">
          <p:sp>
            <p:nvSpPr>
              <p:cNvPr id="31" name="Rectangle 30"/>
              <p:cNvSpPr/>
              <p:nvPr/>
            </p:nvSpPr>
            <p:spPr>
              <a:xfrm>
                <a:off x="62481" y="5728452"/>
                <a:ext cx="2954655" cy="31579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 smtClean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Final Probability</a:t>
                </a:r>
                <a:r>
                  <a:rPr lang="en-US" sz="1200" b="1" baseline="30000" dirty="0" smtClean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*</a:t>
                </a:r>
                <a:r>
                  <a:rPr lang="en-US" sz="1200" b="1" dirty="0" smtClean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</a:t>
                </a:r>
                <a14:m>
                  <m:oMath xmlns:m="http://schemas.openxmlformats.org/officeDocument/2006/math">
                    <m:r>
                      <a:rPr lang="en-US" sz="1200" b="1" i="1">
                        <a:effectLst/>
                        <a:latin typeface="Cambria Math" panose="02040503050406030204" pitchFamily="18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m:t>=</m:t>
                    </m:r>
                    <m:sSup>
                      <m:sSupPr>
                        <m:ctrlPr>
                          <a:rPr lang="en-US" sz="1200" b="1" i="1">
                            <a:effectLst/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</m:ctrlPr>
                      </m:sSupPr>
                      <m:e>
                        <m:r>
                          <a:rPr lang="en-US" sz="1200" b="1" i="1">
                            <a:effectLst/>
                            <a:latin typeface="Cambria Math" panose="02040503050406030204" pitchFamily="18" charset="0"/>
                            <a:ea typeface="Calibri" panose="020F0502020204030204" pitchFamily="34" charset="0"/>
                            <a:cs typeface="Arial" panose="020B0604020202020204" pitchFamily="34" charset="0"/>
                          </a:rPr>
                          <m:t>𝒆</m:t>
                        </m:r>
                      </m:e>
                      <m:sup>
                        <m:r>
                          <a:rPr lang="en-US" sz="1200" b="1" i="1">
                            <a:effectLst/>
                            <a:latin typeface="Cambria Math" panose="02040503050406030204" pitchFamily="18" charset="0"/>
                            <a:ea typeface="Calibri" panose="020F0502020204030204" pitchFamily="34" charset="0"/>
                            <a:cs typeface="Arial" panose="020B0604020202020204" pitchFamily="34" charset="0"/>
                          </a:rPr>
                          <m:t>−</m:t>
                        </m:r>
                        <m:f>
                          <m:fPr>
                            <m:type m:val="lin"/>
                            <m:ctrlPr>
                              <a:rPr lang="en-US" sz="1200" b="1" i="1">
                                <a:effectLst/>
                                <a:latin typeface="Cambria Math" panose="02040503050406030204" pitchFamily="18" charset="0"/>
                                <a:cs typeface="Arial" panose="020B0604020202020204" pitchFamily="34" charset="0"/>
                              </a:rPr>
                            </m:ctrlPr>
                          </m:fPr>
                          <m:num>
                            <m:sSup>
                              <m:sSupPr>
                                <m:ctrlP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</m:ctrlPr>
                              </m:sSupPr>
                              <m:e>
                                <m: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Arial" panose="020B0604020202020204" pitchFamily="34" charset="0"/>
                                  </a:rPr>
                                  <m:t>𝑰</m:t>
                                </m:r>
                              </m:e>
                              <m:sup>
                                <m: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Arial" panose="020B0604020202020204" pitchFamily="34" charset="0"/>
                                  </a:rPr>
                                  <m:t>𝟐</m:t>
                                </m:r>
                              </m:sup>
                            </m:sSup>
                          </m:num>
                          <m:den>
                            <m:r>
                              <a:rPr lang="en-US" sz="1200" b="1" i="1">
                                <a:effectLst/>
                                <a:latin typeface="Cambria Math" panose="02040503050406030204" pitchFamily="18" charset="0"/>
                                <a:ea typeface="Calibri" panose="020F0502020204030204" pitchFamily="34" charset="0"/>
                                <a:cs typeface="Arial" panose="020B0604020202020204" pitchFamily="34" charset="0"/>
                              </a:rPr>
                              <m:t>𝟐</m:t>
                            </m:r>
                            <m:sSubSup>
                              <m:sSubSupPr>
                                <m:ctrlP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</a:rPr>
                                </m:ctrlPr>
                              </m:sSubSupPr>
                              <m:e>
                                <m: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Times New Roman" panose="02020603050405020304" pitchFamily="18" charset="0"/>
                                  </a:rPr>
                                  <m:t>𝝈</m:t>
                                </m:r>
                              </m:e>
                              <m:sub>
                                <m: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Times New Roman" panose="02020603050405020304" pitchFamily="18" charset="0"/>
                                  </a:rPr>
                                  <m:t>𝑰</m:t>
                                </m:r>
                              </m:sub>
                              <m:sup>
                                <m: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Times New Roman" panose="02020603050405020304" pitchFamily="18" charset="0"/>
                                  </a:rPr>
                                  <m:t>𝟐</m:t>
                                </m:r>
                              </m:sup>
                            </m:sSubSup>
                          </m:den>
                        </m:f>
                      </m:sup>
                    </m:sSup>
                    <m:r>
                      <a:rPr lang="en-US" sz="1200" b="1" i="1">
                        <a:effectLst/>
                        <a:latin typeface="Cambria Math" panose="02040503050406030204" pitchFamily="18" charset="0"/>
                        <a:ea typeface="Calibri" panose="020F0502020204030204" pitchFamily="34" charset="0"/>
                        <a:cs typeface="Arial" panose="020B0604020202020204" pitchFamily="34" charset="0"/>
                      </a:rPr>
                      <m:t> </m:t>
                    </m:r>
                    <m:sSup>
                      <m:sSupPr>
                        <m:ctrlPr>
                          <a:rPr lang="en-US" sz="1200" b="1" i="1">
                            <a:effectLst/>
                            <a:latin typeface="Cambria Math" panose="02040503050406030204" pitchFamily="18" charset="0"/>
                            <a:cs typeface="Arial" panose="020B0604020202020204" pitchFamily="34" charset="0"/>
                          </a:rPr>
                        </m:ctrlPr>
                      </m:sSupPr>
                      <m:e>
                        <m:r>
                          <a:rPr lang="en-US" sz="1200" b="1" i="1">
                            <a:effectLst/>
                            <a:latin typeface="Cambria Math" panose="02040503050406030204" pitchFamily="18" charset="0"/>
                            <a:ea typeface="Calibri" panose="020F0502020204030204" pitchFamily="34" charset="0"/>
                            <a:cs typeface="Arial" panose="020B0604020202020204" pitchFamily="34" charset="0"/>
                          </a:rPr>
                          <m:t>𝒆</m:t>
                        </m:r>
                      </m:e>
                      <m:sup>
                        <m:r>
                          <a:rPr lang="en-US" sz="1200" b="1" i="1">
                            <a:effectLst/>
                            <a:latin typeface="Cambria Math" panose="02040503050406030204" pitchFamily="18" charset="0"/>
                            <a:ea typeface="Calibri" panose="020F0502020204030204" pitchFamily="34" charset="0"/>
                            <a:cs typeface="Arial" panose="020B0604020202020204" pitchFamily="34" charset="0"/>
                          </a:rPr>
                          <m:t>−</m:t>
                        </m:r>
                        <m:f>
                          <m:fPr>
                            <m:type m:val="lin"/>
                            <m:ctrlPr>
                              <a:rPr lang="en-US" sz="1200" b="1" i="1">
                                <a:effectLst/>
                                <a:latin typeface="Cambria Math" panose="02040503050406030204" pitchFamily="18" charset="0"/>
                                <a:cs typeface="Arial" panose="020B0604020202020204" pitchFamily="34" charset="0"/>
                              </a:rPr>
                            </m:ctrlPr>
                          </m:fPr>
                          <m:num>
                            <m:sSup>
                              <m:sSupPr>
                                <m:ctrlP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</m:ctrlPr>
                              </m:sSupPr>
                              <m:e>
                                <m: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Arial" panose="020B0604020202020204" pitchFamily="34" charset="0"/>
                                  </a:rPr>
                                  <m:t>𝑴</m:t>
                                </m:r>
                              </m:e>
                              <m:sup>
                                <m: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Arial" panose="020B0604020202020204" pitchFamily="34" charset="0"/>
                                  </a:rPr>
                                  <m:t>𝟐</m:t>
                                </m:r>
                              </m:sup>
                            </m:sSup>
                          </m:num>
                          <m:den>
                            <m:r>
                              <a:rPr lang="en-US" sz="1200" b="1" i="1">
                                <a:effectLst/>
                                <a:latin typeface="Cambria Math" panose="02040503050406030204" pitchFamily="18" charset="0"/>
                                <a:ea typeface="Calibri" panose="020F0502020204030204" pitchFamily="34" charset="0"/>
                                <a:cs typeface="Arial" panose="020B0604020202020204" pitchFamily="34" charset="0"/>
                              </a:rPr>
                              <m:t>𝟐</m:t>
                            </m:r>
                            <m:sSubSup>
                              <m:sSubSupPr>
                                <m:ctrlP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</a:rPr>
                                </m:ctrlPr>
                              </m:sSubSupPr>
                              <m:e>
                                <m: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Times New Roman" panose="02020603050405020304" pitchFamily="18" charset="0"/>
                                  </a:rPr>
                                  <m:t>𝝈</m:t>
                                </m:r>
                              </m:e>
                              <m:sub>
                                <m: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Times New Roman" panose="02020603050405020304" pitchFamily="18" charset="0"/>
                                  </a:rPr>
                                  <m:t>𝑴</m:t>
                                </m:r>
                              </m:sub>
                              <m:sup>
                                <m:r>
                                  <a:rPr lang="en-US" sz="1200" b="1" i="1">
                                    <a:effectLst/>
                                    <a:latin typeface="Cambria Math" panose="02040503050406030204" pitchFamily="18" charset="0"/>
                                    <a:ea typeface="Calibri" panose="020F0502020204030204" pitchFamily="34" charset="0"/>
                                    <a:cs typeface="Times New Roman" panose="02020603050405020304" pitchFamily="18" charset="0"/>
                                  </a:rPr>
                                  <m:t>𝟐</m:t>
                                </m:r>
                              </m:sup>
                            </m:sSubSup>
                          </m:den>
                        </m:f>
                      </m:sup>
                    </m:sSup>
                  </m:oMath>
                </a14:m>
                <a:r>
                  <a:rPr lang="en-US" sz="1200" b="1" dirty="0">
                    <a:effectLst/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	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31" name="Rectangle 30"/>
              <p:cNvSpPr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2481" y="5728452"/>
                <a:ext cx="2954655" cy="315792"/>
              </a:xfrm>
              <a:prstGeom prst="rect">
                <a:avLst/>
              </a:prstGeom>
              <a:blipFill rotWithShape="0">
                <a:blip r:embed="rId9"/>
                <a:stretch>
                  <a:fillRect t="-71154" b="-1000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cxnSp>
        <p:nvCxnSpPr>
          <p:cNvPr id="35" name="Straight Connector 34"/>
          <p:cNvCxnSpPr/>
          <p:nvPr/>
        </p:nvCxnSpPr>
        <p:spPr>
          <a:xfrm>
            <a:off x="0" y="3061252"/>
            <a:ext cx="626427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Rectangle 44"/>
          <p:cNvSpPr/>
          <p:nvPr/>
        </p:nvSpPr>
        <p:spPr>
          <a:xfrm>
            <a:off x="1913815" y="4210263"/>
            <a:ext cx="2324805" cy="52138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C(16:0_22:5)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atch score: 75 </a:t>
            </a:r>
          </a:p>
        </p:txBody>
      </p:sp>
      <p:sp>
        <p:nvSpPr>
          <p:cNvPr id="46" name="Rectangle 45"/>
          <p:cNvSpPr/>
          <p:nvPr/>
        </p:nvSpPr>
        <p:spPr>
          <a:xfrm>
            <a:off x="1085427" y="5331146"/>
            <a:ext cx="849587" cy="3128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:0</a:t>
            </a:r>
            <a:endParaRPr lang="en-US" sz="12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1573923" y="5319671"/>
            <a:ext cx="849587" cy="3128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:5</a:t>
            </a:r>
            <a:endParaRPr lang="en-US" sz="1200" baseline="300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Straight Connector 47"/>
          <p:cNvCxnSpPr/>
          <p:nvPr/>
        </p:nvCxnSpPr>
        <p:spPr>
          <a:xfrm>
            <a:off x="0" y="5728252"/>
            <a:ext cx="626427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391903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0"/>
            <a:ext cx="6264275" cy="318103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" y="3264590"/>
            <a:ext cx="6264275" cy="31543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45778" y="6449538"/>
            <a:ext cx="55567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2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tch Details view, showing two panels for the annotation of TG(16:0_16:1_18:1)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d18:1/18:0)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76707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-1" y="689693"/>
            <a:ext cx="6264275" cy="5538581"/>
            <a:chOff x="-1" y="689693"/>
            <a:chExt cx="6264275" cy="553858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1" y="4150800"/>
              <a:ext cx="6264275" cy="2077474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1" y="2120911"/>
              <a:ext cx="6264275" cy="1931012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1" y="689693"/>
              <a:ext cx="6264275" cy="1188209"/>
            </a:xfrm>
            <a:prstGeom prst="rect">
              <a:avLst/>
            </a:prstGeom>
          </p:spPr>
        </p:pic>
      </p:grpSp>
      <p:sp>
        <p:nvSpPr>
          <p:cNvPr id="9" name="TextBox 8"/>
          <p:cNvSpPr txBox="1"/>
          <p:nvPr/>
        </p:nvSpPr>
        <p:spPr>
          <a:xfrm>
            <a:off x="0" y="669699"/>
            <a:ext cx="202914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ipid Constituents Tabl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0" y="2082330"/>
            <a:ext cx="3736216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ragment Spectrum Viewer: TG(16:0_16:1_18:1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0" y="4145592"/>
            <a:ext cx="3736216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ragment Spectrum Viewer: TG(14:0_18:1_18:1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-45778" y="6208378"/>
            <a:ext cx="55567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ipid constituents table (A), showing two triglycerides (TG) annotated for the same feature (B and C) 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i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rcent abundance score. 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38549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0" name="Picture 19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060" y="195463"/>
            <a:ext cx="13905868" cy="733739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0193" y="3516922"/>
            <a:ext cx="60139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4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lipid dense region of the mass spectru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750-765) without (A) and with (B) peak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turation. The figure shows that lower abundant ions can be observed when the sample is concentrated which would not have been observed otherwise. </a:t>
            </a:r>
          </a:p>
        </p:txBody>
      </p:sp>
      <p:sp>
        <p:nvSpPr>
          <p:cNvPr id="383" name="TextBox 382"/>
          <p:cNvSpPr txBox="1"/>
          <p:nvPr/>
        </p:nvSpPr>
        <p:spPr>
          <a:xfrm>
            <a:off x="502920" y="304800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)</a:t>
            </a:r>
            <a:endParaRPr lang="en-US" dirty="0"/>
          </a:p>
        </p:txBody>
      </p:sp>
      <p:sp>
        <p:nvSpPr>
          <p:cNvPr id="384" name="TextBox 383"/>
          <p:cNvSpPr txBox="1"/>
          <p:nvPr/>
        </p:nvSpPr>
        <p:spPr>
          <a:xfrm>
            <a:off x="487680" y="1684020"/>
            <a:ext cx="396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01513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FF7DF71C-3B52-4436-8F7F-53F6B076DE7A}"/>
              </a:ext>
            </a:extLst>
          </p:cNvPr>
          <p:cNvSpPr txBox="1"/>
          <p:nvPr/>
        </p:nvSpPr>
        <p:spPr>
          <a:xfrm>
            <a:off x="125167" y="6473164"/>
            <a:ext cx="60139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: Mass accuracy versus abundance (intensity) of ions. Mass accuracy is consistently within 5 ppm on the Agilent 6546 even when peaks are saturated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Chart 2">
            <a:extLst>
              <a:ext uri="{FF2B5EF4-FFF2-40B4-BE49-F238E27FC236}">
                <a16:creationId xmlns="" xmlns:a16="http://schemas.microsoft.com/office/drawing/2014/main" id="{FF06253E-4432-4C02-8510-A4E771850011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45431" y="305130"/>
          <a:ext cx="5341854" cy="27716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="" xmlns:a16="http://schemas.microsoft.com/office/drawing/2014/main" id="{2796B48C-0EBB-49BD-9A35-3BA7675ACB48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45431" y="3471062"/>
          <a:ext cx="5341854" cy="27716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5189345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1" name="Group 100"/>
          <p:cNvGrpSpPr/>
          <p:nvPr/>
        </p:nvGrpSpPr>
        <p:grpSpPr>
          <a:xfrm>
            <a:off x="0" y="211829"/>
            <a:ext cx="8859475" cy="5382732"/>
            <a:chOff x="0" y="0"/>
            <a:chExt cx="10805115" cy="656484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259291"/>
              <a:ext cx="4181475" cy="6305550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22887" y="1849488"/>
              <a:ext cx="3373437" cy="1500304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22887" y="3437962"/>
              <a:ext cx="3373437" cy="1500304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22887" y="261014"/>
              <a:ext cx="3373437" cy="1500304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22887" y="5026437"/>
              <a:ext cx="3373437" cy="1500304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2143958" y="4980818"/>
              <a:ext cx="360119" cy="394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/>
                <a:t>A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693081" y="580571"/>
              <a:ext cx="352299" cy="394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/>
                <a:t>B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039005" y="5140477"/>
              <a:ext cx="350343" cy="394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/>
                <a:t>C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680052" y="5873448"/>
              <a:ext cx="369893" cy="394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/>
                <a:t>D</a:t>
              </a:r>
            </a:p>
          </p:txBody>
        </p:sp>
        <p:grpSp>
          <p:nvGrpSpPr>
            <p:cNvPr id="11" name="Group 4"/>
            <p:cNvGrpSpPr>
              <a:grpSpLocks noChangeAspect="1"/>
            </p:cNvGrpSpPr>
            <p:nvPr/>
          </p:nvGrpSpPr>
          <p:grpSpPr bwMode="auto">
            <a:xfrm>
              <a:off x="7723777" y="5067906"/>
              <a:ext cx="3081338" cy="1300057"/>
              <a:chOff x="4811" y="2267"/>
              <a:chExt cx="2200" cy="547"/>
            </a:xfrm>
          </p:grpSpPr>
          <p:sp>
            <p:nvSpPr>
              <p:cNvPr id="12" name="Line 5"/>
              <p:cNvSpPr>
                <a:spLocks noChangeShapeType="1"/>
              </p:cNvSpPr>
              <p:nvPr/>
            </p:nvSpPr>
            <p:spPr bwMode="auto">
              <a:xfrm flipV="1">
                <a:off x="4857" y="2319"/>
                <a:ext cx="0" cy="421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13" name="Rectangle 6"/>
              <p:cNvSpPr>
                <a:spLocks noChangeArrowheads="1"/>
              </p:cNvSpPr>
              <p:nvPr/>
            </p:nvSpPr>
            <p:spPr bwMode="auto">
              <a:xfrm>
                <a:off x="4841" y="2277"/>
                <a:ext cx="21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4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4" name="Rectangle 7"/>
              <p:cNvSpPr>
                <a:spLocks noChangeArrowheads="1"/>
              </p:cNvSpPr>
              <p:nvPr/>
            </p:nvSpPr>
            <p:spPr bwMode="auto">
              <a:xfrm>
                <a:off x="4811" y="2281"/>
                <a:ext cx="60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x10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5" name="Line 8"/>
              <p:cNvSpPr>
                <a:spLocks noChangeShapeType="1"/>
              </p:cNvSpPr>
              <p:nvPr/>
            </p:nvSpPr>
            <p:spPr bwMode="auto">
              <a:xfrm flipH="1">
                <a:off x="4851" y="2722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16" name="Rectangle 9"/>
              <p:cNvSpPr>
                <a:spLocks noChangeArrowheads="1"/>
              </p:cNvSpPr>
              <p:nvPr/>
            </p:nvSpPr>
            <p:spPr bwMode="auto">
              <a:xfrm>
                <a:off x="4827" y="2706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0.2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7" name="Line 10"/>
              <p:cNvSpPr>
                <a:spLocks noChangeShapeType="1"/>
              </p:cNvSpPr>
              <p:nvPr/>
            </p:nvSpPr>
            <p:spPr bwMode="auto">
              <a:xfrm flipH="1">
                <a:off x="4851" y="2690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18" name="Rectangle 11"/>
              <p:cNvSpPr>
                <a:spLocks noChangeArrowheads="1"/>
              </p:cNvSpPr>
              <p:nvPr/>
            </p:nvSpPr>
            <p:spPr bwMode="auto">
              <a:xfrm>
                <a:off x="4827" y="2674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0.4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9" name="Line 12"/>
              <p:cNvSpPr>
                <a:spLocks noChangeShapeType="1"/>
              </p:cNvSpPr>
              <p:nvPr/>
            </p:nvSpPr>
            <p:spPr bwMode="auto">
              <a:xfrm flipH="1">
                <a:off x="4851" y="2658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20" name="Rectangle 13"/>
              <p:cNvSpPr>
                <a:spLocks noChangeArrowheads="1"/>
              </p:cNvSpPr>
              <p:nvPr/>
            </p:nvSpPr>
            <p:spPr bwMode="auto">
              <a:xfrm>
                <a:off x="4827" y="2642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0.6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1" name="Line 14"/>
              <p:cNvSpPr>
                <a:spLocks noChangeShapeType="1"/>
              </p:cNvSpPr>
              <p:nvPr/>
            </p:nvSpPr>
            <p:spPr bwMode="auto">
              <a:xfrm flipH="1">
                <a:off x="4851" y="2624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22" name="Rectangle 15"/>
              <p:cNvSpPr>
                <a:spLocks noChangeArrowheads="1"/>
              </p:cNvSpPr>
              <p:nvPr/>
            </p:nvSpPr>
            <p:spPr bwMode="auto">
              <a:xfrm>
                <a:off x="4827" y="2608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0.8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3" name="Line 16"/>
              <p:cNvSpPr>
                <a:spLocks noChangeShapeType="1"/>
              </p:cNvSpPr>
              <p:nvPr/>
            </p:nvSpPr>
            <p:spPr bwMode="auto">
              <a:xfrm flipH="1">
                <a:off x="4851" y="2593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24" name="Rectangle 17"/>
              <p:cNvSpPr>
                <a:spLocks noChangeArrowheads="1"/>
              </p:cNvSpPr>
              <p:nvPr/>
            </p:nvSpPr>
            <p:spPr bwMode="auto">
              <a:xfrm>
                <a:off x="4840" y="2577"/>
                <a:ext cx="21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1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5" name="Line 18"/>
              <p:cNvSpPr>
                <a:spLocks noChangeShapeType="1"/>
              </p:cNvSpPr>
              <p:nvPr/>
            </p:nvSpPr>
            <p:spPr bwMode="auto">
              <a:xfrm flipH="1">
                <a:off x="4851" y="2561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26" name="Rectangle 19"/>
              <p:cNvSpPr>
                <a:spLocks noChangeArrowheads="1"/>
              </p:cNvSpPr>
              <p:nvPr/>
            </p:nvSpPr>
            <p:spPr bwMode="auto">
              <a:xfrm>
                <a:off x="4827" y="2545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1.2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7" name="Line 20"/>
              <p:cNvSpPr>
                <a:spLocks noChangeShapeType="1"/>
              </p:cNvSpPr>
              <p:nvPr/>
            </p:nvSpPr>
            <p:spPr bwMode="auto">
              <a:xfrm flipH="1">
                <a:off x="4851" y="2529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28" name="Rectangle 21"/>
              <p:cNvSpPr>
                <a:spLocks noChangeArrowheads="1"/>
              </p:cNvSpPr>
              <p:nvPr/>
            </p:nvSpPr>
            <p:spPr bwMode="auto">
              <a:xfrm>
                <a:off x="4827" y="2513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1.4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29" name="Line 22"/>
              <p:cNvSpPr>
                <a:spLocks noChangeShapeType="1"/>
              </p:cNvSpPr>
              <p:nvPr/>
            </p:nvSpPr>
            <p:spPr bwMode="auto">
              <a:xfrm flipH="1">
                <a:off x="4851" y="2497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30" name="Rectangle 23"/>
              <p:cNvSpPr>
                <a:spLocks noChangeArrowheads="1"/>
              </p:cNvSpPr>
              <p:nvPr/>
            </p:nvSpPr>
            <p:spPr bwMode="auto">
              <a:xfrm>
                <a:off x="4827" y="2481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1.6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1" name="Line 24"/>
              <p:cNvSpPr>
                <a:spLocks noChangeShapeType="1"/>
              </p:cNvSpPr>
              <p:nvPr/>
            </p:nvSpPr>
            <p:spPr bwMode="auto">
              <a:xfrm flipH="1">
                <a:off x="4851" y="2463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32" name="Rectangle 25"/>
              <p:cNvSpPr>
                <a:spLocks noChangeArrowheads="1"/>
              </p:cNvSpPr>
              <p:nvPr/>
            </p:nvSpPr>
            <p:spPr bwMode="auto">
              <a:xfrm>
                <a:off x="4827" y="2447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1.8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3" name="Line 26"/>
              <p:cNvSpPr>
                <a:spLocks noChangeShapeType="1"/>
              </p:cNvSpPr>
              <p:nvPr/>
            </p:nvSpPr>
            <p:spPr bwMode="auto">
              <a:xfrm flipH="1">
                <a:off x="4851" y="2431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34" name="Rectangle 27"/>
              <p:cNvSpPr>
                <a:spLocks noChangeArrowheads="1"/>
              </p:cNvSpPr>
              <p:nvPr/>
            </p:nvSpPr>
            <p:spPr bwMode="auto">
              <a:xfrm>
                <a:off x="4840" y="2415"/>
                <a:ext cx="21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2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5" name="Line 28"/>
              <p:cNvSpPr>
                <a:spLocks noChangeShapeType="1"/>
              </p:cNvSpPr>
              <p:nvPr/>
            </p:nvSpPr>
            <p:spPr bwMode="auto">
              <a:xfrm flipH="1">
                <a:off x="4851" y="2399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36" name="Rectangle 29"/>
              <p:cNvSpPr>
                <a:spLocks noChangeArrowheads="1"/>
              </p:cNvSpPr>
              <p:nvPr/>
            </p:nvSpPr>
            <p:spPr bwMode="auto">
              <a:xfrm>
                <a:off x="4827" y="2383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2.2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7" name="Line 30"/>
              <p:cNvSpPr>
                <a:spLocks noChangeShapeType="1"/>
              </p:cNvSpPr>
              <p:nvPr/>
            </p:nvSpPr>
            <p:spPr bwMode="auto">
              <a:xfrm flipH="1">
                <a:off x="4851" y="2367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38" name="Rectangle 31"/>
              <p:cNvSpPr>
                <a:spLocks noChangeArrowheads="1"/>
              </p:cNvSpPr>
              <p:nvPr/>
            </p:nvSpPr>
            <p:spPr bwMode="auto">
              <a:xfrm>
                <a:off x="4827" y="2351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2.4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39" name="Line 32"/>
              <p:cNvSpPr>
                <a:spLocks noChangeShapeType="1"/>
              </p:cNvSpPr>
              <p:nvPr/>
            </p:nvSpPr>
            <p:spPr bwMode="auto">
              <a:xfrm flipH="1">
                <a:off x="4851" y="2335"/>
                <a:ext cx="6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40" name="Rectangle 33"/>
              <p:cNvSpPr>
                <a:spLocks noChangeArrowheads="1"/>
              </p:cNvSpPr>
              <p:nvPr/>
            </p:nvSpPr>
            <p:spPr bwMode="auto">
              <a:xfrm>
                <a:off x="4827" y="2319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2.6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41" name="Rectangle 34"/>
              <p:cNvSpPr>
                <a:spLocks noChangeArrowheads="1"/>
              </p:cNvSpPr>
              <p:nvPr/>
            </p:nvSpPr>
            <p:spPr bwMode="auto">
              <a:xfrm>
                <a:off x="4858" y="2267"/>
                <a:ext cx="2134" cy="48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42" name="Rectangle 35"/>
              <p:cNvSpPr>
                <a:spLocks noChangeArrowheads="1"/>
              </p:cNvSpPr>
              <p:nvPr/>
            </p:nvSpPr>
            <p:spPr bwMode="auto">
              <a:xfrm>
                <a:off x="4861" y="2319"/>
                <a:ext cx="2127" cy="42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43" name="Rectangle 36"/>
              <p:cNvSpPr>
                <a:spLocks noChangeArrowheads="1"/>
              </p:cNvSpPr>
              <p:nvPr/>
            </p:nvSpPr>
            <p:spPr bwMode="auto">
              <a:xfrm>
                <a:off x="4864" y="2279"/>
                <a:ext cx="1209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+ESI EIC(522.3555) Scan Frag=150.0V 05_Plasma_Pos_Iterative-r001.d 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44" name="Freeform 41"/>
              <p:cNvSpPr>
                <a:spLocks/>
              </p:cNvSpPr>
              <p:nvPr/>
            </p:nvSpPr>
            <p:spPr bwMode="auto">
              <a:xfrm>
                <a:off x="4876" y="2319"/>
                <a:ext cx="2112" cy="383"/>
              </a:xfrm>
              <a:custGeom>
                <a:avLst/>
                <a:gdLst>
                  <a:gd name="T0" fmla="*/ 0 w 2112"/>
                  <a:gd name="T1" fmla="*/ 0 h 383"/>
                  <a:gd name="T2" fmla="*/ 27 w 2112"/>
                  <a:gd name="T3" fmla="*/ 35 h 383"/>
                  <a:gd name="T4" fmla="*/ 123 w 2112"/>
                  <a:gd name="T5" fmla="*/ 106 h 383"/>
                  <a:gd name="T6" fmla="*/ 201 w 2112"/>
                  <a:gd name="T7" fmla="*/ 89 h 383"/>
                  <a:gd name="T8" fmla="*/ 312 w 2112"/>
                  <a:gd name="T9" fmla="*/ 168 h 383"/>
                  <a:gd name="T10" fmla="*/ 408 w 2112"/>
                  <a:gd name="T11" fmla="*/ 126 h 383"/>
                  <a:gd name="T12" fmla="*/ 484 w 2112"/>
                  <a:gd name="T13" fmla="*/ 179 h 383"/>
                  <a:gd name="T14" fmla="*/ 598 w 2112"/>
                  <a:gd name="T15" fmla="*/ 182 h 383"/>
                  <a:gd name="T16" fmla="*/ 733 w 2112"/>
                  <a:gd name="T17" fmla="*/ 167 h 383"/>
                  <a:gd name="T18" fmla="*/ 854 w 2112"/>
                  <a:gd name="T19" fmla="*/ 242 h 383"/>
                  <a:gd name="T20" fmla="*/ 984 w 2112"/>
                  <a:gd name="T21" fmla="*/ 344 h 383"/>
                  <a:gd name="T22" fmla="*/ 1110 w 2112"/>
                  <a:gd name="T23" fmla="*/ 336 h 383"/>
                  <a:gd name="T24" fmla="*/ 1235 w 2112"/>
                  <a:gd name="T25" fmla="*/ 343 h 383"/>
                  <a:gd name="T26" fmla="*/ 1360 w 2112"/>
                  <a:gd name="T27" fmla="*/ 297 h 383"/>
                  <a:gd name="T28" fmla="*/ 1474 w 2112"/>
                  <a:gd name="T29" fmla="*/ 265 h 383"/>
                  <a:gd name="T30" fmla="*/ 1587 w 2112"/>
                  <a:gd name="T31" fmla="*/ 326 h 383"/>
                  <a:gd name="T32" fmla="*/ 1706 w 2112"/>
                  <a:gd name="T33" fmla="*/ 383 h 383"/>
                  <a:gd name="T34" fmla="*/ 1821 w 2112"/>
                  <a:gd name="T35" fmla="*/ 356 h 383"/>
                  <a:gd name="T36" fmla="*/ 1933 w 2112"/>
                  <a:gd name="T37" fmla="*/ 358 h 383"/>
                  <a:gd name="T38" fmla="*/ 2055 w 2112"/>
                  <a:gd name="T39" fmla="*/ 378 h 383"/>
                  <a:gd name="T40" fmla="*/ 2112 w 2112"/>
                  <a:gd name="T41" fmla="*/ 380 h 3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2112" h="383">
                    <a:moveTo>
                      <a:pt x="0" y="0"/>
                    </a:moveTo>
                    <a:lnTo>
                      <a:pt x="27" y="35"/>
                    </a:lnTo>
                    <a:lnTo>
                      <a:pt x="123" y="106"/>
                    </a:lnTo>
                    <a:lnTo>
                      <a:pt x="201" y="89"/>
                    </a:lnTo>
                    <a:lnTo>
                      <a:pt x="312" y="168"/>
                    </a:lnTo>
                    <a:lnTo>
                      <a:pt x="408" y="126"/>
                    </a:lnTo>
                    <a:lnTo>
                      <a:pt x="484" y="179"/>
                    </a:lnTo>
                    <a:lnTo>
                      <a:pt x="598" y="182"/>
                    </a:lnTo>
                    <a:lnTo>
                      <a:pt x="733" y="167"/>
                    </a:lnTo>
                    <a:lnTo>
                      <a:pt x="854" y="242"/>
                    </a:lnTo>
                    <a:lnTo>
                      <a:pt x="984" y="344"/>
                    </a:lnTo>
                    <a:lnTo>
                      <a:pt x="1110" y="336"/>
                    </a:lnTo>
                    <a:lnTo>
                      <a:pt x="1235" y="343"/>
                    </a:lnTo>
                    <a:lnTo>
                      <a:pt x="1360" y="297"/>
                    </a:lnTo>
                    <a:lnTo>
                      <a:pt x="1474" y="265"/>
                    </a:lnTo>
                    <a:lnTo>
                      <a:pt x="1587" y="326"/>
                    </a:lnTo>
                    <a:lnTo>
                      <a:pt x="1706" y="383"/>
                    </a:lnTo>
                    <a:lnTo>
                      <a:pt x="1821" y="356"/>
                    </a:lnTo>
                    <a:lnTo>
                      <a:pt x="1933" y="358"/>
                    </a:lnTo>
                    <a:lnTo>
                      <a:pt x="2055" y="378"/>
                    </a:lnTo>
                    <a:lnTo>
                      <a:pt x="2112" y="380"/>
                    </a:lnTo>
                  </a:path>
                </a:pathLst>
              </a:custGeom>
              <a:noFill/>
              <a:ln w="0" cap="flat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45" name="Rectangle 42"/>
              <p:cNvSpPr>
                <a:spLocks noChangeArrowheads="1"/>
              </p:cNvSpPr>
              <p:nvPr/>
            </p:nvSpPr>
            <p:spPr bwMode="auto">
              <a:xfrm>
                <a:off x="4860" y="2269"/>
                <a:ext cx="2131" cy="481"/>
              </a:xfrm>
              <a:prstGeom prst="rect">
                <a:avLst/>
              </a:prstGeom>
              <a:noFill/>
              <a:ln w="4763" cap="flat">
                <a:solidFill>
                  <a:srgbClr val="316AC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46" name="Rectangle 43"/>
              <p:cNvSpPr>
                <a:spLocks noChangeArrowheads="1"/>
              </p:cNvSpPr>
              <p:nvPr/>
            </p:nvSpPr>
            <p:spPr bwMode="auto">
              <a:xfrm>
                <a:off x="5803" y="2788"/>
                <a:ext cx="549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Counts vs. Acquisition Time (min)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47" name="Line 44"/>
              <p:cNvSpPr>
                <a:spLocks noChangeShapeType="1"/>
              </p:cNvSpPr>
              <p:nvPr/>
            </p:nvSpPr>
            <p:spPr bwMode="auto">
              <a:xfrm>
                <a:off x="4861" y="2754"/>
                <a:ext cx="2127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48" name="Line 45"/>
              <p:cNvSpPr>
                <a:spLocks noChangeShapeType="1"/>
              </p:cNvSpPr>
              <p:nvPr/>
            </p:nvSpPr>
            <p:spPr bwMode="auto">
              <a:xfrm>
                <a:off x="4884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49" name="Rectangle 46"/>
              <p:cNvSpPr>
                <a:spLocks noChangeArrowheads="1"/>
              </p:cNvSpPr>
              <p:nvPr/>
            </p:nvSpPr>
            <p:spPr bwMode="auto">
              <a:xfrm>
                <a:off x="4868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2.97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0" name="Line 47"/>
              <p:cNvSpPr>
                <a:spLocks noChangeShapeType="1"/>
              </p:cNvSpPr>
              <p:nvPr/>
            </p:nvSpPr>
            <p:spPr bwMode="auto">
              <a:xfrm>
                <a:off x="4978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51" name="Rectangle 48"/>
              <p:cNvSpPr>
                <a:spLocks noChangeArrowheads="1"/>
              </p:cNvSpPr>
              <p:nvPr/>
            </p:nvSpPr>
            <p:spPr bwMode="auto">
              <a:xfrm>
                <a:off x="4962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2.98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2" name="Line 49"/>
              <p:cNvSpPr>
                <a:spLocks noChangeShapeType="1"/>
              </p:cNvSpPr>
              <p:nvPr/>
            </p:nvSpPr>
            <p:spPr bwMode="auto">
              <a:xfrm>
                <a:off x="5073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53" name="Rectangle 50"/>
              <p:cNvSpPr>
                <a:spLocks noChangeArrowheads="1"/>
              </p:cNvSpPr>
              <p:nvPr/>
            </p:nvSpPr>
            <p:spPr bwMode="auto">
              <a:xfrm>
                <a:off x="5057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2.99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4" name="Line 51"/>
              <p:cNvSpPr>
                <a:spLocks noChangeShapeType="1"/>
              </p:cNvSpPr>
              <p:nvPr/>
            </p:nvSpPr>
            <p:spPr bwMode="auto">
              <a:xfrm>
                <a:off x="5167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55" name="Rectangle 52"/>
              <p:cNvSpPr>
                <a:spLocks noChangeArrowheads="1"/>
              </p:cNvSpPr>
              <p:nvPr/>
            </p:nvSpPr>
            <p:spPr bwMode="auto">
              <a:xfrm>
                <a:off x="5163" y="2760"/>
                <a:ext cx="21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6" name="Line 53"/>
              <p:cNvSpPr>
                <a:spLocks noChangeShapeType="1"/>
              </p:cNvSpPr>
              <p:nvPr/>
            </p:nvSpPr>
            <p:spPr bwMode="auto">
              <a:xfrm>
                <a:off x="5261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57" name="Rectangle 54"/>
              <p:cNvSpPr>
                <a:spLocks noChangeArrowheads="1"/>
              </p:cNvSpPr>
              <p:nvPr/>
            </p:nvSpPr>
            <p:spPr bwMode="auto">
              <a:xfrm>
                <a:off x="5245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01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58" name="Line 55"/>
              <p:cNvSpPr>
                <a:spLocks noChangeShapeType="1"/>
              </p:cNvSpPr>
              <p:nvPr/>
            </p:nvSpPr>
            <p:spPr bwMode="auto">
              <a:xfrm>
                <a:off x="5355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59" name="Rectangle 56"/>
              <p:cNvSpPr>
                <a:spLocks noChangeArrowheads="1"/>
              </p:cNvSpPr>
              <p:nvPr/>
            </p:nvSpPr>
            <p:spPr bwMode="auto">
              <a:xfrm>
                <a:off x="5339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02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0" name="Line 57"/>
              <p:cNvSpPr>
                <a:spLocks noChangeShapeType="1"/>
              </p:cNvSpPr>
              <p:nvPr/>
            </p:nvSpPr>
            <p:spPr bwMode="auto">
              <a:xfrm>
                <a:off x="5448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61" name="Rectangle 58"/>
              <p:cNvSpPr>
                <a:spLocks noChangeArrowheads="1"/>
              </p:cNvSpPr>
              <p:nvPr/>
            </p:nvSpPr>
            <p:spPr bwMode="auto">
              <a:xfrm>
                <a:off x="5433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03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2" name="Line 59"/>
              <p:cNvSpPr>
                <a:spLocks noChangeShapeType="1"/>
              </p:cNvSpPr>
              <p:nvPr/>
            </p:nvSpPr>
            <p:spPr bwMode="auto">
              <a:xfrm>
                <a:off x="5544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63" name="Rectangle 60"/>
              <p:cNvSpPr>
                <a:spLocks noChangeArrowheads="1"/>
              </p:cNvSpPr>
              <p:nvPr/>
            </p:nvSpPr>
            <p:spPr bwMode="auto">
              <a:xfrm>
                <a:off x="5528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04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4" name="Line 61"/>
              <p:cNvSpPr>
                <a:spLocks noChangeShapeType="1"/>
              </p:cNvSpPr>
              <p:nvPr/>
            </p:nvSpPr>
            <p:spPr bwMode="auto">
              <a:xfrm>
                <a:off x="5638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65" name="Rectangle 62"/>
              <p:cNvSpPr>
                <a:spLocks noChangeArrowheads="1"/>
              </p:cNvSpPr>
              <p:nvPr/>
            </p:nvSpPr>
            <p:spPr bwMode="auto">
              <a:xfrm>
                <a:off x="5622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05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6" name="Line 63"/>
              <p:cNvSpPr>
                <a:spLocks noChangeShapeType="1"/>
              </p:cNvSpPr>
              <p:nvPr/>
            </p:nvSpPr>
            <p:spPr bwMode="auto">
              <a:xfrm>
                <a:off x="5731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67" name="Rectangle 64"/>
              <p:cNvSpPr>
                <a:spLocks noChangeArrowheads="1"/>
              </p:cNvSpPr>
              <p:nvPr/>
            </p:nvSpPr>
            <p:spPr bwMode="auto">
              <a:xfrm>
                <a:off x="5715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06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8" name="Line 65"/>
              <p:cNvSpPr>
                <a:spLocks noChangeShapeType="1"/>
              </p:cNvSpPr>
              <p:nvPr/>
            </p:nvSpPr>
            <p:spPr bwMode="auto">
              <a:xfrm>
                <a:off x="5825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69" name="Rectangle 66"/>
              <p:cNvSpPr>
                <a:spLocks noChangeArrowheads="1"/>
              </p:cNvSpPr>
              <p:nvPr/>
            </p:nvSpPr>
            <p:spPr bwMode="auto">
              <a:xfrm>
                <a:off x="5809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07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70" name="Line 67"/>
              <p:cNvSpPr>
                <a:spLocks noChangeShapeType="1"/>
              </p:cNvSpPr>
              <p:nvPr/>
            </p:nvSpPr>
            <p:spPr bwMode="auto">
              <a:xfrm>
                <a:off x="5919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71" name="Rectangle 68"/>
              <p:cNvSpPr>
                <a:spLocks noChangeArrowheads="1"/>
              </p:cNvSpPr>
              <p:nvPr/>
            </p:nvSpPr>
            <p:spPr bwMode="auto">
              <a:xfrm>
                <a:off x="5903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08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72" name="Line 69"/>
              <p:cNvSpPr>
                <a:spLocks noChangeShapeType="1"/>
              </p:cNvSpPr>
              <p:nvPr/>
            </p:nvSpPr>
            <p:spPr bwMode="auto">
              <a:xfrm>
                <a:off x="6014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73" name="Rectangle 70"/>
              <p:cNvSpPr>
                <a:spLocks noChangeArrowheads="1"/>
              </p:cNvSpPr>
              <p:nvPr/>
            </p:nvSpPr>
            <p:spPr bwMode="auto">
              <a:xfrm>
                <a:off x="5998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09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74" name="Line 71"/>
              <p:cNvSpPr>
                <a:spLocks noChangeShapeType="1"/>
              </p:cNvSpPr>
              <p:nvPr/>
            </p:nvSpPr>
            <p:spPr bwMode="auto">
              <a:xfrm>
                <a:off x="6108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75" name="Rectangle 72"/>
              <p:cNvSpPr>
                <a:spLocks noChangeArrowheads="1"/>
              </p:cNvSpPr>
              <p:nvPr/>
            </p:nvSpPr>
            <p:spPr bwMode="auto">
              <a:xfrm>
                <a:off x="6096" y="2760"/>
                <a:ext cx="5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1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76" name="Line 73"/>
              <p:cNvSpPr>
                <a:spLocks noChangeShapeType="1"/>
              </p:cNvSpPr>
              <p:nvPr/>
            </p:nvSpPr>
            <p:spPr bwMode="auto">
              <a:xfrm>
                <a:off x="6202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77" name="Rectangle 74"/>
              <p:cNvSpPr>
                <a:spLocks noChangeArrowheads="1"/>
              </p:cNvSpPr>
              <p:nvPr/>
            </p:nvSpPr>
            <p:spPr bwMode="auto">
              <a:xfrm>
                <a:off x="6186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11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78" name="Line 75"/>
              <p:cNvSpPr>
                <a:spLocks noChangeShapeType="1"/>
              </p:cNvSpPr>
              <p:nvPr/>
            </p:nvSpPr>
            <p:spPr bwMode="auto">
              <a:xfrm>
                <a:off x="6295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79" name="Rectangle 76"/>
              <p:cNvSpPr>
                <a:spLocks noChangeArrowheads="1"/>
              </p:cNvSpPr>
              <p:nvPr/>
            </p:nvSpPr>
            <p:spPr bwMode="auto">
              <a:xfrm>
                <a:off x="6280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12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80" name="Line 77"/>
              <p:cNvSpPr>
                <a:spLocks noChangeShapeType="1"/>
              </p:cNvSpPr>
              <p:nvPr/>
            </p:nvSpPr>
            <p:spPr bwMode="auto">
              <a:xfrm>
                <a:off x="6389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81" name="Rectangle 78"/>
              <p:cNvSpPr>
                <a:spLocks noChangeArrowheads="1"/>
              </p:cNvSpPr>
              <p:nvPr/>
            </p:nvSpPr>
            <p:spPr bwMode="auto">
              <a:xfrm>
                <a:off x="6373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13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82" name="Line 79"/>
              <p:cNvSpPr>
                <a:spLocks noChangeShapeType="1"/>
              </p:cNvSpPr>
              <p:nvPr/>
            </p:nvSpPr>
            <p:spPr bwMode="auto">
              <a:xfrm>
                <a:off x="6484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83" name="Rectangle 80"/>
              <p:cNvSpPr>
                <a:spLocks noChangeArrowheads="1"/>
              </p:cNvSpPr>
              <p:nvPr/>
            </p:nvSpPr>
            <p:spPr bwMode="auto">
              <a:xfrm>
                <a:off x="6469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14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84" name="Line 81"/>
              <p:cNvSpPr>
                <a:spLocks noChangeShapeType="1"/>
              </p:cNvSpPr>
              <p:nvPr/>
            </p:nvSpPr>
            <p:spPr bwMode="auto">
              <a:xfrm>
                <a:off x="6578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85" name="Rectangle 82"/>
              <p:cNvSpPr>
                <a:spLocks noChangeArrowheads="1"/>
              </p:cNvSpPr>
              <p:nvPr/>
            </p:nvSpPr>
            <p:spPr bwMode="auto">
              <a:xfrm>
                <a:off x="6562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15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86" name="Line 83"/>
              <p:cNvSpPr>
                <a:spLocks noChangeShapeType="1"/>
              </p:cNvSpPr>
              <p:nvPr/>
            </p:nvSpPr>
            <p:spPr bwMode="auto">
              <a:xfrm>
                <a:off x="6672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87" name="Rectangle 84"/>
              <p:cNvSpPr>
                <a:spLocks noChangeArrowheads="1"/>
              </p:cNvSpPr>
              <p:nvPr/>
            </p:nvSpPr>
            <p:spPr bwMode="auto">
              <a:xfrm>
                <a:off x="6656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16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88" name="Line 85"/>
              <p:cNvSpPr>
                <a:spLocks noChangeShapeType="1"/>
              </p:cNvSpPr>
              <p:nvPr/>
            </p:nvSpPr>
            <p:spPr bwMode="auto">
              <a:xfrm>
                <a:off x="6766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89" name="Rectangle 86"/>
              <p:cNvSpPr>
                <a:spLocks noChangeArrowheads="1"/>
              </p:cNvSpPr>
              <p:nvPr/>
            </p:nvSpPr>
            <p:spPr bwMode="auto">
              <a:xfrm>
                <a:off x="6750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17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90" name="Line 87"/>
              <p:cNvSpPr>
                <a:spLocks noChangeShapeType="1"/>
              </p:cNvSpPr>
              <p:nvPr/>
            </p:nvSpPr>
            <p:spPr bwMode="auto">
              <a:xfrm>
                <a:off x="6860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91" name="Rectangle 88"/>
              <p:cNvSpPr>
                <a:spLocks noChangeArrowheads="1"/>
              </p:cNvSpPr>
              <p:nvPr/>
            </p:nvSpPr>
            <p:spPr bwMode="auto">
              <a:xfrm>
                <a:off x="6844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18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92" name="Line 89"/>
              <p:cNvSpPr>
                <a:spLocks noChangeShapeType="1"/>
              </p:cNvSpPr>
              <p:nvPr/>
            </p:nvSpPr>
            <p:spPr bwMode="auto">
              <a:xfrm>
                <a:off x="6955" y="2754"/>
                <a:ext cx="0" cy="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00"/>
              </a:p>
            </p:txBody>
          </p:sp>
          <p:sp>
            <p:nvSpPr>
              <p:cNvPr id="93" name="Rectangle 90"/>
              <p:cNvSpPr>
                <a:spLocks noChangeArrowheads="1"/>
              </p:cNvSpPr>
              <p:nvPr/>
            </p:nvSpPr>
            <p:spPr bwMode="auto">
              <a:xfrm>
                <a:off x="6939" y="2760"/>
                <a:ext cx="72" cy="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icrosoft Sans Serif" panose="020B0604020202020204" pitchFamily="34" charset="0"/>
                  </a:rPr>
                  <a:t>3.19</a:t>
                </a:r>
                <a:endParaRPr kumimoji="0" lang="en-US" altLang="en-US" sz="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</p:grpSp>
        <p:sp>
          <p:nvSpPr>
            <p:cNvPr id="94" name="TextBox 93"/>
            <p:cNvSpPr txBox="1"/>
            <p:nvPr/>
          </p:nvSpPr>
          <p:spPr>
            <a:xfrm>
              <a:off x="4513174" y="0"/>
              <a:ext cx="1814669" cy="394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/>
                <a:t>A   LPC(18:1/0:0)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4513174" y="1598991"/>
              <a:ext cx="1806849" cy="394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/>
                <a:t>B   LPC(0:0/18:1)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4513174" y="3173791"/>
              <a:ext cx="1804893" cy="394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/>
                <a:t>C   LPC(0:0/18:1)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4513174" y="4767943"/>
              <a:ext cx="1824443" cy="3941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/>
                <a:t>D   LPC(0:0/18:1)</a:t>
              </a:r>
            </a:p>
          </p:txBody>
        </p:sp>
        <p:sp>
          <p:nvSpPr>
            <p:cNvPr id="99" name="Rectangle 98"/>
            <p:cNvSpPr/>
            <p:nvPr/>
          </p:nvSpPr>
          <p:spPr>
            <a:xfrm>
              <a:off x="7704824" y="4693342"/>
              <a:ext cx="307802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/>
                <a:t>D: may be tail of previous peak</a:t>
              </a:r>
            </a:p>
          </p:txBody>
        </p:sp>
        <p:sp>
          <p:nvSpPr>
            <p:cNvPr id="100" name="Rectangle 99"/>
            <p:cNvSpPr/>
            <p:nvPr/>
          </p:nvSpPr>
          <p:spPr>
            <a:xfrm>
              <a:off x="9143230" y="5454952"/>
              <a:ext cx="1582057" cy="716038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2" name="TextBox 101"/>
          <p:cNvSpPr txBox="1"/>
          <p:nvPr/>
        </p:nvSpPr>
        <p:spPr>
          <a:xfrm>
            <a:off x="40193" y="5622052"/>
            <a:ext cx="60139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6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ICs for LPC(18:1) (5 ppm tolerance) showing 4 annotated isomers. Note the last peak could be an erroneously detected LPC due to peak tailing.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104 fragment is used to discern LPC sn1 and sn2 isomers. </a:t>
            </a:r>
          </a:p>
        </p:txBody>
      </p:sp>
    </p:spTree>
    <p:extLst>
      <p:ext uri="{BB962C8B-B14F-4D97-AF65-F5344CB8AC3E}">
        <p14:creationId xmlns:p14="http://schemas.microsoft.com/office/powerpoint/2010/main" val="40021755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193" y="5064368"/>
            <a:ext cx="60139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7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stribution of unique lipids by class after combining positive and negative polarity lipid annotation using Lipid Annotator (as a percent of annotations, not intensity or relative amounts). Other consists of one CL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HexC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2296" y="2011950"/>
            <a:ext cx="3590855" cy="27556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3742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91</TotalTime>
  <Words>1002</Words>
  <Application>Microsoft Office PowerPoint</Application>
  <PresentationFormat>Custom</PresentationFormat>
  <Paragraphs>212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3" baseType="lpstr">
      <vt:lpstr>SimSun</vt:lpstr>
      <vt:lpstr>AgilentCond-Bold</vt:lpstr>
      <vt:lpstr>Arial</vt:lpstr>
      <vt:lpstr>Calibri</vt:lpstr>
      <vt:lpstr>Calibri Light</vt:lpstr>
      <vt:lpstr>Cambria Math</vt:lpstr>
      <vt:lpstr>Microsoft Sans Serif</vt:lpstr>
      <vt:lpstr>Symbol</vt:lpstr>
      <vt:lpstr>Times New Roman</vt:lpstr>
      <vt:lpstr>Office Theme</vt:lpstr>
      <vt:lpstr> Supplemental Figures and Tables   Lipid Annotator: a Rapid, Accurate, and User-Friendly Software for Comprehensive LC-HRMS/MS Lipidomic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panding lipidome coverage using LC-MS/MS data-dependent acquisition with automated exclusion list generation</dc:title>
  <dc:creator>Jeremy Koelmel</dc:creator>
  <cp:lastModifiedBy>Jeremy Koelmel</cp:lastModifiedBy>
  <cp:revision>265</cp:revision>
  <cp:lastPrinted>2017-09-05T20:55:14Z</cp:lastPrinted>
  <dcterms:created xsi:type="dcterms:W3CDTF">2016-09-10T22:02:34Z</dcterms:created>
  <dcterms:modified xsi:type="dcterms:W3CDTF">2019-07-29T19:23:43Z</dcterms:modified>
</cp:coreProperties>
</file>